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ct" ContentType="image/x-pict"/>
  <Override PartName="/ppt/media/image3.pct" ContentType="image/x-pict"/>
  <Override PartName="/ppt/media/image6.png" ContentType="image/png"/>
  <Override PartName="/ppt/media/image4.pct" ContentType="image/x-pict"/>
  <Override PartName="/ppt/media/image7.png" ContentType="image/png"/>
  <Override PartName="/ppt/media/image5.pct" ContentType="image/x-pict"/>
  <Override PartName="/ppt/media/image8.png" ContentType="image/png"/>
  <Override PartName="/ppt/media/image9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6B3D4D3-AAEE-4164-9EAA-4024BAC115F7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582912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514440" y="5507640"/>
            <a:ext cx="582912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9A0DE6C-99B7-4F68-809B-8CBD57BB82C8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136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514440" y="550764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1360" y="550764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190D008-4E0B-4527-89BE-B5C2483DB9A8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85440" y="264168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456080" y="264168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514440" y="550764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85440" y="550764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456080" y="550764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66FA95F-65B0-42DD-AAA4-BA88BD4DD63F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514440" y="2641680"/>
            <a:ext cx="5829120" cy="54864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A2E5BEA-1B1F-41BD-9DAC-89AE687FC599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582912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65BCCBC-3523-421C-99E8-86F942EEBD57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284436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1360" y="2641680"/>
            <a:ext cx="284436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962BA85-2D9B-426F-BA07-C5AD56CCBE4A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97DFF34-A653-45C2-9A67-1EB1D83D4EF1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514440" y="812520"/>
            <a:ext cx="582912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498D88C-97B2-4F05-9238-331473244CE3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1360" y="2641680"/>
            <a:ext cx="284436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514440" y="550764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2661AE2-D9F1-46FE-BBF1-38046721608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284436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136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1360" y="550764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4DE0633-A69E-44EF-AED8-5D3A5971A45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136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514440" y="5507640"/>
            <a:ext cx="582912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C524EE3-9AEA-48A9-9B57-15B9C8B0B87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514440" y="2641680"/>
            <a:ext cx="582912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514080" y="8331120"/>
            <a:ext cx="1428840" cy="609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331120"/>
            <a:ext cx="2171520" cy="609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5080" y="8331120"/>
            <a:ext cx="1428480" cy="609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4205527D-BEED-4802-88BC-B1AB2470862A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ct"/><Relationship Id="rId3" Type="http://schemas.openxmlformats.org/officeDocument/2006/relationships/image" Target="../media/image3.pct"/><Relationship Id="rId4" Type="http://schemas.openxmlformats.org/officeDocument/2006/relationships/image" Target="../media/image4.pct"/><Relationship Id="rId5" Type="http://schemas.openxmlformats.org/officeDocument/2006/relationships/image" Target="../media/image5.pct"/><Relationship Id="rId6" Type="http://schemas.openxmlformats.org/officeDocument/2006/relationships/image" Target="../media/image6.png"/><Relationship Id="rId7" Type="http://schemas.openxmlformats.org/officeDocument/2006/relationships/image" Target="../media/image7.png"/><Relationship Id="rId8" Type="http://schemas.openxmlformats.org/officeDocument/2006/relationships/image" Target="../media/image8.png"/><Relationship Id="rId9" Type="http://schemas.openxmlformats.org/officeDocument/2006/relationships/image" Target="../media/image9.png"/><Relationship Id="rId10" Type="http://schemas.openxmlformats.org/officeDocument/2006/relationships/slideLayout" Target="../slideLayouts/slideLayout2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"/>
          <p:cNvGrpSpPr/>
          <p:nvPr/>
        </p:nvGrpSpPr>
        <p:grpSpPr>
          <a:xfrm>
            <a:off x="455760" y="6853320"/>
            <a:ext cx="1767960" cy="1663200"/>
            <a:chOff x="455760" y="6853320"/>
            <a:chExt cx="1767960" cy="1663200"/>
          </a:xfrm>
        </p:grpSpPr>
        <p:grpSp>
          <p:nvGrpSpPr>
            <p:cNvPr id="42" name=""/>
            <p:cNvGrpSpPr/>
            <p:nvPr/>
          </p:nvGrpSpPr>
          <p:grpSpPr>
            <a:xfrm>
              <a:off x="455760" y="6853320"/>
              <a:ext cx="1767960" cy="1663200"/>
              <a:chOff x="455760" y="6853320"/>
              <a:chExt cx="1767960" cy="1663200"/>
            </a:xfrm>
          </p:grpSpPr>
          <p:sp>
            <p:nvSpPr>
              <p:cNvPr id="43" name=""/>
              <p:cNvSpPr/>
              <p:nvPr/>
            </p:nvSpPr>
            <p:spPr>
              <a:xfrm>
                <a:off x="741960" y="6922080"/>
                <a:ext cx="1409400" cy="1320840"/>
              </a:xfrm>
              <a:prstGeom prst="rect">
                <a:avLst/>
              </a:prstGeom>
              <a:solidFill>
                <a:srgbClr val="ffffff"/>
              </a:solidFill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grpSp>
            <p:nvGrpSpPr>
              <p:cNvPr id="44" name=""/>
              <p:cNvGrpSpPr/>
              <p:nvPr/>
            </p:nvGrpSpPr>
            <p:grpSpPr>
              <a:xfrm>
                <a:off x="673200" y="8237160"/>
                <a:ext cx="1550520" cy="279360"/>
                <a:chOff x="673200" y="8237160"/>
                <a:chExt cx="1550520" cy="279360"/>
              </a:xfrm>
            </p:grpSpPr>
            <p:sp>
              <p:nvSpPr>
                <p:cNvPr id="45" name=""/>
                <p:cNvSpPr/>
                <p:nvPr/>
              </p:nvSpPr>
              <p:spPr>
                <a:xfrm>
                  <a:off x="741600" y="8237160"/>
                  <a:ext cx="1402920" cy="1080"/>
                </a:xfrm>
                <a:prstGeom prst="line">
                  <a:avLst/>
                </a:prstGeom>
                <a:ln w="64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720" bIns="-4572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grpSp>
              <p:nvGrpSpPr>
                <p:cNvPr id="46" name=""/>
                <p:cNvGrpSpPr/>
                <p:nvPr/>
              </p:nvGrpSpPr>
              <p:grpSpPr>
                <a:xfrm>
                  <a:off x="741600" y="8242920"/>
                  <a:ext cx="1404000" cy="29880"/>
                  <a:chOff x="741600" y="8242920"/>
                  <a:chExt cx="1404000" cy="29880"/>
                </a:xfrm>
              </p:grpSpPr>
              <p:sp>
                <p:nvSpPr>
                  <p:cNvPr id="47" name=""/>
                  <p:cNvSpPr/>
                  <p:nvPr/>
                </p:nvSpPr>
                <p:spPr>
                  <a:xfrm>
                    <a:off x="741600" y="8242920"/>
                    <a:ext cx="1440" cy="2988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16920" bIns="-1692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48" name=""/>
                  <p:cNvSpPr/>
                  <p:nvPr/>
                </p:nvSpPr>
                <p:spPr>
                  <a:xfrm>
                    <a:off x="845280" y="8242920"/>
                    <a:ext cx="1080" cy="1008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6720" bIns="-3672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49" name=""/>
                  <p:cNvSpPr/>
                  <p:nvPr/>
                </p:nvSpPr>
                <p:spPr>
                  <a:xfrm>
                    <a:off x="904680" y="8242920"/>
                    <a:ext cx="1440" cy="1008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6720" bIns="-3672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50" name=""/>
                  <p:cNvSpPr/>
                  <p:nvPr/>
                </p:nvSpPr>
                <p:spPr>
                  <a:xfrm>
                    <a:off x="949320" y="8242920"/>
                    <a:ext cx="1080" cy="1008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6720" bIns="-3672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51" name=""/>
                  <p:cNvSpPr/>
                  <p:nvPr/>
                </p:nvSpPr>
                <p:spPr>
                  <a:xfrm>
                    <a:off x="986400" y="8242920"/>
                    <a:ext cx="1080" cy="1980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27000" bIns="-2700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52" name=""/>
                  <p:cNvSpPr/>
                  <p:nvPr/>
                </p:nvSpPr>
                <p:spPr>
                  <a:xfrm>
                    <a:off x="1014480" y="8242920"/>
                    <a:ext cx="1080" cy="1008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6720" bIns="-3672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53" name=""/>
                  <p:cNvSpPr/>
                  <p:nvPr/>
                </p:nvSpPr>
                <p:spPr>
                  <a:xfrm>
                    <a:off x="1035000" y="8242920"/>
                    <a:ext cx="1440" cy="1008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6720" bIns="-3672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54" name=""/>
                  <p:cNvSpPr/>
                  <p:nvPr/>
                </p:nvSpPr>
                <p:spPr>
                  <a:xfrm>
                    <a:off x="1057680" y="8242920"/>
                    <a:ext cx="1080" cy="1008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6720" bIns="-3672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55" name=""/>
                  <p:cNvSpPr/>
                  <p:nvPr/>
                </p:nvSpPr>
                <p:spPr>
                  <a:xfrm>
                    <a:off x="1073520" y="8242920"/>
                    <a:ext cx="1440" cy="1008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6720" bIns="-3672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56" name=""/>
                  <p:cNvSpPr/>
                  <p:nvPr/>
                </p:nvSpPr>
                <p:spPr>
                  <a:xfrm>
                    <a:off x="1090080" y="8242920"/>
                    <a:ext cx="1080" cy="2988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16920" bIns="-1692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57" name=""/>
                  <p:cNvSpPr/>
                  <p:nvPr/>
                </p:nvSpPr>
                <p:spPr>
                  <a:xfrm>
                    <a:off x="1198440" y="8242920"/>
                    <a:ext cx="1080" cy="1008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6720" bIns="-3672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58" name=""/>
                  <p:cNvSpPr/>
                  <p:nvPr/>
                </p:nvSpPr>
                <p:spPr>
                  <a:xfrm>
                    <a:off x="1258920" y="8242920"/>
                    <a:ext cx="1440" cy="1008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6720" bIns="-3672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59" name=""/>
                  <p:cNvSpPr/>
                  <p:nvPr/>
                </p:nvSpPr>
                <p:spPr>
                  <a:xfrm>
                    <a:off x="1302120" y="8242920"/>
                    <a:ext cx="1440" cy="1008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6720" bIns="-3672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60" name=""/>
                  <p:cNvSpPr/>
                  <p:nvPr/>
                </p:nvSpPr>
                <p:spPr>
                  <a:xfrm>
                    <a:off x="1334520" y="8242920"/>
                    <a:ext cx="1440" cy="1980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27000" bIns="-2700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61" name=""/>
                  <p:cNvSpPr/>
                  <p:nvPr/>
                </p:nvSpPr>
                <p:spPr>
                  <a:xfrm>
                    <a:off x="1367280" y="8242920"/>
                    <a:ext cx="1440" cy="1008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6720" bIns="-3672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62" name=""/>
                  <p:cNvSpPr/>
                  <p:nvPr/>
                </p:nvSpPr>
                <p:spPr>
                  <a:xfrm>
                    <a:off x="1388160" y="8242920"/>
                    <a:ext cx="1080" cy="1008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6720" bIns="-3672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63" name=""/>
                  <p:cNvSpPr/>
                  <p:nvPr/>
                </p:nvSpPr>
                <p:spPr>
                  <a:xfrm>
                    <a:off x="1410480" y="8242920"/>
                    <a:ext cx="1440" cy="1008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6720" bIns="-3672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64" name=""/>
                  <p:cNvSpPr/>
                  <p:nvPr/>
                </p:nvSpPr>
                <p:spPr>
                  <a:xfrm>
                    <a:off x="1426680" y="8242920"/>
                    <a:ext cx="1080" cy="1008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6720" bIns="-3672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65" name=""/>
                  <p:cNvSpPr/>
                  <p:nvPr/>
                </p:nvSpPr>
                <p:spPr>
                  <a:xfrm>
                    <a:off x="1442880" y="8242920"/>
                    <a:ext cx="1440" cy="2988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16920" bIns="-1692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66" name=""/>
                  <p:cNvSpPr/>
                  <p:nvPr/>
                </p:nvSpPr>
                <p:spPr>
                  <a:xfrm>
                    <a:off x="1546920" y="8242920"/>
                    <a:ext cx="1080" cy="1008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6720" bIns="-3672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67" name=""/>
                  <p:cNvSpPr/>
                  <p:nvPr/>
                </p:nvSpPr>
                <p:spPr>
                  <a:xfrm>
                    <a:off x="1612080" y="8242920"/>
                    <a:ext cx="1080" cy="1008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6720" bIns="-3672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68" name=""/>
                  <p:cNvSpPr/>
                  <p:nvPr/>
                </p:nvSpPr>
                <p:spPr>
                  <a:xfrm>
                    <a:off x="1655280" y="8242920"/>
                    <a:ext cx="1080" cy="1008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6720" bIns="-3672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69" name=""/>
                  <p:cNvSpPr/>
                  <p:nvPr/>
                </p:nvSpPr>
                <p:spPr>
                  <a:xfrm>
                    <a:off x="1687680" y="8242920"/>
                    <a:ext cx="1080" cy="1980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27000" bIns="-2700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70" name=""/>
                  <p:cNvSpPr/>
                  <p:nvPr/>
                </p:nvSpPr>
                <p:spPr>
                  <a:xfrm>
                    <a:off x="1714320" y="8242920"/>
                    <a:ext cx="1440" cy="1008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6720" bIns="-3672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71" name=""/>
                  <p:cNvSpPr/>
                  <p:nvPr/>
                </p:nvSpPr>
                <p:spPr>
                  <a:xfrm>
                    <a:off x="1742760" y="8242920"/>
                    <a:ext cx="1080" cy="1008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6720" bIns="-3672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72" name=""/>
                  <p:cNvSpPr/>
                  <p:nvPr/>
                </p:nvSpPr>
                <p:spPr>
                  <a:xfrm>
                    <a:off x="1758600" y="8242920"/>
                    <a:ext cx="1440" cy="1008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6720" bIns="-3672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73" name=""/>
                  <p:cNvSpPr/>
                  <p:nvPr/>
                </p:nvSpPr>
                <p:spPr>
                  <a:xfrm>
                    <a:off x="1779480" y="8242920"/>
                    <a:ext cx="1440" cy="1008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6720" bIns="-3672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74" name=""/>
                  <p:cNvSpPr/>
                  <p:nvPr/>
                </p:nvSpPr>
                <p:spPr>
                  <a:xfrm>
                    <a:off x="1796040" y="8242920"/>
                    <a:ext cx="1080" cy="2988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16920" bIns="-1692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75" name=""/>
                  <p:cNvSpPr/>
                  <p:nvPr/>
                </p:nvSpPr>
                <p:spPr>
                  <a:xfrm>
                    <a:off x="1899720" y="8242920"/>
                    <a:ext cx="1440" cy="1008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6720" bIns="-3672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76" name=""/>
                  <p:cNvSpPr/>
                  <p:nvPr/>
                </p:nvSpPr>
                <p:spPr>
                  <a:xfrm>
                    <a:off x="1964880" y="8242920"/>
                    <a:ext cx="1440" cy="1008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6720" bIns="-3672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77" name=""/>
                  <p:cNvSpPr/>
                  <p:nvPr/>
                </p:nvSpPr>
                <p:spPr>
                  <a:xfrm>
                    <a:off x="2008080" y="8242920"/>
                    <a:ext cx="1440" cy="1008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6720" bIns="-3672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78" name=""/>
                  <p:cNvSpPr/>
                  <p:nvPr/>
                </p:nvSpPr>
                <p:spPr>
                  <a:xfrm>
                    <a:off x="2040480" y="8242920"/>
                    <a:ext cx="1440" cy="1980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27000" bIns="-2700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79" name=""/>
                  <p:cNvSpPr/>
                  <p:nvPr/>
                </p:nvSpPr>
                <p:spPr>
                  <a:xfrm>
                    <a:off x="2068920" y="8242920"/>
                    <a:ext cx="1080" cy="1008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6720" bIns="-3672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80" name=""/>
                  <p:cNvSpPr/>
                  <p:nvPr/>
                </p:nvSpPr>
                <p:spPr>
                  <a:xfrm>
                    <a:off x="2089800" y="8242920"/>
                    <a:ext cx="1080" cy="1008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6720" bIns="-3672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81" name=""/>
                  <p:cNvSpPr/>
                  <p:nvPr/>
                </p:nvSpPr>
                <p:spPr>
                  <a:xfrm>
                    <a:off x="2111760" y="8242920"/>
                    <a:ext cx="1080" cy="1008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6720" bIns="-3672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82" name=""/>
                  <p:cNvSpPr/>
                  <p:nvPr/>
                </p:nvSpPr>
                <p:spPr>
                  <a:xfrm>
                    <a:off x="2127960" y="8242920"/>
                    <a:ext cx="1440" cy="1008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6720" bIns="-3672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83" name=""/>
                  <p:cNvSpPr/>
                  <p:nvPr/>
                </p:nvSpPr>
                <p:spPr>
                  <a:xfrm>
                    <a:off x="2144520" y="8242920"/>
                    <a:ext cx="1080" cy="2988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16920" bIns="-1692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</p:grpSp>
            <p:grpSp>
              <p:nvGrpSpPr>
                <p:cNvPr id="84" name=""/>
                <p:cNvGrpSpPr/>
                <p:nvPr/>
              </p:nvGrpSpPr>
              <p:grpSpPr>
                <a:xfrm>
                  <a:off x="673200" y="8280000"/>
                  <a:ext cx="1550520" cy="158040"/>
                  <a:chOff x="673200" y="8280000"/>
                  <a:chExt cx="1550520" cy="158040"/>
                </a:xfrm>
              </p:grpSpPr>
              <p:sp>
                <p:nvSpPr>
                  <p:cNvPr id="85" name=""/>
                  <p:cNvSpPr/>
                  <p:nvPr/>
                </p:nvSpPr>
                <p:spPr>
                  <a:xfrm>
                    <a:off x="673200" y="8316000"/>
                    <a:ext cx="113400" cy="12204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1" lang="en-US" sz="800" spc="-1" strike="noStrike">
                        <a:solidFill>
                          <a:srgbClr val="000000"/>
                        </a:solidFill>
                        <a:latin typeface="Arial"/>
                      </a:rPr>
                      <a:t>10</a:t>
                    </a:r>
                    <a:endParaRPr b="0" lang="en-US" sz="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86" name=""/>
                  <p:cNvSpPr/>
                  <p:nvPr/>
                </p:nvSpPr>
                <p:spPr>
                  <a:xfrm>
                    <a:off x="771120" y="8280000"/>
                    <a:ext cx="49320" cy="10692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1" lang="en-US" sz="700" spc="-1" strike="noStrike">
                        <a:solidFill>
                          <a:srgbClr val="000000"/>
                        </a:solidFill>
                        <a:latin typeface="Arial"/>
                      </a:rPr>
                      <a:t>0</a:t>
                    </a:r>
                    <a:endParaRPr b="0" lang="en-US" sz="7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87" name=""/>
                  <p:cNvSpPr/>
                  <p:nvPr/>
                </p:nvSpPr>
                <p:spPr>
                  <a:xfrm>
                    <a:off x="1021680" y="8316000"/>
                    <a:ext cx="113400" cy="12204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1" lang="en-US" sz="800" spc="-1" strike="noStrike">
                        <a:solidFill>
                          <a:srgbClr val="000000"/>
                        </a:solidFill>
                        <a:latin typeface="Arial"/>
                      </a:rPr>
                      <a:t>10</a:t>
                    </a:r>
                    <a:endParaRPr b="0" lang="en-US" sz="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88" name=""/>
                  <p:cNvSpPr/>
                  <p:nvPr/>
                </p:nvSpPr>
                <p:spPr>
                  <a:xfrm>
                    <a:off x="1118520" y="8280000"/>
                    <a:ext cx="49320" cy="10692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1" lang="en-US" sz="700" spc="-1" strike="noStrike">
                        <a:solidFill>
                          <a:srgbClr val="000000"/>
                        </a:solidFill>
                        <a:latin typeface="Arial"/>
                      </a:rPr>
                      <a:t>1</a:t>
                    </a:r>
                    <a:endParaRPr b="0" lang="en-US" sz="7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89" name=""/>
                  <p:cNvSpPr/>
                  <p:nvPr/>
                </p:nvSpPr>
                <p:spPr>
                  <a:xfrm>
                    <a:off x="1374480" y="8316000"/>
                    <a:ext cx="113400" cy="12204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1" lang="en-US" sz="800" spc="-1" strike="noStrike">
                        <a:solidFill>
                          <a:srgbClr val="000000"/>
                        </a:solidFill>
                        <a:latin typeface="Arial"/>
                      </a:rPr>
                      <a:t>10</a:t>
                    </a:r>
                    <a:endParaRPr b="0" lang="en-US" sz="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90" name=""/>
                  <p:cNvSpPr/>
                  <p:nvPr/>
                </p:nvSpPr>
                <p:spPr>
                  <a:xfrm>
                    <a:off x="1472760" y="8280000"/>
                    <a:ext cx="49320" cy="10692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1" lang="en-US" sz="700" spc="-1" strike="noStrike">
                        <a:solidFill>
                          <a:srgbClr val="000000"/>
                        </a:solidFill>
                        <a:latin typeface="Arial"/>
                      </a:rPr>
                      <a:t>2</a:t>
                    </a:r>
                    <a:endParaRPr b="0" lang="en-US" sz="7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91" name=""/>
                  <p:cNvSpPr/>
                  <p:nvPr/>
                </p:nvSpPr>
                <p:spPr>
                  <a:xfrm>
                    <a:off x="1727640" y="8316000"/>
                    <a:ext cx="113400" cy="12204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1" lang="en-US" sz="800" spc="-1" strike="noStrike">
                        <a:solidFill>
                          <a:srgbClr val="000000"/>
                        </a:solidFill>
                        <a:latin typeface="Arial"/>
                      </a:rPr>
                      <a:t>10</a:t>
                    </a:r>
                    <a:endParaRPr b="0" lang="en-US" sz="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92" name=""/>
                  <p:cNvSpPr/>
                  <p:nvPr/>
                </p:nvSpPr>
                <p:spPr>
                  <a:xfrm>
                    <a:off x="1824840" y="8280000"/>
                    <a:ext cx="49320" cy="10692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1" lang="en-US" sz="700" spc="-1" strike="noStrike">
                        <a:solidFill>
                          <a:srgbClr val="000000"/>
                        </a:solidFill>
                        <a:latin typeface="Arial"/>
                      </a:rPr>
                      <a:t>3</a:t>
                    </a:r>
                    <a:endParaRPr b="0" lang="en-US" sz="7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93" name=""/>
                  <p:cNvSpPr/>
                  <p:nvPr/>
                </p:nvSpPr>
                <p:spPr>
                  <a:xfrm>
                    <a:off x="2075040" y="8316000"/>
                    <a:ext cx="113400" cy="12204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1" lang="en-US" sz="800" spc="-1" strike="noStrike">
                        <a:solidFill>
                          <a:srgbClr val="000000"/>
                        </a:solidFill>
                        <a:latin typeface="Arial"/>
                      </a:rPr>
                      <a:t>10</a:t>
                    </a:r>
                    <a:endParaRPr b="0" lang="en-US" sz="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94" name=""/>
                  <p:cNvSpPr/>
                  <p:nvPr/>
                </p:nvSpPr>
                <p:spPr>
                  <a:xfrm>
                    <a:off x="2174400" y="8280000"/>
                    <a:ext cx="49320" cy="10692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1" lang="en-US" sz="700" spc="-1" strike="noStrike">
                        <a:solidFill>
                          <a:srgbClr val="000000"/>
                        </a:solidFill>
                        <a:latin typeface="Arial"/>
                      </a:rPr>
                      <a:t>4</a:t>
                    </a:r>
                    <a:endParaRPr b="0" lang="en-US" sz="7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</p:grpSp>
            <p:sp>
              <p:nvSpPr>
                <p:cNvPr id="95" name=""/>
                <p:cNvSpPr/>
                <p:nvPr/>
              </p:nvSpPr>
              <p:spPr>
                <a:xfrm>
                  <a:off x="1332000" y="8394480"/>
                  <a:ext cx="259920" cy="1220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800" spc="-1" strike="noStrike">
                      <a:solidFill>
                        <a:srgbClr val="000000"/>
                      </a:solidFill>
                      <a:latin typeface="Arial"/>
                    </a:rPr>
                    <a:t>CD69</a:t>
                  </a:r>
                  <a:endParaRPr b="0" lang="en-US" sz="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grpSp>
            <p:nvGrpSpPr>
              <p:cNvPr id="96" name=""/>
              <p:cNvGrpSpPr/>
              <p:nvPr/>
            </p:nvGrpSpPr>
            <p:grpSpPr>
              <a:xfrm>
                <a:off x="455760" y="6853320"/>
                <a:ext cx="287280" cy="1463040"/>
                <a:chOff x="455760" y="6853320"/>
                <a:chExt cx="287280" cy="1463040"/>
              </a:xfrm>
            </p:grpSpPr>
            <p:sp>
              <p:nvSpPr>
                <p:cNvPr id="97" name=""/>
                <p:cNvSpPr/>
                <p:nvPr/>
              </p:nvSpPr>
              <p:spPr>
                <a:xfrm flipV="1">
                  <a:off x="741600" y="6921720"/>
                  <a:ext cx="1440" cy="1315080"/>
                </a:xfrm>
                <a:prstGeom prst="line">
                  <a:avLst/>
                </a:prstGeom>
                <a:ln w="64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grpSp>
              <p:nvGrpSpPr>
                <p:cNvPr id="98" name=""/>
                <p:cNvGrpSpPr/>
                <p:nvPr/>
              </p:nvGrpSpPr>
              <p:grpSpPr>
                <a:xfrm>
                  <a:off x="708840" y="6922080"/>
                  <a:ext cx="32400" cy="1316160"/>
                  <a:chOff x="708840" y="6922080"/>
                  <a:chExt cx="32400" cy="1316160"/>
                </a:xfrm>
              </p:grpSpPr>
              <p:sp>
                <p:nvSpPr>
                  <p:cNvPr id="99" name=""/>
                  <p:cNvSpPr/>
                  <p:nvPr/>
                </p:nvSpPr>
                <p:spPr>
                  <a:xfrm flipH="1">
                    <a:off x="708840" y="8237160"/>
                    <a:ext cx="32400" cy="108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5720" bIns="-4572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00" name=""/>
                  <p:cNvSpPr/>
                  <p:nvPr/>
                </p:nvSpPr>
                <p:spPr>
                  <a:xfrm flipH="1">
                    <a:off x="730800" y="8141400"/>
                    <a:ext cx="10080" cy="108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5720" bIns="-4572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01" name=""/>
                  <p:cNvSpPr/>
                  <p:nvPr/>
                </p:nvSpPr>
                <p:spPr>
                  <a:xfrm flipH="1">
                    <a:off x="730800" y="8083800"/>
                    <a:ext cx="10080" cy="144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5360" bIns="-4536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02" name=""/>
                  <p:cNvSpPr/>
                  <p:nvPr/>
                </p:nvSpPr>
                <p:spPr>
                  <a:xfrm flipH="1">
                    <a:off x="730800" y="8043840"/>
                    <a:ext cx="10080" cy="108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5720" bIns="-4572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03" name=""/>
                  <p:cNvSpPr/>
                  <p:nvPr/>
                </p:nvSpPr>
                <p:spPr>
                  <a:xfrm flipH="1">
                    <a:off x="720720" y="8007840"/>
                    <a:ext cx="20160" cy="144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5360" bIns="-4536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04" name=""/>
                  <p:cNvSpPr/>
                  <p:nvPr/>
                </p:nvSpPr>
                <p:spPr>
                  <a:xfrm flipH="1">
                    <a:off x="730800" y="7981920"/>
                    <a:ext cx="10080" cy="108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5720" bIns="-4572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05" name=""/>
                  <p:cNvSpPr/>
                  <p:nvPr/>
                </p:nvSpPr>
                <p:spPr>
                  <a:xfrm flipH="1">
                    <a:off x="730800" y="7962120"/>
                    <a:ext cx="10080" cy="144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5360" bIns="-4536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06" name=""/>
                  <p:cNvSpPr/>
                  <p:nvPr/>
                </p:nvSpPr>
                <p:spPr>
                  <a:xfrm flipH="1">
                    <a:off x="730800" y="7941960"/>
                    <a:ext cx="10080" cy="108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5720" bIns="-4572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07" name=""/>
                  <p:cNvSpPr/>
                  <p:nvPr/>
                </p:nvSpPr>
                <p:spPr>
                  <a:xfrm flipH="1">
                    <a:off x="730800" y="7926120"/>
                    <a:ext cx="10080" cy="144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5360" bIns="-4536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08" name=""/>
                  <p:cNvSpPr/>
                  <p:nvPr/>
                </p:nvSpPr>
                <p:spPr>
                  <a:xfrm flipH="1">
                    <a:off x="708840" y="7912080"/>
                    <a:ext cx="32400" cy="108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5720" bIns="-4572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09" name=""/>
                  <p:cNvSpPr/>
                  <p:nvPr/>
                </p:nvSpPr>
                <p:spPr>
                  <a:xfrm flipH="1">
                    <a:off x="730800" y="7808760"/>
                    <a:ext cx="10080" cy="144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5360" bIns="-4536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10" name=""/>
                  <p:cNvSpPr/>
                  <p:nvPr/>
                </p:nvSpPr>
                <p:spPr>
                  <a:xfrm flipH="1">
                    <a:off x="730800" y="7752960"/>
                    <a:ext cx="10080" cy="108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5720" bIns="-4572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11" name=""/>
                  <p:cNvSpPr/>
                  <p:nvPr/>
                </p:nvSpPr>
                <p:spPr>
                  <a:xfrm flipH="1">
                    <a:off x="730800" y="7712640"/>
                    <a:ext cx="10080" cy="108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5720" bIns="-4572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12" name=""/>
                  <p:cNvSpPr/>
                  <p:nvPr/>
                </p:nvSpPr>
                <p:spPr>
                  <a:xfrm flipH="1">
                    <a:off x="720720" y="7681320"/>
                    <a:ext cx="20160" cy="108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5720" bIns="-4572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13" name=""/>
                  <p:cNvSpPr/>
                  <p:nvPr/>
                </p:nvSpPr>
                <p:spPr>
                  <a:xfrm flipH="1">
                    <a:off x="730800" y="7651080"/>
                    <a:ext cx="10080" cy="144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5360" bIns="-4536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14" name=""/>
                  <p:cNvSpPr/>
                  <p:nvPr/>
                </p:nvSpPr>
                <p:spPr>
                  <a:xfrm flipH="1">
                    <a:off x="730800" y="7631280"/>
                    <a:ext cx="10080" cy="108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5720" bIns="-4572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15" name=""/>
                  <p:cNvSpPr/>
                  <p:nvPr/>
                </p:nvSpPr>
                <p:spPr>
                  <a:xfrm flipH="1">
                    <a:off x="730800" y="7611120"/>
                    <a:ext cx="10080" cy="108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5720" bIns="-4572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16" name=""/>
                  <p:cNvSpPr/>
                  <p:nvPr/>
                </p:nvSpPr>
                <p:spPr>
                  <a:xfrm flipH="1">
                    <a:off x="730800" y="7595280"/>
                    <a:ext cx="10080" cy="144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5360" bIns="-4536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17" name=""/>
                  <p:cNvSpPr/>
                  <p:nvPr/>
                </p:nvSpPr>
                <p:spPr>
                  <a:xfrm flipH="1">
                    <a:off x="708840" y="7579440"/>
                    <a:ext cx="32400" cy="108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5720" bIns="-4572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18" name=""/>
                  <p:cNvSpPr/>
                  <p:nvPr/>
                </p:nvSpPr>
                <p:spPr>
                  <a:xfrm flipH="1">
                    <a:off x="730800" y="7483320"/>
                    <a:ext cx="10080" cy="144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5360" bIns="-4536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19" name=""/>
                  <p:cNvSpPr/>
                  <p:nvPr/>
                </p:nvSpPr>
                <p:spPr>
                  <a:xfrm flipH="1">
                    <a:off x="730800" y="7422120"/>
                    <a:ext cx="10080" cy="108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5720" bIns="-4572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20" name=""/>
                  <p:cNvSpPr/>
                  <p:nvPr/>
                </p:nvSpPr>
                <p:spPr>
                  <a:xfrm flipH="1">
                    <a:off x="730800" y="7381800"/>
                    <a:ext cx="10080" cy="144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5360" bIns="-4536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21" name=""/>
                  <p:cNvSpPr/>
                  <p:nvPr/>
                </p:nvSpPr>
                <p:spPr>
                  <a:xfrm flipH="1">
                    <a:off x="720720" y="7350120"/>
                    <a:ext cx="20160" cy="144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5360" bIns="-4536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22" name=""/>
                  <p:cNvSpPr/>
                  <p:nvPr/>
                </p:nvSpPr>
                <p:spPr>
                  <a:xfrm flipH="1">
                    <a:off x="730800" y="7324560"/>
                    <a:ext cx="10080" cy="108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5720" bIns="-4572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23" name=""/>
                  <p:cNvSpPr/>
                  <p:nvPr/>
                </p:nvSpPr>
                <p:spPr>
                  <a:xfrm flipH="1">
                    <a:off x="730800" y="7300080"/>
                    <a:ext cx="10080" cy="108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5720" bIns="-4572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24" name=""/>
                  <p:cNvSpPr/>
                  <p:nvPr/>
                </p:nvSpPr>
                <p:spPr>
                  <a:xfrm flipH="1">
                    <a:off x="730800" y="7284600"/>
                    <a:ext cx="10080" cy="108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5720" bIns="-4572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25" name=""/>
                  <p:cNvSpPr/>
                  <p:nvPr/>
                </p:nvSpPr>
                <p:spPr>
                  <a:xfrm flipH="1">
                    <a:off x="730800" y="7264440"/>
                    <a:ext cx="10080" cy="108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5720" bIns="-4572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26" name=""/>
                  <p:cNvSpPr/>
                  <p:nvPr/>
                </p:nvSpPr>
                <p:spPr>
                  <a:xfrm flipH="1">
                    <a:off x="708840" y="7248600"/>
                    <a:ext cx="32400" cy="144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5360" bIns="-4536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27" name=""/>
                  <p:cNvSpPr/>
                  <p:nvPr/>
                </p:nvSpPr>
                <p:spPr>
                  <a:xfrm flipH="1">
                    <a:off x="730800" y="7152480"/>
                    <a:ext cx="10080" cy="108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5720" bIns="-4572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28" name=""/>
                  <p:cNvSpPr/>
                  <p:nvPr/>
                </p:nvSpPr>
                <p:spPr>
                  <a:xfrm flipH="1">
                    <a:off x="730800" y="7090920"/>
                    <a:ext cx="10080" cy="144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5360" bIns="-4536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29" name=""/>
                  <p:cNvSpPr/>
                  <p:nvPr/>
                </p:nvSpPr>
                <p:spPr>
                  <a:xfrm flipH="1">
                    <a:off x="730800" y="7049160"/>
                    <a:ext cx="10080" cy="144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5360" bIns="-4536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30" name=""/>
                  <p:cNvSpPr/>
                  <p:nvPr/>
                </p:nvSpPr>
                <p:spPr>
                  <a:xfrm flipH="1">
                    <a:off x="720720" y="7019280"/>
                    <a:ext cx="20160" cy="108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5720" bIns="-4572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31" name=""/>
                  <p:cNvSpPr/>
                  <p:nvPr/>
                </p:nvSpPr>
                <p:spPr>
                  <a:xfrm flipH="1">
                    <a:off x="730800" y="6993360"/>
                    <a:ext cx="10080" cy="144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5360" bIns="-4536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32" name=""/>
                  <p:cNvSpPr/>
                  <p:nvPr/>
                </p:nvSpPr>
                <p:spPr>
                  <a:xfrm flipH="1">
                    <a:off x="730800" y="6973560"/>
                    <a:ext cx="10080" cy="108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5720" bIns="-4572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33" name=""/>
                  <p:cNvSpPr/>
                  <p:nvPr/>
                </p:nvSpPr>
                <p:spPr>
                  <a:xfrm flipH="1">
                    <a:off x="730800" y="6953400"/>
                    <a:ext cx="10080" cy="108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5720" bIns="-4572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34" name=""/>
                  <p:cNvSpPr/>
                  <p:nvPr/>
                </p:nvSpPr>
                <p:spPr>
                  <a:xfrm flipH="1">
                    <a:off x="730800" y="6937560"/>
                    <a:ext cx="10080" cy="144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5360" bIns="-4536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35" name=""/>
                  <p:cNvSpPr/>
                  <p:nvPr/>
                </p:nvSpPr>
                <p:spPr>
                  <a:xfrm flipH="1">
                    <a:off x="708840" y="6922080"/>
                    <a:ext cx="32400" cy="108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5720" bIns="-4572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</p:grpSp>
            <p:grpSp>
              <p:nvGrpSpPr>
                <p:cNvPr id="136" name=""/>
                <p:cNvGrpSpPr/>
                <p:nvPr/>
              </p:nvGrpSpPr>
              <p:grpSpPr>
                <a:xfrm>
                  <a:off x="548640" y="6853320"/>
                  <a:ext cx="142200" cy="1463040"/>
                  <a:chOff x="548640" y="6853320"/>
                  <a:chExt cx="142200" cy="1463040"/>
                </a:xfrm>
              </p:grpSpPr>
              <p:sp>
                <p:nvSpPr>
                  <p:cNvPr id="137" name=""/>
                  <p:cNvSpPr/>
                  <p:nvPr/>
                </p:nvSpPr>
                <p:spPr>
                  <a:xfrm>
                    <a:off x="548640" y="8194320"/>
                    <a:ext cx="113400" cy="12204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1" lang="en-US" sz="800" spc="-1" strike="noStrike">
                        <a:solidFill>
                          <a:srgbClr val="000000"/>
                        </a:solidFill>
                        <a:latin typeface="Arial"/>
                      </a:rPr>
                      <a:t>10</a:t>
                    </a:r>
                    <a:endParaRPr b="0" lang="en-US" sz="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38" name=""/>
                  <p:cNvSpPr/>
                  <p:nvPr/>
                </p:nvSpPr>
                <p:spPr>
                  <a:xfrm>
                    <a:off x="639000" y="8164080"/>
                    <a:ext cx="49320" cy="10692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1" lang="en-US" sz="700" spc="-1" strike="noStrike">
                        <a:solidFill>
                          <a:srgbClr val="000000"/>
                        </a:solidFill>
                        <a:latin typeface="Arial"/>
                      </a:rPr>
                      <a:t>0</a:t>
                    </a:r>
                    <a:endParaRPr b="0" lang="en-US" sz="7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39" name=""/>
                  <p:cNvSpPr/>
                  <p:nvPr/>
                </p:nvSpPr>
                <p:spPr>
                  <a:xfrm>
                    <a:off x="548640" y="7870320"/>
                    <a:ext cx="113400" cy="12204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1" lang="en-US" sz="800" spc="-1" strike="noStrike">
                        <a:solidFill>
                          <a:srgbClr val="000000"/>
                        </a:solidFill>
                        <a:latin typeface="Arial"/>
                      </a:rPr>
                      <a:t>10</a:t>
                    </a:r>
                    <a:endParaRPr b="0" lang="en-US" sz="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40" name=""/>
                  <p:cNvSpPr/>
                  <p:nvPr/>
                </p:nvSpPr>
                <p:spPr>
                  <a:xfrm>
                    <a:off x="639000" y="7841880"/>
                    <a:ext cx="49320" cy="10692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1" lang="en-US" sz="700" spc="-1" strike="noStrike">
                        <a:solidFill>
                          <a:srgbClr val="000000"/>
                        </a:solidFill>
                        <a:latin typeface="Arial"/>
                      </a:rPr>
                      <a:t>1</a:t>
                    </a:r>
                    <a:endParaRPr b="0" lang="en-US" sz="7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41" name=""/>
                  <p:cNvSpPr/>
                  <p:nvPr/>
                </p:nvSpPr>
                <p:spPr>
                  <a:xfrm>
                    <a:off x="548640" y="7545240"/>
                    <a:ext cx="113400" cy="12204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1" lang="en-US" sz="800" spc="-1" strike="noStrike">
                        <a:solidFill>
                          <a:srgbClr val="000000"/>
                        </a:solidFill>
                        <a:latin typeface="Arial"/>
                      </a:rPr>
                      <a:t>10</a:t>
                    </a:r>
                    <a:endParaRPr b="0" lang="en-US" sz="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42" name=""/>
                  <p:cNvSpPr/>
                  <p:nvPr/>
                </p:nvSpPr>
                <p:spPr>
                  <a:xfrm>
                    <a:off x="639000" y="7505280"/>
                    <a:ext cx="49320" cy="10692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1" lang="en-US" sz="700" spc="-1" strike="noStrike">
                        <a:solidFill>
                          <a:srgbClr val="000000"/>
                        </a:solidFill>
                        <a:latin typeface="Arial"/>
                      </a:rPr>
                      <a:t>2</a:t>
                    </a:r>
                    <a:endParaRPr b="0" lang="en-US" sz="7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43" name=""/>
                  <p:cNvSpPr/>
                  <p:nvPr/>
                </p:nvSpPr>
                <p:spPr>
                  <a:xfrm>
                    <a:off x="548640" y="7215840"/>
                    <a:ext cx="113400" cy="12204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1" lang="en-US" sz="800" spc="-1" strike="noStrike">
                        <a:solidFill>
                          <a:srgbClr val="000000"/>
                        </a:solidFill>
                        <a:latin typeface="Arial"/>
                      </a:rPr>
                      <a:t>10</a:t>
                    </a:r>
                    <a:endParaRPr b="0" lang="en-US" sz="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44" name=""/>
                  <p:cNvSpPr/>
                  <p:nvPr/>
                </p:nvSpPr>
                <p:spPr>
                  <a:xfrm>
                    <a:off x="640440" y="7179840"/>
                    <a:ext cx="49320" cy="10692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1" lang="en-US" sz="700" spc="-1" strike="noStrike">
                        <a:solidFill>
                          <a:srgbClr val="000000"/>
                        </a:solidFill>
                        <a:latin typeface="Arial"/>
                      </a:rPr>
                      <a:t>3</a:t>
                    </a:r>
                    <a:endParaRPr b="0" lang="en-US" sz="7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45" name=""/>
                  <p:cNvSpPr/>
                  <p:nvPr/>
                </p:nvSpPr>
                <p:spPr>
                  <a:xfrm>
                    <a:off x="548640" y="6888960"/>
                    <a:ext cx="113400" cy="12204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1" lang="en-US" sz="800" spc="-1" strike="noStrike">
                        <a:solidFill>
                          <a:srgbClr val="000000"/>
                        </a:solidFill>
                        <a:latin typeface="Arial"/>
                      </a:rPr>
                      <a:t>10</a:t>
                    </a:r>
                    <a:endParaRPr b="0" lang="en-US" sz="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46" name=""/>
                  <p:cNvSpPr/>
                  <p:nvPr/>
                </p:nvSpPr>
                <p:spPr>
                  <a:xfrm>
                    <a:off x="641520" y="6853320"/>
                    <a:ext cx="49320" cy="10692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1" lang="en-US" sz="700" spc="-1" strike="noStrike">
                        <a:solidFill>
                          <a:srgbClr val="000000"/>
                        </a:solidFill>
                        <a:latin typeface="Arial"/>
                      </a:rPr>
                      <a:t>4</a:t>
                    </a:r>
                    <a:endParaRPr b="0" lang="en-US" sz="7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</p:grpSp>
            <p:sp>
              <p:nvSpPr>
                <p:cNvPr id="147" name=""/>
                <p:cNvSpPr/>
                <p:nvPr/>
              </p:nvSpPr>
              <p:spPr>
                <a:xfrm rot="16200000">
                  <a:off x="415080" y="7497000"/>
                  <a:ext cx="203400" cy="1220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800" spc="-1" strike="noStrike">
                      <a:solidFill>
                        <a:srgbClr val="000000"/>
                      </a:solidFill>
                      <a:latin typeface="Arial"/>
                    </a:rPr>
                    <a:t>CD4</a:t>
                  </a:r>
                  <a:endParaRPr b="0" lang="en-US" sz="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</p:grpSp>
        <p:grpSp>
          <p:nvGrpSpPr>
            <p:cNvPr id="148" name=""/>
            <p:cNvGrpSpPr/>
            <p:nvPr/>
          </p:nvGrpSpPr>
          <p:grpSpPr>
            <a:xfrm>
              <a:off x="753840" y="6933240"/>
              <a:ext cx="1384920" cy="1299600"/>
              <a:chOff x="753840" y="6933240"/>
              <a:chExt cx="1384920" cy="1299600"/>
            </a:xfrm>
          </p:grpSpPr>
          <p:pic>
            <p:nvPicPr>
              <p:cNvPr id="149" name="" descr=""/>
              <p:cNvPicPr/>
              <p:nvPr/>
            </p:nvPicPr>
            <p:blipFill>
              <a:blip r:embed="rId1"/>
              <a:stretch/>
            </p:blipFill>
            <p:spPr>
              <a:xfrm>
                <a:off x="753840" y="6933240"/>
                <a:ext cx="1384920" cy="1299600"/>
              </a:xfrm>
              <a:prstGeom prst="rect">
                <a:avLst/>
              </a:prstGeom>
              <a:ln w="0">
                <a:noFill/>
              </a:ln>
            </p:spPr>
          </p:pic>
          <p:grpSp>
            <p:nvGrpSpPr>
              <p:cNvPr id="150" name=""/>
              <p:cNvGrpSpPr/>
              <p:nvPr/>
            </p:nvGrpSpPr>
            <p:grpSpPr>
              <a:xfrm>
                <a:off x="1149480" y="7186680"/>
                <a:ext cx="482760" cy="596880"/>
                <a:chOff x="1149480" y="7186680"/>
                <a:chExt cx="482760" cy="596880"/>
              </a:xfrm>
            </p:grpSpPr>
            <p:sp>
              <p:nvSpPr>
                <p:cNvPr id="151" name=""/>
                <p:cNvSpPr/>
                <p:nvPr/>
              </p:nvSpPr>
              <p:spPr>
                <a:xfrm>
                  <a:off x="1149480" y="7345440"/>
                  <a:ext cx="456480" cy="438120"/>
                </a:xfrm>
                <a:prstGeom prst="rect">
                  <a:avLst/>
                </a:prstGeom>
                <a:noFill/>
                <a:ln w="6480">
                  <a:solidFill>
                    <a:srgbClr val="0000ff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52" name=""/>
                <p:cNvSpPr/>
                <p:nvPr/>
              </p:nvSpPr>
              <p:spPr>
                <a:xfrm>
                  <a:off x="1351080" y="7186680"/>
                  <a:ext cx="260640" cy="148680"/>
                </a:xfrm>
                <a:custGeom>
                  <a:avLst/>
                  <a:gdLst/>
                  <a:ahLst/>
                  <a:rect l="l" t="t" r="r" b="b"/>
                  <a:pathLst>
                    <a:path w="176" h="104">
                      <a:moveTo>
                        <a:pt x="0" y="4"/>
                      </a:moveTo>
                      <a:lnTo>
                        <a:pt x="0" y="104"/>
                      </a:lnTo>
                      <a:lnTo>
                        <a:pt x="0" y="104"/>
                      </a:lnTo>
                      <a:lnTo>
                        <a:pt x="176" y="104"/>
                      </a:lnTo>
                      <a:lnTo>
                        <a:pt x="176" y="0"/>
                      </a:lnTo>
                      <a:lnTo>
                        <a:pt x="176" y="0"/>
                      </a:lnTo>
                      <a:lnTo>
                        <a:pt x="0" y="0"/>
                      </a:lnTo>
                      <a:lnTo>
                        <a:pt x="0" y="4"/>
                      </a:lnTo>
                      <a:close/>
                    </a:path>
                  </a:pathLst>
                </a:custGeom>
                <a:solidFill>
                  <a:srgbClr val="ffffff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53" name=""/>
                <p:cNvSpPr/>
                <p:nvPr/>
              </p:nvSpPr>
              <p:spPr>
                <a:xfrm>
                  <a:off x="1358640" y="7194960"/>
                  <a:ext cx="273600" cy="16776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1100" spc="-1" strike="noStrike">
                      <a:solidFill>
                        <a:srgbClr val="000000"/>
                      </a:solidFill>
                      <a:latin typeface="Arial"/>
                    </a:rPr>
                    <a:t>2.49</a:t>
                  </a:r>
                  <a:endParaRPr b="0" lang="en-US" sz="11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</p:grpSp>
      </p:grpSp>
      <p:grpSp>
        <p:nvGrpSpPr>
          <p:cNvPr id="154" name=""/>
          <p:cNvGrpSpPr/>
          <p:nvPr/>
        </p:nvGrpSpPr>
        <p:grpSpPr>
          <a:xfrm>
            <a:off x="449280" y="5019480"/>
            <a:ext cx="1774440" cy="1596960"/>
            <a:chOff x="449280" y="5019480"/>
            <a:chExt cx="1774440" cy="1596960"/>
          </a:xfrm>
        </p:grpSpPr>
        <p:grpSp>
          <p:nvGrpSpPr>
            <p:cNvPr id="155" name=""/>
            <p:cNvGrpSpPr/>
            <p:nvPr/>
          </p:nvGrpSpPr>
          <p:grpSpPr>
            <a:xfrm>
              <a:off x="449280" y="5019480"/>
              <a:ext cx="1774440" cy="1596960"/>
              <a:chOff x="449280" y="5019480"/>
              <a:chExt cx="1774440" cy="1596960"/>
            </a:xfrm>
          </p:grpSpPr>
          <p:sp>
            <p:nvSpPr>
              <p:cNvPr id="156" name=""/>
              <p:cNvSpPr/>
              <p:nvPr/>
            </p:nvSpPr>
            <p:spPr>
              <a:xfrm>
                <a:off x="741240" y="5019840"/>
                <a:ext cx="1409760" cy="1320120"/>
              </a:xfrm>
              <a:prstGeom prst="rect">
                <a:avLst/>
              </a:prstGeom>
              <a:solidFill>
                <a:srgbClr val="ffffff"/>
              </a:solidFill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grpSp>
            <p:nvGrpSpPr>
              <p:cNvPr id="157" name=""/>
              <p:cNvGrpSpPr/>
              <p:nvPr/>
            </p:nvGrpSpPr>
            <p:grpSpPr>
              <a:xfrm>
                <a:off x="672840" y="6335640"/>
                <a:ext cx="1550880" cy="280800"/>
                <a:chOff x="672840" y="6335640"/>
                <a:chExt cx="1550880" cy="280800"/>
              </a:xfrm>
            </p:grpSpPr>
            <p:sp>
              <p:nvSpPr>
                <p:cNvPr id="158" name=""/>
                <p:cNvSpPr/>
                <p:nvPr/>
              </p:nvSpPr>
              <p:spPr>
                <a:xfrm>
                  <a:off x="740880" y="6335640"/>
                  <a:ext cx="1403640" cy="1080"/>
                </a:xfrm>
                <a:prstGeom prst="line">
                  <a:avLst/>
                </a:prstGeom>
                <a:ln w="64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720" bIns="-4572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grpSp>
              <p:nvGrpSpPr>
                <p:cNvPr id="159" name=""/>
                <p:cNvGrpSpPr/>
                <p:nvPr/>
              </p:nvGrpSpPr>
              <p:grpSpPr>
                <a:xfrm>
                  <a:off x="740880" y="6339600"/>
                  <a:ext cx="1404720" cy="31320"/>
                  <a:chOff x="740880" y="6339600"/>
                  <a:chExt cx="1404720" cy="31320"/>
                </a:xfrm>
              </p:grpSpPr>
              <p:sp>
                <p:nvSpPr>
                  <p:cNvPr id="160" name=""/>
                  <p:cNvSpPr/>
                  <p:nvPr/>
                </p:nvSpPr>
                <p:spPr>
                  <a:xfrm>
                    <a:off x="740880" y="6339600"/>
                    <a:ext cx="1440" cy="3132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15480" bIns="-1548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61" name=""/>
                  <p:cNvSpPr/>
                  <p:nvPr/>
                </p:nvSpPr>
                <p:spPr>
                  <a:xfrm>
                    <a:off x="844560" y="6339600"/>
                    <a:ext cx="1080" cy="972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7080" bIns="-3708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62" name=""/>
                  <p:cNvSpPr/>
                  <p:nvPr/>
                </p:nvSpPr>
                <p:spPr>
                  <a:xfrm>
                    <a:off x="903960" y="6339600"/>
                    <a:ext cx="1440" cy="972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7080" bIns="-3708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63" name=""/>
                  <p:cNvSpPr/>
                  <p:nvPr/>
                </p:nvSpPr>
                <p:spPr>
                  <a:xfrm>
                    <a:off x="948600" y="6339600"/>
                    <a:ext cx="1080" cy="972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7080" bIns="-3708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64" name=""/>
                  <p:cNvSpPr/>
                  <p:nvPr/>
                </p:nvSpPr>
                <p:spPr>
                  <a:xfrm>
                    <a:off x="985680" y="6339600"/>
                    <a:ext cx="1080" cy="1980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27000" bIns="-2700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65" name=""/>
                  <p:cNvSpPr/>
                  <p:nvPr/>
                </p:nvSpPr>
                <p:spPr>
                  <a:xfrm>
                    <a:off x="1013760" y="6339600"/>
                    <a:ext cx="1080" cy="972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7080" bIns="-3708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66" name=""/>
                  <p:cNvSpPr/>
                  <p:nvPr/>
                </p:nvSpPr>
                <p:spPr>
                  <a:xfrm>
                    <a:off x="1034280" y="6339600"/>
                    <a:ext cx="1440" cy="972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7080" bIns="-3708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67" name=""/>
                  <p:cNvSpPr/>
                  <p:nvPr/>
                </p:nvSpPr>
                <p:spPr>
                  <a:xfrm>
                    <a:off x="1056960" y="6339600"/>
                    <a:ext cx="1080" cy="972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7080" bIns="-3708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68" name=""/>
                  <p:cNvSpPr/>
                  <p:nvPr/>
                </p:nvSpPr>
                <p:spPr>
                  <a:xfrm>
                    <a:off x="1073160" y="6339600"/>
                    <a:ext cx="1440" cy="972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7080" bIns="-3708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69" name=""/>
                  <p:cNvSpPr/>
                  <p:nvPr/>
                </p:nvSpPr>
                <p:spPr>
                  <a:xfrm>
                    <a:off x="1089720" y="6339600"/>
                    <a:ext cx="1080" cy="3132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15480" bIns="-1548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70" name=""/>
                  <p:cNvSpPr/>
                  <p:nvPr/>
                </p:nvSpPr>
                <p:spPr>
                  <a:xfrm>
                    <a:off x="1198080" y="6339600"/>
                    <a:ext cx="1080" cy="972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7080" bIns="-3708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71" name=""/>
                  <p:cNvSpPr/>
                  <p:nvPr/>
                </p:nvSpPr>
                <p:spPr>
                  <a:xfrm>
                    <a:off x="1258560" y="6339600"/>
                    <a:ext cx="1440" cy="972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7080" bIns="-3708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72" name=""/>
                  <p:cNvSpPr/>
                  <p:nvPr/>
                </p:nvSpPr>
                <p:spPr>
                  <a:xfrm>
                    <a:off x="1301760" y="6339600"/>
                    <a:ext cx="1440" cy="972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7080" bIns="-3708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73" name=""/>
                  <p:cNvSpPr/>
                  <p:nvPr/>
                </p:nvSpPr>
                <p:spPr>
                  <a:xfrm>
                    <a:off x="1334160" y="6339600"/>
                    <a:ext cx="1440" cy="1980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27000" bIns="-2700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74" name=""/>
                  <p:cNvSpPr/>
                  <p:nvPr/>
                </p:nvSpPr>
                <p:spPr>
                  <a:xfrm>
                    <a:off x="1366920" y="6339600"/>
                    <a:ext cx="1440" cy="972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7080" bIns="-3708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75" name=""/>
                  <p:cNvSpPr/>
                  <p:nvPr/>
                </p:nvSpPr>
                <p:spPr>
                  <a:xfrm>
                    <a:off x="1387800" y="6339600"/>
                    <a:ext cx="1080" cy="972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7080" bIns="-3708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76" name=""/>
                  <p:cNvSpPr/>
                  <p:nvPr/>
                </p:nvSpPr>
                <p:spPr>
                  <a:xfrm>
                    <a:off x="1410120" y="6339600"/>
                    <a:ext cx="1440" cy="972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7080" bIns="-3708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77" name=""/>
                  <p:cNvSpPr/>
                  <p:nvPr/>
                </p:nvSpPr>
                <p:spPr>
                  <a:xfrm>
                    <a:off x="1426320" y="6339600"/>
                    <a:ext cx="1080" cy="972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7080" bIns="-3708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78" name=""/>
                  <p:cNvSpPr/>
                  <p:nvPr/>
                </p:nvSpPr>
                <p:spPr>
                  <a:xfrm>
                    <a:off x="1442520" y="6339600"/>
                    <a:ext cx="1440" cy="3132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15480" bIns="-1548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79" name=""/>
                  <p:cNvSpPr/>
                  <p:nvPr/>
                </p:nvSpPr>
                <p:spPr>
                  <a:xfrm>
                    <a:off x="1546560" y="6339600"/>
                    <a:ext cx="1080" cy="972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7080" bIns="-3708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80" name=""/>
                  <p:cNvSpPr/>
                  <p:nvPr/>
                </p:nvSpPr>
                <p:spPr>
                  <a:xfrm>
                    <a:off x="1611720" y="6339600"/>
                    <a:ext cx="1080" cy="972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7080" bIns="-3708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81" name=""/>
                  <p:cNvSpPr/>
                  <p:nvPr/>
                </p:nvSpPr>
                <p:spPr>
                  <a:xfrm>
                    <a:off x="1654920" y="6339600"/>
                    <a:ext cx="1080" cy="972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7080" bIns="-3708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82" name=""/>
                  <p:cNvSpPr/>
                  <p:nvPr/>
                </p:nvSpPr>
                <p:spPr>
                  <a:xfrm>
                    <a:off x="1687680" y="6339600"/>
                    <a:ext cx="1080" cy="1980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27000" bIns="-2700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83" name=""/>
                  <p:cNvSpPr/>
                  <p:nvPr/>
                </p:nvSpPr>
                <p:spPr>
                  <a:xfrm>
                    <a:off x="1713960" y="6339600"/>
                    <a:ext cx="1440" cy="972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7080" bIns="-3708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84" name=""/>
                  <p:cNvSpPr/>
                  <p:nvPr/>
                </p:nvSpPr>
                <p:spPr>
                  <a:xfrm>
                    <a:off x="1742400" y="6339600"/>
                    <a:ext cx="1080" cy="972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7080" bIns="-3708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85" name=""/>
                  <p:cNvSpPr/>
                  <p:nvPr/>
                </p:nvSpPr>
                <p:spPr>
                  <a:xfrm>
                    <a:off x="1758600" y="6339600"/>
                    <a:ext cx="1440" cy="972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7080" bIns="-3708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86" name=""/>
                  <p:cNvSpPr/>
                  <p:nvPr/>
                </p:nvSpPr>
                <p:spPr>
                  <a:xfrm>
                    <a:off x="1779480" y="6339600"/>
                    <a:ext cx="1440" cy="972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7080" bIns="-3708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87" name=""/>
                  <p:cNvSpPr/>
                  <p:nvPr/>
                </p:nvSpPr>
                <p:spPr>
                  <a:xfrm>
                    <a:off x="1796040" y="6339600"/>
                    <a:ext cx="1080" cy="3132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15480" bIns="-1548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88" name=""/>
                  <p:cNvSpPr/>
                  <p:nvPr/>
                </p:nvSpPr>
                <p:spPr>
                  <a:xfrm>
                    <a:off x="1899360" y="6339600"/>
                    <a:ext cx="1440" cy="972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7080" bIns="-3708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89" name=""/>
                  <p:cNvSpPr/>
                  <p:nvPr/>
                </p:nvSpPr>
                <p:spPr>
                  <a:xfrm>
                    <a:off x="1964880" y="6339600"/>
                    <a:ext cx="1440" cy="972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7080" bIns="-3708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90" name=""/>
                  <p:cNvSpPr/>
                  <p:nvPr/>
                </p:nvSpPr>
                <p:spPr>
                  <a:xfrm>
                    <a:off x="2007720" y="6339600"/>
                    <a:ext cx="1440" cy="972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7080" bIns="-3708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91" name=""/>
                  <p:cNvSpPr/>
                  <p:nvPr/>
                </p:nvSpPr>
                <p:spPr>
                  <a:xfrm>
                    <a:off x="2040480" y="6339600"/>
                    <a:ext cx="1440" cy="1980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27000" bIns="-2700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92" name=""/>
                  <p:cNvSpPr/>
                  <p:nvPr/>
                </p:nvSpPr>
                <p:spPr>
                  <a:xfrm>
                    <a:off x="2068920" y="6339600"/>
                    <a:ext cx="1080" cy="972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7080" bIns="-3708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93" name=""/>
                  <p:cNvSpPr/>
                  <p:nvPr/>
                </p:nvSpPr>
                <p:spPr>
                  <a:xfrm>
                    <a:off x="2089440" y="6339600"/>
                    <a:ext cx="1080" cy="972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7080" bIns="-3708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94" name=""/>
                  <p:cNvSpPr/>
                  <p:nvPr/>
                </p:nvSpPr>
                <p:spPr>
                  <a:xfrm>
                    <a:off x="2111760" y="6339600"/>
                    <a:ext cx="1080" cy="972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7080" bIns="-3708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95" name=""/>
                  <p:cNvSpPr/>
                  <p:nvPr/>
                </p:nvSpPr>
                <p:spPr>
                  <a:xfrm>
                    <a:off x="2127960" y="6339600"/>
                    <a:ext cx="1440" cy="972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7080" bIns="-3708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96" name=""/>
                  <p:cNvSpPr/>
                  <p:nvPr/>
                </p:nvSpPr>
                <p:spPr>
                  <a:xfrm>
                    <a:off x="2144520" y="6339600"/>
                    <a:ext cx="1080" cy="3132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15480" bIns="-1548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</p:grpSp>
            <p:grpSp>
              <p:nvGrpSpPr>
                <p:cNvPr id="197" name=""/>
                <p:cNvGrpSpPr/>
                <p:nvPr/>
              </p:nvGrpSpPr>
              <p:grpSpPr>
                <a:xfrm>
                  <a:off x="672840" y="6378480"/>
                  <a:ext cx="1550880" cy="156240"/>
                  <a:chOff x="672840" y="6378480"/>
                  <a:chExt cx="1550880" cy="156240"/>
                </a:xfrm>
              </p:grpSpPr>
              <p:sp>
                <p:nvSpPr>
                  <p:cNvPr id="198" name=""/>
                  <p:cNvSpPr/>
                  <p:nvPr/>
                </p:nvSpPr>
                <p:spPr>
                  <a:xfrm>
                    <a:off x="672840" y="6412680"/>
                    <a:ext cx="113400" cy="12204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1" lang="en-US" sz="800" spc="-1" strike="noStrike">
                        <a:solidFill>
                          <a:srgbClr val="000000"/>
                        </a:solidFill>
                        <a:latin typeface="Arial"/>
                      </a:rPr>
                      <a:t>10</a:t>
                    </a:r>
                    <a:endParaRPr b="0" lang="en-US" sz="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99" name=""/>
                  <p:cNvSpPr/>
                  <p:nvPr/>
                </p:nvSpPr>
                <p:spPr>
                  <a:xfrm>
                    <a:off x="770400" y="6378480"/>
                    <a:ext cx="49320" cy="10692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1" lang="en-US" sz="700" spc="-1" strike="noStrike">
                        <a:solidFill>
                          <a:srgbClr val="000000"/>
                        </a:solidFill>
                        <a:latin typeface="Arial"/>
                      </a:rPr>
                      <a:t>0</a:t>
                    </a:r>
                    <a:endParaRPr b="0" lang="en-US" sz="7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200" name=""/>
                  <p:cNvSpPr/>
                  <p:nvPr/>
                </p:nvSpPr>
                <p:spPr>
                  <a:xfrm>
                    <a:off x="1021320" y="6412680"/>
                    <a:ext cx="113400" cy="12204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1" lang="en-US" sz="800" spc="-1" strike="noStrike">
                        <a:solidFill>
                          <a:srgbClr val="000000"/>
                        </a:solidFill>
                        <a:latin typeface="Arial"/>
                      </a:rPr>
                      <a:t>10</a:t>
                    </a:r>
                    <a:endParaRPr b="0" lang="en-US" sz="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201" name=""/>
                  <p:cNvSpPr/>
                  <p:nvPr/>
                </p:nvSpPr>
                <p:spPr>
                  <a:xfrm>
                    <a:off x="1116720" y="6378480"/>
                    <a:ext cx="49320" cy="10692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1" lang="en-US" sz="700" spc="-1" strike="noStrike">
                        <a:solidFill>
                          <a:srgbClr val="000000"/>
                        </a:solidFill>
                        <a:latin typeface="Arial"/>
                      </a:rPr>
                      <a:t>1</a:t>
                    </a:r>
                    <a:endParaRPr b="0" lang="en-US" sz="7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202" name=""/>
                  <p:cNvSpPr/>
                  <p:nvPr/>
                </p:nvSpPr>
                <p:spPr>
                  <a:xfrm>
                    <a:off x="1374120" y="6412680"/>
                    <a:ext cx="113400" cy="12204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1" lang="en-US" sz="800" spc="-1" strike="noStrike">
                        <a:solidFill>
                          <a:srgbClr val="000000"/>
                        </a:solidFill>
                        <a:latin typeface="Arial"/>
                      </a:rPr>
                      <a:t>10</a:t>
                    </a:r>
                    <a:endParaRPr b="0" lang="en-US" sz="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203" name=""/>
                  <p:cNvSpPr/>
                  <p:nvPr/>
                </p:nvSpPr>
                <p:spPr>
                  <a:xfrm>
                    <a:off x="1472400" y="6378480"/>
                    <a:ext cx="49320" cy="10692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1" lang="en-US" sz="700" spc="-1" strike="noStrike">
                        <a:solidFill>
                          <a:srgbClr val="000000"/>
                        </a:solidFill>
                        <a:latin typeface="Arial"/>
                      </a:rPr>
                      <a:t>2</a:t>
                    </a:r>
                    <a:endParaRPr b="0" lang="en-US" sz="7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204" name=""/>
                  <p:cNvSpPr/>
                  <p:nvPr/>
                </p:nvSpPr>
                <p:spPr>
                  <a:xfrm>
                    <a:off x="1727640" y="6412680"/>
                    <a:ext cx="113400" cy="12204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1" lang="en-US" sz="800" spc="-1" strike="noStrike">
                        <a:solidFill>
                          <a:srgbClr val="000000"/>
                        </a:solidFill>
                        <a:latin typeface="Arial"/>
                      </a:rPr>
                      <a:t>10</a:t>
                    </a:r>
                    <a:endParaRPr b="0" lang="en-US" sz="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205" name=""/>
                  <p:cNvSpPr/>
                  <p:nvPr/>
                </p:nvSpPr>
                <p:spPr>
                  <a:xfrm>
                    <a:off x="1824480" y="6378480"/>
                    <a:ext cx="49320" cy="10692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1" lang="en-US" sz="700" spc="-1" strike="noStrike">
                        <a:solidFill>
                          <a:srgbClr val="000000"/>
                        </a:solidFill>
                        <a:latin typeface="Arial"/>
                      </a:rPr>
                      <a:t>3</a:t>
                    </a:r>
                    <a:endParaRPr b="0" lang="en-US" sz="7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206" name=""/>
                  <p:cNvSpPr/>
                  <p:nvPr/>
                </p:nvSpPr>
                <p:spPr>
                  <a:xfrm>
                    <a:off x="2075400" y="6412680"/>
                    <a:ext cx="113400" cy="12204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1" lang="en-US" sz="800" spc="-1" strike="noStrike">
                        <a:solidFill>
                          <a:srgbClr val="000000"/>
                        </a:solidFill>
                        <a:latin typeface="Arial"/>
                      </a:rPr>
                      <a:t>10</a:t>
                    </a:r>
                    <a:endParaRPr b="0" lang="en-US" sz="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207" name=""/>
                  <p:cNvSpPr/>
                  <p:nvPr/>
                </p:nvSpPr>
                <p:spPr>
                  <a:xfrm>
                    <a:off x="2174400" y="6378480"/>
                    <a:ext cx="49320" cy="10692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1" lang="en-US" sz="700" spc="-1" strike="noStrike">
                        <a:solidFill>
                          <a:srgbClr val="000000"/>
                        </a:solidFill>
                        <a:latin typeface="Arial"/>
                      </a:rPr>
                      <a:t>4</a:t>
                    </a:r>
                    <a:endParaRPr b="0" lang="en-US" sz="7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</p:grpSp>
            <p:sp>
              <p:nvSpPr>
                <p:cNvPr id="208" name=""/>
                <p:cNvSpPr/>
                <p:nvPr/>
              </p:nvSpPr>
              <p:spPr>
                <a:xfrm>
                  <a:off x="1358280" y="6494400"/>
                  <a:ext cx="203400" cy="1220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800" spc="-1" strike="noStrike">
                      <a:solidFill>
                        <a:srgbClr val="000000"/>
                      </a:solidFill>
                      <a:latin typeface="Arial"/>
                    </a:rPr>
                    <a:t>CD4</a:t>
                  </a:r>
                  <a:endParaRPr b="0" lang="en-US" sz="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grpSp>
            <p:nvGrpSpPr>
              <p:cNvPr id="209" name=""/>
              <p:cNvGrpSpPr/>
              <p:nvPr/>
            </p:nvGrpSpPr>
            <p:grpSpPr>
              <a:xfrm>
                <a:off x="449280" y="5019480"/>
                <a:ext cx="293400" cy="1403280"/>
                <a:chOff x="449280" y="5019480"/>
                <a:chExt cx="293400" cy="1403280"/>
              </a:xfrm>
            </p:grpSpPr>
            <p:sp>
              <p:nvSpPr>
                <p:cNvPr id="210" name=""/>
                <p:cNvSpPr/>
                <p:nvPr/>
              </p:nvSpPr>
              <p:spPr>
                <a:xfrm flipV="1">
                  <a:off x="741240" y="5019480"/>
                  <a:ext cx="1440" cy="1315800"/>
                </a:xfrm>
                <a:prstGeom prst="line">
                  <a:avLst/>
                </a:prstGeom>
                <a:ln w="64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grpSp>
              <p:nvGrpSpPr>
                <p:cNvPr id="211" name=""/>
                <p:cNvGrpSpPr/>
                <p:nvPr/>
              </p:nvGrpSpPr>
              <p:grpSpPr>
                <a:xfrm>
                  <a:off x="542520" y="5092560"/>
                  <a:ext cx="169920" cy="1330200"/>
                  <a:chOff x="542520" y="5092560"/>
                  <a:chExt cx="169920" cy="1330200"/>
                </a:xfrm>
              </p:grpSpPr>
              <p:sp>
                <p:nvSpPr>
                  <p:cNvPr id="212" name=""/>
                  <p:cNvSpPr/>
                  <p:nvPr/>
                </p:nvSpPr>
                <p:spPr>
                  <a:xfrm>
                    <a:off x="637200" y="6300720"/>
                    <a:ext cx="57240" cy="12204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1" lang="en-US" sz="800" spc="-1" strike="noStrike">
                        <a:solidFill>
                          <a:srgbClr val="000000"/>
                        </a:solidFill>
                        <a:latin typeface="Arial"/>
                      </a:rPr>
                      <a:t>0</a:t>
                    </a:r>
                    <a:endParaRPr b="0" lang="en-US" sz="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213" name=""/>
                  <p:cNvSpPr/>
                  <p:nvPr/>
                </p:nvSpPr>
                <p:spPr>
                  <a:xfrm>
                    <a:off x="542520" y="5896440"/>
                    <a:ext cx="169920" cy="12204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1" lang="en-US" sz="800" spc="-1" strike="noStrike">
                        <a:solidFill>
                          <a:srgbClr val="000000"/>
                        </a:solidFill>
                        <a:latin typeface="Arial"/>
                      </a:rPr>
                      <a:t>100</a:t>
                    </a:r>
                    <a:endParaRPr b="0" lang="en-US" sz="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214" name=""/>
                  <p:cNvSpPr/>
                  <p:nvPr/>
                </p:nvSpPr>
                <p:spPr>
                  <a:xfrm>
                    <a:off x="542520" y="5495400"/>
                    <a:ext cx="169920" cy="12204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1" lang="en-US" sz="800" spc="-1" strike="noStrike">
                        <a:solidFill>
                          <a:srgbClr val="000000"/>
                        </a:solidFill>
                        <a:latin typeface="Arial"/>
                      </a:rPr>
                      <a:t>200</a:t>
                    </a:r>
                    <a:endParaRPr b="0" lang="en-US" sz="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215" name=""/>
                  <p:cNvSpPr/>
                  <p:nvPr/>
                </p:nvSpPr>
                <p:spPr>
                  <a:xfrm>
                    <a:off x="542520" y="5092560"/>
                    <a:ext cx="169920" cy="12204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1" lang="en-US" sz="800" spc="-1" strike="noStrike">
                        <a:solidFill>
                          <a:srgbClr val="000000"/>
                        </a:solidFill>
                        <a:latin typeface="Arial"/>
                      </a:rPr>
                      <a:t>300</a:t>
                    </a:r>
                    <a:endParaRPr b="0" lang="en-US" sz="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</p:grpSp>
            <p:grpSp>
              <p:nvGrpSpPr>
                <p:cNvPr id="216" name=""/>
                <p:cNvGrpSpPr/>
                <p:nvPr/>
              </p:nvGrpSpPr>
              <p:grpSpPr>
                <a:xfrm>
                  <a:off x="708480" y="5025240"/>
                  <a:ext cx="32400" cy="1311120"/>
                  <a:chOff x="708480" y="5025240"/>
                  <a:chExt cx="32400" cy="1311120"/>
                </a:xfrm>
              </p:grpSpPr>
              <p:sp>
                <p:nvSpPr>
                  <p:cNvPr id="217" name=""/>
                  <p:cNvSpPr/>
                  <p:nvPr/>
                </p:nvSpPr>
                <p:spPr>
                  <a:xfrm flipH="1">
                    <a:off x="708480" y="6335280"/>
                    <a:ext cx="32400" cy="108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5720" bIns="-4572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218" name=""/>
                  <p:cNvSpPr/>
                  <p:nvPr/>
                </p:nvSpPr>
                <p:spPr>
                  <a:xfrm flipH="1">
                    <a:off x="730440" y="6237720"/>
                    <a:ext cx="10080" cy="108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5720" bIns="-4572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219" name=""/>
                  <p:cNvSpPr/>
                  <p:nvPr/>
                </p:nvSpPr>
                <p:spPr>
                  <a:xfrm flipH="1">
                    <a:off x="730440" y="6136200"/>
                    <a:ext cx="10080" cy="108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5720" bIns="-4572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220" name=""/>
                  <p:cNvSpPr/>
                  <p:nvPr/>
                </p:nvSpPr>
                <p:spPr>
                  <a:xfrm flipH="1">
                    <a:off x="730440" y="6034320"/>
                    <a:ext cx="10080" cy="108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5720" bIns="-4572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221" name=""/>
                  <p:cNvSpPr/>
                  <p:nvPr/>
                </p:nvSpPr>
                <p:spPr>
                  <a:xfrm flipH="1">
                    <a:off x="708480" y="5932440"/>
                    <a:ext cx="32400" cy="108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5720" bIns="-4572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222" name=""/>
                  <p:cNvSpPr/>
                  <p:nvPr/>
                </p:nvSpPr>
                <p:spPr>
                  <a:xfrm flipH="1">
                    <a:off x="730440" y="5830560"/>
                    <a:ext cx="10080" cy="144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5360" bIns="-4536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223" name=""/>
                  <p:cNvSpPr/>
                  <p:nvPr/>
                </p:nvSpPr>
                <p:spPr>
                  <a:xfrm flipH="1">
                    <a:off x="730440" y="5733360"/>
                    <a:ext cx="10080" cy="108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5720" bIns="-4572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224" name=""/>
                  <p:cNvSpPr/>
                  <p:nvPr/>
                </p:nvSpPr>
                <p:spPr>
                  <a:xfrm flipH="1">
                    <a:off x="730440" y="5631120"/>
                    <a:ext cx="10080" cy="144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5360" bIns="-4536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225" name=""/>
                  <p:cNvSpPr/>
                  <p:nvPr/>
                </p:nvSpPr>
                <p:spPr>
                  <a:xfrm flipH="1">
                    <a:off x="708480" y="5529600"/>
                    <a:ext cx="32400" cy="144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5360" bIns="-4536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226" name=""/>
                  <p:cNvSpPr/>
                  <p:nvPr/>
                </p:nvSpPr>
                <p:spPr>
                  <a:xfrm flipH="1">
                    <a:off x="730440" y="5427720"/>
                    <a:ext cx="10080" cy="144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5360" bIns="-4536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227" name=""/>
                  <p:cNvSpPr/>
                  <p:nvPr/>
                </p:nvSpPr>
                <p:spPr>
                  <a:xfrm flipH="1">
                    <a:off x="730440" y="5324760"/>
                    <a:ext cx="10080" cy="108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5720" bIns="-4572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228" name=""/>
                  <p:cNvSpPr/>
                  <p:nvPr/>
                </p:nvSpPr>
                <p:spPr>
                  <a:xfrm flipH="1">
                    <a:off x="730440" y="5228640"/>
                    <a:ext cx="10080" cy="144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5360" bIns="-4536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229" name=""/>
                  <p:cNvSpPr/>
                  <p:nvPr/>
                </p:nvSpPr>
                <p:spPr>
                  <a:xfrm flipH="1">
                    <a:off x="708480" y="5126760"/>
                    <a:ext cx="32400" cy="144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5360" bIns="-4536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230" name=""/>
                  <p:cNvSpPr/>
                  <p:nvPr/>
                </p:nvSpPr>
                <p:spPr>
                  <a:xfrm flipH="1">
                    <a:off x="730440" y="5025240"/>
                    <a:ext cx="10080" cy="144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5360" bIns="-4536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</p:grpSp>
            <p:sp>
              <p:nvSpPr>
                <p:cNvPr id="231" name=""/>
                <p:cNvSpPr/>
                <p:nvPr/>
              </p:nvSpPr>
              <p:spPr>
                <a:xfrm rot="16200000">
                  <a:off x="345240" y="5578920"/>
                  <a:ext cx="329760" cy="1220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800" spc="-1" strike="noStrike">
                      <a:solidFill>
                        <a:srgbClr val="000000"/>
                      </a:solidFill>
                      <a:latin typeface="Arial"/>
                    </a:rPr>
                    <a:t># Cells</a:t>
                  </a:r>
                  <a:endParaRPr b="0" lang="en-US" sz="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</p:grpSp>
        <p:grpSp>
          <p:nvGrpSpPr>
            <p:cNvPr id="232" name=""/>
            <p:cNvGrpSpPr/>
            <p:nvPr/>
          </p:nvGrpSpPr>
          <p:grpSpPr>
            <a:xfrm>
              <a:off x="753480" y="5029560"/>
              <a:ext cx="1381320" cy="1300320"/>
              <a:chOff x="753480" y="5029560"/>
              <a:chExt cx="1381320" cy="1300320"/>
            </a:xfrm>
          </p:grpSpPr>
          <p:sp>
            <p:nvSpPr>
              <p:cNvPr id="233" name=""/>
              <p:cNvSpPr/>
              <p:nvPr/>
            </p:nvSpPr>
            <p:spPr>
              <a:xfrm>
                <a:off x="753480" y="5029560"/>
                <a:ext cx="1381320" cy="1300320"/>
              </a:xfrm>
              <a:custGeom>
                <a:avLst/>
                <a:gdLst/>
                <a:ahLst/>
                <a:rect l="l" t="t" r="r" b="b"/>
                <a:pathLst>
                  <a:path w="931" h="907">
                    <a:moveTo>
                      <a:pt x="0" y="907"/>
                    </a:moveTo>
                    <a:lnTo>
                      <a:pt x="0" y="0"/>
                    </a:lnTo>
                    <a:lnTo>
                      <a:pt x="3" y="786"/>
                    </a:lnTo>
                    <a:lnTo>
                      <a:pt x="7" y="900"/>
                    </a:lnTo>
                    <a:lnTo>
                      <a:pt x="11" y="900"/>
                    </a:lnTo>
                    <a:lnTo>
                      <a:pt x="14" y="896"/>
                    </a:lnTo>
                    <a:lnTo>
                      <a:pt x="18" y="896"/>
                    </a:lnTo>
                    <a:lnTo>
                      <a:pt x="22" y="896"/>
                    </a:lnTo>
                    <a:lnTo>
                      <a:pt x="25" y="896"/>
                    </a:lnTo>
                    <a:lnTo>
                      <a:pt x="29" y="896"/>
                    </a:lnTo>
                    <a:lnTo>
                      <a:pt x="33" y="896"/>
                    </a:lnTo>
                    <a:lnTo>
                      <a:pt x="36" y="900"/>
                    </a:lnTo>
                    <a:lnTo>
                      <a:pt x="40" y="900"/>
                    </a:lnTo>
                    <a:lnTo>
                      <a:pt x="44" y="900"/>
                    </a:lnTo>
                    <a:lnTo>
                      <a:pt x="47" y="900"/>
                    </a:lnTo>
                    <a:lnTo>
                      <a:pt x="51" y="900"/>
                    </a:lnTo>
                    <a:lnTo>
                      <a:pt x="55" y="896"/>
                    </a:lnTo>
                    <a:lnTo>
                      <a:pt x="58" y="896"/>
                    </a:lnTo>
                    <a:lnTo>
                      <a:pt x="62" y="896"/>
                    </a:lnTo>
                    <a:lnTo>
                      <a:pt x="66" y="896"/>
                    </a:lnTo>
                    <a:lnTo>
                      <a:pt x="69" y="893"/>
                    </a:lnTo>
                    <a:lnTo>
                      <a:pt x="73" y="893"/>
                    </a:lnTo>
                    <a:lnTo>
                      <a:pt x="77" y="889"/>
                    </a:lnTo>
                    <a:lnTo>
                      <a:pt x="80" y="889"/>
                    </a:lnTo>
                    <a:lnTo>
                      <a:pt x="84" y="889"/>
                    </a:lnTo>
                    <a:lnTo>
                      <a:pt x="88" y="893"/>
                    </a:lnTo>
                    <a:lnTo>
                      <a:pt x="91" y="893"/>
                    </a:lnTo>
                    <a:lnTo>
                      <a:pt x="95" y="896"/>
                    </a:lnTo>
                    <a:lnTo>
                      <a:pt x="99" y="896"/>
                    </a:lnTo>
                    <a:lnTo>
                      <a:pt x="102" y="893"/>
                    </a:lnTo>
                    <a:lnTo>
                      <a:pt x="106" y="893"/>
                    </a:lnTo>
                    <a:lnTo>
                      <a:pt x="110" y="889"/>
                    </a:lnTo>
                    <a:lnTo>
                      <a:pt x="113" y="889"/>
                    </a:lnTo>
                    <a:lnTo>
                      <a:pt x="117" y="886"/>
                    </a:lnTo>
                    <a:lnTo>
                      <a:pt x="121" y="886"/>
                    </a:lnTo>
                    <a:lnTo>
                      <a:pt x="124" y="886"/>
                    </a:lnTo>
                    <a:lnTo>
                      <a:pt x="128" y="889"/>
                    </a:lnTo>
                    <a:lnTo>
                      <a:pt x="132" y="889"/>
                    </a:lnTo>
                    <a:lnTo>
                      <a:pt x="135" y="889"/>
                    </a:lnTo>
                    <a:lnTo>
                      <a:pt x="139" y="889"/>
                    </a:lnTo>
                    <a:lnTo>
                      <a:pt x="143" y="889"/>
                    </a:lnTo>
                    <a:lnTo>
                      <a:pt x="146" y="886"/>
                    </a:lnTo>
                    <a:lnTo>
                      <a:pt x="150" y="886"/>
                    </a:lnTo>
                    <a:lnTo>
                      <a:pt x="154" y="882"/>
                    </a:lnTo>
                    <a:lnTo>
                      <a:pt x="157" y="882"/>
                    </a:lnTo>
                    <a:lnTo>
                      <a:pt x="161" y="886"/>
                    </a:lnTo>
                    <a:lnTo>
                      <a:pt x="165" y="886"/>
                    </a:lnTo>
                    <a:lnTo>
                      <a:pt x="168" y="886"/>
                    </a:lnTo>
                    <a:lnTo>
                      <a:pt x="172" y="886"/>
                    </a:lnTo>
                    <a:lnTo>
                      <a:pt x="176" y="886"/>
                    </a:lnTo>
                    <a:lnTo>
                      <a:pt x="179" y="886"/>
                    </a:lnTo>
                    <a:lnTo>
                      <a:pt x="183" y="882"/>
                    </a:lnTo>
                    <a:lnTo>
                      <a:pt x="187" y="882"/>
                    </a:lnTo>
                    <a:lnTo>
                      <a:pt x="190" y="882"/>
                    </a:lnTo>
                    <a:lnTo>
                      <a:pt x="194" y="882"/>
                    </a:lnTo>
                    <a:lnTo>
                      <a:pt x="198" y="882"/>
                    </a:lnTo>
                    <a:lnTo>
                      <a:pt x="201" y="882"/>
                    </a:lnTo>
                    <a:lnTo>
                      <a:pt x="205" y="882"/>
                    </a:lnTo>
                    <a:lnTo>
                      <a:pt x="209" y="886"/>
                    </a:lnTo>
                    <a:lnTo>
                      <a:pt x="212" y="886"/>
                    </a:lnTo>
                    <a:lnTo>
                      <a:pt x="216" y="886"/>
                    </a:lnTo>
                    <a:lnTo>
                      <a:pt x="220" y="886"/>
                    </a:lnTo>
                    <a:lnTo>
                      <a:pt x="223" y="886"/>
                    </a:lnTo>
                    <a:lnTo>
                      <a:pt x="227" y="882"/>
                    </a:lnTo>
                    <a:lnTo>
                      <a:pt x="231" y="882"/>
                    </a:lnTo>
                    <a:lnTo>
                      <a:pt x="234" y="882"/>
                    </a:lnTo>
                    <a:lnTo>
                      <a:pt x="238" y="882"/>
                    </a:lnTo>
                    <a:lnTo>
                      <a:pt x="242" y="882"/>
                    </a:lnTo>
                    <a:lnTo>
                      <a:pt x="245" y="882"/>
                    </a:lnTo>
                    <a:lnTo>
                      <a:pt x="249" y="882"/>
                    </a:lnTo>
                    <a:lnTo>
                      <a:pt x="253" y="882"/>
                    </a:lnTo>
                    <a:lnTo>
                      <a:pt x="256" y="882"/>
                    </a:lnTo>
                    <a:lnTo>
                      <a:pt x="260" y="882"/>
                    </a:lnTo>
                    <a:lnTo>
                      <a:pt x="264" y="882"/>
                    </a:lnTo>
                    <a:lnTo>
                      <a:pt x="267" y="882"/>
                    </a:lnTo>
                    <a:lnTo>
                      <a:pt x="271" y="882"/>
                    </a:lnTo>
                    <a:lnTo>
                      <a:pt x="275" y="886"/>
                    </a:lnTo>
                    <a:lnTo>
                      <a:pt x="278" y="886"/>
                    </a:lnTo>
                    <a:lnTo>
                      <a:pt x="282" y="882"/>
                    </a:lnTo>
                    <a:lnTo>
                      <a:pt x="286" y="882"/>
                    </a:lnTo>
                    <a:lnTo>
                      <a:pt x="289" y="879"/>
                    </a:lnTo>
                    <a:lnTo>
                      <a:pt x="293" y="879"/>
                    </a:lnTo>
                    <a:lnTo>
                      <a:pt x="297" y="879"/>
                    </a:lnTo>
                    <a:lnTo>
                      <a:pt x="300" y="882"/>
                    </a:lnTo>
                    <a:lnTo>
                      <a:pt x="304" y="882"/>
                    </a:lnTo>
                    <a:lnTo>
                      <a:pt x="308" y="882"/>
                    </a:lnTo>
                    <a:lnTo>
                      <a:pt x="311" y="879"/>
                    </a:lnTo>
                    <a:lnTo>
                      <a:pt x="315" y="879"/>
                    </a:lnTo>
                    <a:lnTo>
                      <a:pt x="319" y="875"/>
                    </a:lnTo>
                    <a:lnTo>
                      <a:pt x="322" y="875"/>
                    </a:lnTo>
                    <a:lnTo>
                      <a:pt x="326" y="879"/>
                    </a:lnTo>
                    <a:lnTo>
                      <a:pt x="330" y="879"/>
                    </a:lnTo>
                    <a:lnTo>
                      <a:pt x="333" y="879"/>
                    </a:lnTo>
                    <a:lnTo>
                      <a:pt x="337" y="879"/>
                    </a:lnTo>
                    <a:lnTo>
                      <a:pt x="341" y="879"/>
                    </a:lnTo>
                    <a:lnTo>
                      <a:pt x="344" y="879"/>
                    </a:lnTo>
                    <a:lnTo>
                      <a:pt x="348" y="879"/>
                    </a:lnTo>
                    <a:lnTo>
                      <a:pt x="352" y="875"/>
                    </a:lnTo>
                    <a:lnTo>
                      <a:pt x="355" y="875"/>
                    </a:lnTo>
                    <a:lnTo>
                      <a:pt x="359" y="875"/>
                    </a:lnTo>
                    <a:lnTo>
                      <a:pt x="363" y="875"/>
                    </a:lnTo>
                    <a:lnTo>
                      <a:pt x="366" y="875"/>
                    </a:lnTo>
                    <a:lnTo>
                      <a:pt x="370" y="875"/>
                    </a:lnTo>
                    <a:lnTo>
                      <a:pt x="374" y="875"/>
                    </a:lnTo>
                    <a:lnTo>
                      <a:pt x="377" y="875"/>
                    </a:lnTo>
                    <a:lnTo>
                      <a:pt x="381" y="872"/>
                    </a:lnTo>
                    <a:lnTo>
                      <a:pt x="385" y="872"/>
                    </a:lnTo>
                    <a:lnTo>
                      <a:pt x="388" y="872"/>
                    </a:lnTo>
                    <a:lnTo>
                      <a:pt x="392" y="872"/>
                    </a:lnTo>
                    <a:lnTo>
                      <a:pt x="395" y="872"/>
                    </a:lnTo>
                    <a:lnTo>
                      <a:pt x="399" y="872"/>
                    </a:lnTo>
                    <a:lnTo>
                      <a:pt x="403" y="872"/>
                    </a:lnTo>
                    <a:lnTo>
                      <a:pt x="406" y="872"/>
                    </a:lnTo>
                    <a:lnTo>
                      <a:pt x="410" y="872"/>
                    </a:lnTo>
                    <a:lnTo>
                      <a:pt x="414" y="872"/>
                    </a:lnTo>
                    <a:lnTo>
                      <a:pt x="417" y="868"/>
                    </a:lnTo>
                    <a:lnTo>
                      <a:pt x="421" y="868"/>
                    </a:lnTo>
                    <a:lnTo>
                      <a:pt x="425" y="864"/>
                    </a:lnTo>
                    <a:lnTo>
                      <a:pt x="428" y="864"/>
                    </a:lnTo>
                    <a:lnTo>
                      <a:pt x="432" y="864"/>
                    </a:lnTo>
                    <a:lnTo>
                      <a:pt x="436" y="864"/>
                    </a:lnTo>
                    <a:lnTo>
                      <a:pt x="439" y="861"/>
                    </a:lnTo>
                    <a:lnTo>
                      <a:pt x="443" y="854"/>
                    </a:lnTo>
                    <a:lnTo>
                      <a:pt x="447" y="847"/>
                    </a:lnTo>
                    <a:lnTo>
                      <a:pt x="450" y="843"/>
                    </a:lnTo>
                    <a:lnTo>
                      <a:pt x="454" y="843"/>
                    </a:lnTo>
                    <a:lnTo>
                      <a:pt x="458" y="843"/>
                    </a:lnTo>
                    <a:lnTo>
                      <a:pt x="461" y="840"/>
                    </a:lnTo>
                    <a:lnTo>
                      <a:pt x="465" y="836"/>
                    </a:lnTo>
                    <a:lnTo>
                      <a:pt x="469" y="829"/>
                    </a:lnTo>
                    <a:lnTo>
                      <a:pt x="472" y="822"/>
                    </a:lnTo>
                    <a:lnTo>
                      <a:pt x="476" y="818"/>
                    </a:lnTo>
                    <a:lnTo>
                      <a:pt x="480" y="811"/>
                    </a:lnTo>
                    <a:lnTo>
                      <a:pt x="483" y="797"/>
                    </a:lnTo>
                    <a:lnTo>
                      <a:pt x="487" y="776"/>
                    </a:lnTo>
                    <a:lnTo>
                      <a:pt x="491" y="758"/>
                    </a:lnTo>
                    <a:lnTo>
                      <a:pt x="494" y="747"/>
                    </a:lnTo>
                    <a:lnTo>
                      <a:pt x="498" y="740"/>
                    </a:lnTo>
                    <a:lnTo>
                      <a:pt x="502" y="729"/>
                    </a:lnTo>
                    <a:lnTo>
                      <a:pt x="505" y="708"/>
                    </a:lnTo>
                    <a:lnTo>
                      <a:pt x="509" y="687"/>
                    </a:lnTo>
                    <a:lnTo>
                      <a:pt x="513" y="679"/>
                    </a:lnTo>
                    <a:lnTo>
                      <a:pt x="516" y="683"/>
                    </a:lnTo>
                    <a:lnTo>
                      <a:pt x="520" y="672"/>
                    </a:lnTo>
                    <a:lnTo>
                      <a:pt x="524" y="651"/>
                    </a:lnTo>
                    <a:lnTo>
                      <a:pt x="527" y="626"/>
                    </a:lnTo>
                    <a:lnTo>
                      <a:pt x="531" y="587"/>
                    </a:lnTo>
                    <a:lnTo>
                      <a:pt x="535" y="537"/>
                    </a:lnTo>
                    <a:lnTo>
                      <a:pt x="538" y="509"/>
                    </a:lnTo>
                    <a:lnTo>
                      <a:pt x="542" y="498"/>
                    </a:lnTo>
                    <a:lnTo>
                      <a:pt x="546" y="470"/>
                    </a:lnTo>
                    <a:lnTo>
                      <a:pt x="549" y="434"/>
                    </a:lnTo>
                    <a:lnTo>
                      <a:pt x="553" y="402"/>
                    </a:lnTo>
                    <a:lnTo>
                      <a:pt x="557" y="363"/>
                    </a:lnTo>
                    <a:lnTo>
                      <a:pt x="560" y="317"/>
                    </a:lnTo>
                    <a:lnTo>
                      <a:pt x="564" y="253"/>
                    </a:lnTo>
                    <a:lnTo>
                      <a:pt x="568" y="196"/>
                    </a:lnTo>
                    <a:lnTo>
                      <a:pt x="571" y="178"/>
                    </a:lnTo>
                    <a:lnTo>
                      <a:pt x="575" y="221"/>
                    </a:lnTo>
                    <a:lnTo>
                      <a:pt x="579" y="196"/>
                    </a:lnTo>
                    <a:lnTo>
                      <a:pt x="582" y="142"/>
                    </a:lnTo>
                    <a:lnTo>
                      <a:pt x="586" y="114"/>
                    </a:lnTo>
                    <a:lnTo>
                      <a:pt x="590" y="96"/>
                    </a:lnTo>
                    <a:lnTo>
                      <a:pt x="593" y="75"/>
                    </a:lnTo>
                    <a:lnTo>
                      <a:pt x="597" y="50"/>
                    </a:lnTo>
                    <a:lnTo>
                      <a:pt x="601" y="39"/>
                    </a:lnTo>
                    <a:lnTo>
                      <a:pt x="604" y="75"/>
                    </a:lnTo>
                    <a:lnTo>
                      <a:pt x="608" y="157"/>
                    </a:lnTo>
                    <a:lnTo>
                      <a:pt x="612" y="203"/>
                    </a:lnTo>
                    <a:lnTo>
                      <a:pt x="615" y="203"/>
                    </a:lnTo>
                    <a:lnTo>
                      <a:pt x="619" y="313"/>
                    </a:lnTo>
                    <a:lnTo>
                      <a:pt x="623" y="455"/>
                    </a:lnTo>
                    <a:lnTo>
                      <a:pt x="626" y="555"/>
                    </a:lnTo>
                    <a:lnTo>
                      <a:pt x="630" y="637"/>
                    </a:lnTo>
                    <a:lnTo>
                      <a:pt x="634" y="722"/>
                    </a:lnTo>
                    <a:lnTo>
                      <a:pt x="637" y="783"/>
                    </a:lnTo>
                    <a:lnTo>
                      <a:pt x="641" y="815"/>
                    </a:lnTo>
                    <a:lnTo>
                      <a:pt x="645" y="836"/>
                    </a:lnTo>
                    <a:lnTo>
                      <a:pt x="648" y="850"/>
                    </a:lnTo>
                    <a:lnTo>
                      <a:pt x="652" y="861"/>
                    </a:lnTo>
                    <a:lnTo>
                      <a:pt x="656" y="868"/>
                    </a:lnTo>
                    <a:lnTo>
                      <a:pt x="659" y="875"/>
                    </a:lnTo>
                    <a:lnTo>
                      <a:pt x="663" y="882"/>
                    </a:lnTo>
                    <a:lnTo>
                      <a:pt x="667" y="889"/>
                    </a:lnTo>
                    <a:lnTo>
                      <a:pt x="670" y="893"/>
                    </a:lnTo>
                    <a:lnTo>
                      <a:pt x="674" y="896"/>
                    </a:lnTo>
                    <a:lnTo>
                      <a:pt x="678" y="896"/>
                    </a:lnTo>
                    <a:lnTo>
                      <a:pt x="681" y="900"/>
                    </a:lnTo>
                    <a:lnTo>
                      <a:pt x="685" y="900"/>
                    </a:lnTo>
                    <a:lnTo>
                      <a:pt x="689" y="900"/>
                    </a:lnTo>
                    <a:lnTo>
                      <a:pt x="692" y="900"/>
                    </a:lnTo>
                    <a:lnTo>
                      <a:pt x="696" y="900"/>
                    </a:lnTo>
                    <a:lnTo>
                      <a:pt x="700" y="904"/>
                    </a:lnTo>
                    <a:lnTo>
                      <a:pt x="703" y="904"/>
                    </a:lnTo>
                    <a:lnTo>
                      <a:pt x="707" y="904"/>
                    </a:lnTo>
                    <a:lnTo>
                      <a:pt x="711" y="904"/>
                    </a:lnTo>
                    <a:lnTo>
                      <a:pt x="714" y="904"/>
                    </a:lnTo>
                    <a:lnTo>
                      <a:pt x="718" y="904"/>
                    </a:lnTo>
                    <a:lnTo>
                      <a:pt x="722" y="904"/>
                    </a:lnTo>
                    <a:lnTo>
                      <a:pt x="725" y="904"/>
                    </a:lnTo>
                    <a:lnTo>
                      <a:pt x="729" y="904"/>
                    </a:lnTo>
                    <a:lnTo>
                      <a:pt x="733" y="904"/>
                    </a:lnTo>
                    <a:lnTo>
                      <a:pt x="736" y="904"/>
                    </a:lnTo>
                    <a:lnTo>
                      <a:pt x="740" y="904"/>
                    </a:lnTo>
                    <a:lnTo>
                      <a:pt x="744" y="904"/>
                    </a:lnTo>
                    <a:lnTo>
                      <a:pt x="747" y="904"/>
                    </a:lnTo>
                    <a:lnTo>
                      <a:pt x="751" y="904"/>
                    </a:lnTo>
                    <a:lnTo>
                      <a:pt x="755" y="904"/>
                    </a:lnTo>
                    <a:lnTo>
                      <a:pt x="758" y="904"/>
                    </a:lnTo>
                    <a:lnTo>
                      <a:pt x="762" y="904"/>
                    </a:lnTo>
                    <a:lnTo>
                      <a:pt x="766" y="904"/>
                    </a:lnTo>
                    <a:lnTo>
                      <a:pt x="769" y="904"/>
                    </a:lnTo>
                    <a:lnTo>
                      <a:pt x="773" y="904"/>
                    </a:lnTo>
                    <a:lnTo>
                      <a:pt x="777" y="904"/>
                    </a:lnTo>
                    <a:lnTo>
                      <a:pt x="780" y="904"/>
                    </a:lnTo>
                    <a:lnTo>
                      <a:pt x="784" y="904"/>
                    </a:lnTo>
                    <a:lnTo>
                      <a:pt x="788" y="904"/>
                    </a:lnTo>
                    <a:lnTo>
                      <a:pt x="791" y="904"/>
                    </a:lnTo>
                    <a:lnTo>
                      <a:pt x="795" y="904"/>
                    </a:lnTo>
                    <a:lnTo>
                      <a:pt x="799" y="904"/>
                    </a:lnTo>
                    <a:lnTo>
                      <a:pt x="802" y="904"/>
                    </a:lnTo>
                    <a:lnTo>
                      <a:pt x="806" y="904"/>
                    </a:lnTo>
                    <a:lnTo>
                      <a:pt x="810" y="904"/>
                    </a:lnTo>
                    <a:lnTo>
                      <a:pt x="813" y="904"/>
                    </a:lnTo>
                    <a:lnTo>
                      <a:pt x="817" y="904"/>
                    </a:lnTo>
                    <a:lnTo>
                      <a:pt x="821" y="904"/>
                    </a:lnTo>
                    <a:lnTo>
                      <a:pt x="824" y="904"/>
                    </a:lnTo>
                    <a:lnTo>
                      <a:pt x="828" y="907"/>
                    </a:lnTo>
                    <a:lnTo>
                      <a:pt x="832" y="907"/>
                    </a:lnTo>
                    <a:lnTo>
                      <a:pt x="835" y="907"/>
                    </a:lnTo>
                    <a:lnTo>
                      <a:pt x="839" y="907"/>
                    </a:lnTo>
                    <a:lnTo>
                      <a:pt x="843" y="907"/>
                    </a:lnTo>
                    <a:lnTo>
                      <a:pt x="846" y="907"/>
                    </a:lnTo>
                    <a:lnTo>
                      <a:pt x="850" y="907"/>
                    </a:lnTo>
                    <a:lnTo>
                      <a:pt x="854" y="907"/>
                    </a:lnTo>
                    <a:lnTo>
                      <a:pt x="857" y="907"/>
                    </a:lnTo>
                    <a:lnTo>
                      <a:pt x="861" y="907"/>
                    </a:lnTo>
                    <a:lnTo>
                      <a:pt x="865" y="907"/>
                    </a:lnTo>
                    <a:lnTo>
                      <a:pt x="868" y="907"/>
                    </a:lnTo>
                    <a:lnTo>
                      <a:pt x="872" y="907"/>
                    </a:lnTo>
                    <a:lnTo>
                      <a:pt x="876" y="907"/>
                    </a:lnTo>
                    <a:lnTo>
                      <a:pt x="879" y="907"/>
                    </a:lnTo>
                    <a:lnTo>
                      <a:pt x="883" y="907"/>
                    </a:lnTo>
                    <a:lnTo>
                      <a:pt x="887" y="907"/>
                    </a:lnTo>
                    <a:lnTo>
                      <a:pt x="890" y="907"/>
                    </a:lnTo>
                    <a:lnTo>
                      <a:pt x="894" y="907"/>
                    </a:lnTo>
                    <a:lnTo>
                      <a:pt x="898" y="907"/>
                    </a:lnTo>
                    <a:lnTo>
                      <a:pt x="901" y="907"/>
                    </a:lnTo>
                    <a:lnTo>
                      <a:pt x="905" y="907"/>
                    </a:lnTo>
                    <a:lnTo>
                      <a:pt x="909" y="907"/>
                    </a:lnTo>
                    <a:lnTo>
                      <a:pt x="912" y="907"/>
                    </a:lnTo>
                    <a:lnTo>
                      <a:pt x="916" y="907"/>
                    </a:lnTo>
                    <a:lnTo>
                      <a:pt x="920" y="907"/>
                    </a:lnTo>
                    <a:lnTo>
                      <a:pt x="923" y="907"/>
                    </a:lnTo>
                    <a:lnTo>
                      <a:pt x="927" y="907"/>
                    </a:lnTo>
                    <a:lnTo>
                      <a:pt x="931" y="907"/>
                    </a:lnTo>
                  </a:path>
                </a:pathLst>
              </a:custGeom>
              <a:noFill/>
              <a:ln w="64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grpSp>
            <p:nvGrpSpPr>
              <p:cNvPr id="234" name=""/>
              <p:cNvGrpSpPr/>
              <p:nvPr/>
            </p:nvGrpSpPr>
            <p:grpSpPr>
              <a:xfrm>
                <a:off x="1437120" y="5396400"/>
                <a:ext cx="585360" cy="316440"/>
                <a:chOff x="1437120" y="5396400"/>
                <a:chExt cx="585360" cy="316440"/>
              </a:xfrm>
            </p:grpSpPr>
            <p:grpSp>
              <p:nvGrpSpPr>
                <p:cNvPr id="235" name=""/>
                <p:cNvGrpSpPr/>
                <p:nvPr/>
              </p:nvGrpSpPr>
              <p:grpSpPr>
                <a:xfrm>
                  <a:off x="1437120" y="5651280"/>
                  <a:ext cx="480240" cy="61560"/>
                  <a:chOff x="1437120" y="5651280"/>
                  <a:chExt cx="480240" cy="61560"/>
                </a:xfrm>
              </p:grpSpPr>
              <p:sp>
                <p:nvSpPr>
                  <p:cNvPr id="236" name=""/>
                  <p:cNvSpPr/>
                  <p:nvPr/>
                </p:nvSpPr>
                <p:spPr>
                  <a:xfrm>
                    <a:off x="1437120" y="5651280"/>
                    <a:ext cx="1440" cy="6156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14760" bIns="1476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237" name=""/>
                  <p:cNvSpPr/>
                  <p:nvPr/>
                </p:nvSpPr>
                <p:spPr>
                  <a:xfrm>
                    <a:off x="1916280" y="5651280"/>
                    <a:ext cx="1080" cy="6156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14760" bIns="1476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238" name=""/>
                  <p:cNvSpPr/>
                  <p:nvPr/>
                </p:nvSpPr>
                <p:spPr>
                  <a:xfrm>
                    <a:off x="1437120" y="5677200"/>
                    <a:ext cx="473040" cy="1080"/>
                  </a:xfrm>
                  <a:prstGeom prst="line">
                    <a:avLst/>
                  </a:prstGeom>
                  <a:ln w="111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5720" bIns="-4572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</p:grpSp>
            <p:sp>
              <p:nvSpPr>
                <p:cNvPr id="239" name=""/>
                <p:cNvSpPr/>
                <p:nvPr/>
              </p:nvSpPr>
              <p:spPr>
                <a:xfrm>
                  <a:off x="1742760" y="5396400"/>
                  <a:ext cx="261000" cy="147600"/>
                </a:xfrm>
                <a:custGeom>
                  <a:avLst/>
                  <a:gdLst/>
                  <a:ahLst/>
                  <a:rect l="l" t="t" r="r" b="b"/>
                  <a:pathLst>
                    <a:path w="176" h="103">
                      <a:moveTo>
                        <a:pt x="0" y="4"/>
                      </a:moveTo>
                      <a:lnTo>
                        <a:pt x="0" y="103"/>
                      </a:lnTo>
                      <a:lnTo>
                        <a:pt x="0" y="103"/>
                      </a:lnTo>
                      <a:lnTo>
                        <a:pt x="176" y="103"/>
                      </a:lnTo>
                      <a:lnTo>
                        <a:pt x="176" y="0"/>
                      </a:lnTo>
                      <a:lnTo>
                        <a:pt x="176" y="0"/>
                      </a:lnTo>
                      <a:lnTo>
                        <a:pt x="0" y="0"/>
                      </a:lnTo>
                      <a:lnTo>
                        <a:pt x="0" y="4"/>
                      </a:lnTo>
                      <a:close/>
                    </a:path>
                  </a:pathLst>
                </a:custGeom>
                <a:solidFill>
                  <a:srgbClr val="ffffff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40" name=""/>
                <p:cNvSpPr/>
                <p:nvPr/>
              </p:nvSpPr>
              <p:spPr>
                <a:xfrm>
                  <a:off x="1748880" y="5403240"/>
                  <a:ext cx="273600" cy="16776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1100" spc="-1" strike="noStrike">
                      <a:solidFill>
                        <a:srgbClr val="000000"/>
                      </a:solidFill>
                      <a:latin typeface="Arial"/>
                    </a:rPr>
                    <a:t>66.3</a:t>
                  </a:r>
                  <a:endParaRPr b="0" lang="en-US" sz="11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</p:grpSp>
      </p:grpSp>
      <p:pic>
        <p:nvPicPr>
          <p:cNvPr id="241" name="" descr=""/>
          <p:cNvPicPr/>
          <p:nvPr/>
        </p:nvPicPr>
        <p:blipFill>
          <a:blip r:embed="rId2"/>
          <a:stretch/>
        </p:blipFill>
        <p:spPr>
          <a:xfrm>
            <a:off x="2398680" y="4902120"/>
            <a:ext cx="1782720" cy="1758960"/>
          </a:xfrm>
          <a:prstGeom prst="rect">
            <a:avLst/>
          </a:prstGeom>
          <a:ln w="0">
            <a:noFill/>
          </a:ln>
        </p:spPr>
      </p:pic>
      <p:pic>
        <p:nvPicPr>
          <p:cNvPr id="242" name="" descr=""/>
          <p:cNvPicPr/>
          <p:nvPr/>
        </p:nvPicPr>
        <p:blipFill>
          <a:blip r:embed="rId3"/>
          <a:stretch/>
        </p:blipFill>
        <p:spPr>
          <a:xfrm>
            <a:off x="4397400" y="4888080"/>
            <a:ext cx="1816200" cy="1793880"/>
          </a:xfrm>
          <a:prstGeom prst="rect">
            <a:avLst/>
          </a:prstGeom>
          <a:ln w="0">
            <a:noFill/>
          </a:ln>
        </p:spPr>
      </p:pic>
      <p:pic>
        <p:nvPicPr>
          <p:cNvPr id="243" name="" descr=""/>
          <p:cNvPicPr/>
          <p:nvPr/>
        </p:nvPicPr>
        <p:blipFill>
          <a:blip r:embed="rId4"/>
          <a:stretch/>
        </p:blipFill>
        <p:spPr>
          <a:xfrm>
            <a:off x="2378160" y="6796080"/>
            <a:ext cx="1782720" cy="1760400"/>
          </a:xfrm>
          <a:prstGeom prst="rect">
            <a:avLst/>
          </a:prstGeom>
          <a:ln w="0">
            <a:noFill/>
          </a:ln>
        </p:spPr>
      </p:pic>
      <p:pic>
        <p:nvPicPr>
          <p:cNvPr id="244" name="" descr=""/>
          <p:cNvPicPr/>
          <p:nvPr/>
        </p:nvPicPr>
        <p:blipFill>
          <a:blip r:embed="rId5"/>
          <a:stretch/>
        </p:blipFill>
        <p:spPr>
          <a:xfrm>
            <a:off x="4381560" y="6796080"/>
            <a:ext cx="1816200" cy="1792440"/>
          </a:xfrm>
          <a:prstGeom prst="rect">
            <a:avLst/>
          </a:prstGeom>
          <a:ln w="0">
            <a:noFill/>
          </a:ln>
        </p:spPr>
      </p:pic>
      <p:sp>
        <p:nvSpPr>
          <p:cNvPr id="245" name=""/>
          <p:cNvSpPr/>
          <p:nvPr/>
        </p:nvSpPr>
        <p:spPr>
          <a:xfrm>
            <a:off x="903960" y="4738680"/>
            <a:ext cx="1195560" cy="33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 baseline="-25000">
                <a:solidFill>
                  <a:srgbClr val="000000"/>
                </a:solidFill>
                <a:latin typeface="Arial"/>
              </a:rPr>
              <a:t>Day 0, gate for CD4+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6" name=""/>
          <p:cNvSpPr/>
          <p:nvPr/>
        </p:nvSpPr>
        <p:spPr>
          <a:xfrm>
            <a:off x="693000" y="6640560"/>
            <a:ext cx="1671120" cy="33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 baseline="-25000">
                <a:solidFill>
                  <a:srgbClr val="000000"/>
                </a:solidFill>
                <a:latin typeface="Arial"/>
              </a:rPr>
              <a:t>Day 0, control without peptide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7" name=""/>
          <p:cNvSpPr/>
          <p:nvPr/>
        </p:nvSpPr>
        <p:spPr>
          <a:xfrm>
            <a:off x="2817000" y="4738680"/>
            <a:ext cx="1125720" cy="33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 baseline="-25000">
                <a:solidFill>
                  <a:srgbClr val="000000"/>
                </a:solidFill>
                <a:latin typeface="Arial"/>
              </a:rPr>
              <a:t>Day 0, with peptide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8" name=""/>
          <p:cNvSpPr/>
          <p:nvPr/>
        </p:nvSpPr>
        <p:spPr>
          <a:xfrm>
            <a:off x="4920480" y="4738680"/>
            <a:ext cx="1125720" cy="33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 baseline="-25000">
                <a:solidFill>
                  <a:srgbClr val="000000"/>
                </a:solidFill>
                <a:latin typeface="Arial"/>
              </a:rPr>
              <a:t>Day 5, with peptide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9" name=""/>
          <p:cNvSpPr/>
          <p:nvPr/>
        </p:nvSpPr>
        <p:spPr>
          <a:xfrm>
            <a:off x="2784600" y="6632640"/>
            <a:ext cx="1183680" cy="33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 baseline="-25000">
                <a:solidFill>
                  <a:srgbClr val="000000"/>
                </a:solidFill>
                <a:latin typeface="Arial"/>
              </a:rPr>
              <a:t>Day 10, with peptide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0" name=""/>
          <p:cNvSpPr/>
          <p:nvPr/>
        </p:nvSpPr>
        <p:spPr>
          <a:xfrm>
            <a:off x="4741920" y="6632640"/>
            <a:ext cx="1183680" cy="33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 baseline="-25000">
                <a:solidFill>
                  <a:srgbClr val="000000"/>
                </a:solidFill>
                <a:latin typeface="Arial"/>
              </a:rPr>
              <a:t>Day 15, with peptide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251" name=""/>
          <p:cNvGrpSpPr/>
          <p:nvPr/>
        </p:nvGrpSpPr>
        <p:grpSpPr>
          <a:xfrm>
            <a:off x="439560" y="2540160"/>
            <a:ext cx="1833840" cy="1830960"/>
            <a:chOff x="439560" y="2540160"/>
            <a:chExt cx="1833840" cy="1830960"/>
          </a:xfrm>
        </p:grpSpPr>
        <p:grpSp>
          <p:nvGrpSpPr>
            <p:cNvPr id="252" name=""/>
            <p:cNvGrpSpPr/>
            <p:nvPr/>
          </p:nvGrpSpPr>
          <p:grpSpPr>
            <a:xfrm>
              <a:off x="439560" y="2540160"/>
              <a:ext cx="1833840" cy="1830960"/>
              <a:chOff x="439560" y="2540160"/>
              <a:chExt cx="1833840" cy="1830960"/>
            </a:xfrm>
          </p:grpSpPr>
          <p:sp>
            <p:nvSpPr>
              <p:cNvPr id="253" name=""/>
              <p:cNvSpPr/>
              <p:nvPr/>
            </p:nvSpPr>
            <p:spPr>
              <a:xfrm>
                <a:off x="738000" y="2616120"/>
                <a:ext cx="1460520" cy="1461600"/>
              </a:xfrm>
              <a:prstGeom prst="rect">
                <a:avLst/>
              </a:prstGeom>
              <a:solidFill>
                <a:srgbClr val="ffffff"/>
              </a:solidFill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grpSp>
            <p:nvGrpSpPr>
              <p:cNvPr id="254" name=""/>
              <p:cNvGrpSpPr/>
              <p:nvPr/>
            </p:nvGrpSpPr>
            <p:grpSpPr>
              <a:xfrm>
                <a:off x="666360" y="4071600"/>
                <a:ext cx="1607040" cy="299520"/>
                <a:chOff x="666360" y="4071600"/>
                <a:chExt cx="1607040" cy="299520"/>
              </a:xfrm>
            </p:grpSpPr>
            <p:sp>
              <p:nvSpPr>
                <p:cNvPr id="255" name=""/>
                <p:cNvSpPr/>
                <p:nvPr/>
              </p:nvSpPr>
              <p:spPr>
                <a:xfrm>
                  <a:off x="738000" y="4071600"/>
                  <a:ext cx="1455840" cy="1440"/>
                </a:xfrm>
                <a:prstGeom prst="line">
                  <a:avLst/>
                </a:prstGeom>
                <a:ln w="64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grpSp>
              <p:nvGrpSpPr>
                <p:cNvPr id="256" name=""/>
                <p:cNvGrpSpPr/>
                <p:nvPr/>
              </p:nvGrpSpPr>
              <p:grpSpPr>
                <a:xfrm>
                  <a:off x="738000" y="4077720"/>
                  <a:ext cx="1457640" cy="33120"/>
                  <a:chOff x="738000" y="4077720"/>
                  <a:chExt cx="1457640" cy="33120"/>
                </a:xfrm>
              </p:grpSpPr>
              <p:sp>
                <p:nvSpPr>
                  <p:cNvPr id="257" name=""/>
                  <p:cNvSpPr/>
                  <p:nvPr/>
                </p:nvSpPr>
                <p:spPr>
                  <a:xfrm>
                    <a:off x="738000" y="4077720"/>
                    <a:ext cx="1800" cy="3312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13680" bIns="-1368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258" name=""/>
                  <p:cNvSpPr/>
                  <p:nvPr/>
                </p:nvSpPr>
                <p:spPr>
                  <a:xfrm>
                    <a:off x="844560" y="4077720"/>
                    <a:ext cx="1440" cy="1080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6000" bIns="-3600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259" name=""/>
                  <p:cNvSpPr/>
                  <p:nvPr/>
                </p:nvSpPr>
                <p:spPr>
                  <a:xfrm>
                    <a:off x="907920" y="4077720"/>
                    <a:ext cx="1800" cy="1080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6000" bIns="-3600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260" name=""/>
                  <p:cNvSpPr/>
                  <p:nvPr/>
                </p:nvSpPr>
                <p:spPr>
                  <a:xfrm>
                    <a:off x="952560" y="4077720"/>
                    <a:ext cx="1440" cy="1080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6000" bIns="-3600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261" name=""/>
                  <p:cNvSpPr/>
                  <p:nvPr/>
                </p:nvSpPr>
                <p:spPr>
                  <a:xfrm>
                    <a:off x="992160" y="4077720"/>
                    <a:ext cx="1440" cy="2196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24840" bIns="-2484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262" name=""/>
                  <p:cNvSpPr/>
                  <p:nvPr/>
                </p:nvSpPr>
                <p:spPr>
                  <a:xfrm>
                    <a:off x="1020600" y="4077720"/>
                    <a:ext cx="1800" cy="1080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6000" bIns="-3600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263" name=""/>
                  <p:cNvSpPr/>
                  <p:nvPr/>
                </p:nvSpPr>
                <p:spPr>
                  <a:xfrm>
                    <a:off x="1042920" y="4077720"/>
                    <a:ext cx="1800" cy="1080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6000" bIns="-3600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264" name=""/>
                  <p:cNvSpPr/>
                  <p:nvPr/>
                </p:nvSpPr>
                <p:spPr>
                  <a:xfrm>
                    <a:off x="1065240" y="4077720"/>
                    <a:ext cx="1440" cy="1080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6000" bIns="-3600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265" name=""/>
                  <p:cNvSpPr/>
                  <p:nvPr/>
                </p:nvSpPr>
                <p:spPr>
                  <a:xfrm>
                    <a:off x="1082520" y="4077720"/>
                    <a:ext cx="1800" cy="1080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6000" bIns="-3600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266" name=""/>
                  <p:cNvSpPr/>
                  <p:nvPr/>
                </p:nvSpPr>
                <p:spPr>
                  <a:xfrm>
                    <a:off x="1098360" y="4077720"/>
                    <a:ext cx="1800" cy="3312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13680" bIns="-1368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267" name=""/>
                  <p:cNvSpPr/>
                  <p:nvPr/>
                </p:nvSpPr>
                <p:spPr>
                  <a:xfrm>
                    <a:off x="1211400" y="4077720"/>
                    <a:ext cx="1440" cy="1080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6000" bIns="-3600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268" name=""/>
                  <p:cNvSpPr/>
                  <p:nvPr/>
                </p:nvSpPr>
                <p:spPr>
                  <a:xfrm>
                    <a:off x="1274760" y="4077720"/>
                    <a:ext cx="1440" cy="1080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6000" bIns="-3600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269" name=""/>
                  <p:cNvSpPr/>
                  <p:nvPr/>
                </p:nvSpPr>
                <p:spPr>
                  <a:xfrm>
                    <a:off x="1319040" y="4077720"/>
                    <a:ext cx="1800" cy="1080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6000" bIns="-3600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270" name=""/>
                  <p:cNvSpPr/>
                  <p:nvPr/>
                </p:nvSpPr>
                <p:spPr>
                  <a:xfrm>
                    <a:off x="1352520" y="4077720"/>
                    <a:ext cx="1440" cy="2196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24840" bIns="-2484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271" name=""/>
                  <p:cNvSpPr/>
                  <p:nvPr/>
                </p:nvSpPr>
                <p:spPr>
                  <a:xfrm>
                    <a:off x="1387440" y="4077720"/>
                    <a:ext cx="1440" cy="1080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6000" bIns="-3600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272" name=""/>
                  <p:cNvSpPr/>
                  <p:nvPr/>
                </p:nvSpPr>
                <p:spPr>
                  <a:xfrm>
                    <a:off x="1409760" y="4077720"/>
                    <a:ext cx="1440" cy="1080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6000" bIns="-3600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273" name=""/>
                  <p:cNvSpPr/>
                  <p:nvPr/>
                </p:nvSpPr>
                <p:spPr>
                  <a:xfrm>
                    <a:off x="1431720" y="4077720"/>
                    <a:ext cx="1800" cy="1080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6000" bIns="-3600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274" name=""/>
                  <p:cNvSpPr/>
                  <p:nvPr/>
                </p:nvSpPr>
                <p:spPr>
                  <a:xfrm>
                    <a:off x="1449360" y="4077720"/>
                    <a:ext cx="1440" cy="1080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6000" bIns="-3600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275" name=""/>
                  <p:cNvSpPr/>
                  <p:nvPr/>
                </p:nvSpPr>
                <p:spPr>
                  <a:xfrm>
                    <a:off x="1465200" y="4077720"/>
                    <a:ext cx="1440" cy="3312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13680" bIns="-1368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276" name=""/>
                  <p:cNvSpPr/>
                  <p:nvPr/>
                </p:nvSpPr>
                <p:spPr>
                  <a:xfrm>
                    <a:off x="1573200" y="4077720"/>
                    <a:ext cx="1440" cy="1080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6000" bIns="-3600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277" name=""/>
                  <p:cNvSpPr/>
                  <p:nvPr/>
                </p:nvSpPr>
                <p:spPr>
                  <a:xfrm>
                    <a:off x="1639800" y="4077720"/>
                    <a:ext cx="1800" cy="1080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6000" bIns="-3600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278" name=""/>
                  <p:cNvSpPr/>
                  <p:nvPr/>
                </p:nvSpPr>
                <p:spPr>
                  <a:xfrm>
                    <a:off x="1685880" y="4077720"/>
                    <a:ext cx="1440" cy="1080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6000" bIns="-3600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279" name=""/>
                  <p:cNvSpPr/>
                  <p:nvPr/>
                </p:nvSpPr>
                <p:spPr>
                  <a:xfrm>
                    <a:off x="1719360" y="4077720"/>
                    <a:ext cx="1440" cy="2196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24840" bIns="-2484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280" name=""/>
                  <p:cNvSpPr/>
                  <p:nvPr/>
                </p:nvSpPr>
                <p:spPr>
                  <a:xfrm>
                    <a:off x="1747800" y="4077720"/>
                    <a:ext cx="1440" cy="1080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6000" bIns="-3600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281" name=""/>
                  <p:cNvSpPr/>
                  <p:nvPr/>
                </p:nvSpPr>
                <p:spPr>
                  <a:xfrm>
                    <a:off x="1776240" y="4077720"/>
                    <a:ext cx="1800" cy="1080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6000" bIns="-3600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282" name=""/>
                  <p:cNvSpPr/>
                  <p:nvPr/>
                </p:nvSpPr>
                <p:spPr>
                  <a:xfrm>
                    <a:off x="1792080" y="4077720"/>
                    <a:ext cx="1800" cy="1080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6000" bIns="-3600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283" name=""/>
                  <p:cNvSpPr/>
                  <p:nvPr/>
                </p:nvSpPr>
                <p:spPr>
                  <a:xfrm>
                    <a:off x="1816200" y="4077720"/>
                    <a:ext cx="1440" cy="1080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6000" bIns="-3600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284" name=""/>
                  <p:cNvSpPr/>
                  <p:nvPr/>
                </p:nvSpPr>
                <p:spPr>
                  <a:xfrm>
                    <a:off x="1832040" y="4077720"/>
                    <a:ext cx="1440" cy="3312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13680" bIns="-1368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285" name=""/>
                  <p:cNvSpPr/>
                  <p:nvPr/>
                </p:nvSpPr>
                <p:spPr>
                  <a:xfrm>
                    <a:off x="1940040" y="4077720"/>
                    <a:ext cx="1440" cy="1080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6000" bIns="-3600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286" name=""/>
                  <p:cNvSpPr/>
                  <p:nvPr/>
                </p:nvSpPr>
                <p:spPr>
                  <a:xfrm>
                    <a:off x="2006640" y="4077720"/>
                    <a:ext cx="1440" cy="1080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6000" bIns="-3600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287" name=""/>
                  <p:cNvSpPr/>
                  <p:nvPr/>
                </p:nvSpPr>
                <p:spPr>
                  <a:xfrm>
                    <a:off x="2052720" y="4077720"/>
                    <a:ext cx="1440" cy="1080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6000" bIns="-3600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288" name=""/>
                  <p:cNvSpPr/>
                  <p:nvPr/>
                </p:nvSpPr>
                <p:spPr>
                  <a:xfrm>
                    <a:off x="2085840" y="4077720"/>
                    <a:ext cx="1800" cy="2196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24840" bIns="-2484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289" name=""/>
                  <p:cNvSpPr/>
                  <p:nvPr/>
                </p:nvSpPr>
                <p:spPr>
                  <a:xfrm>
                    <a:off x="2114640" y="4077720"/>
                    <a:ext cx="1440" cy="1080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6000" bIns="-3600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290" name=""/>
                  <p:cNvSpPr/>
                  <p:nvPr/>
                </p:nvSpPr>
                <p:spPr>
                  <a:xfrm>
                    <a:off x="2136600" y="4077720"/>
                    <a:ext cx="1800" cy="1080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6000" bIns="-3600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291" name=""/>
                  <p:cNvSpPr/>
                  <p:nvPr/>
                </p:nvSpPr>
                <p:spPr>
                  <a:xfrm>
                    <a:off x="2158920" y="4077720"/>
                    <a:ext cx="1800" cy="1080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6000" bIns="-3600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292" name=""/>
                  <p:cNvSpPr/>
                  <p:nvPr/>
                </p:nvSpPr>
                <p:spPr>
                  <a:xfrm>
                    <a:off x="2176560" y="4077720"/>
                    <a:ext cx="1440" cy="1080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6000" bIns="-3600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293" name=""/>
                  <p:cNvSpPr/>
                  <p:nvPr/>
                </p:nvSpPr>
                <p:spPr>
                  <a:xfrm>
                    <a:off x="2193840" y="4077720"/>
                    <a:ext cx="1800" cy="3312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13680" bIns="-1368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</p:grpSp>
            <p:grpSp>
              <p:nvGrpSpPr>
                <p:cNvPr id="294" name=""/>
                <p:cNvGrpSpPr/>
                <p:nvPr/>
              </p:nvGrpSpPr>
              <p:grpSpPr>
                <a:xfrm>
                  <a:off x="666360" y="4119120"/>
                  <a:ext cx="1607040" cy="161280"/>
                  <a:chOff x="666360" y="4119120"/>
                  <a:chExt cx="1607040" cy="161280"/>
                </a:xfrm>
              </p:grpSpPr>
              <p:sp>
                <p:nvSpPr>
                  <p:cNvPr id="295" name=""/>
                  <p:cNvSpPr/>
                  <p:nvPr/>
                </p:nvSpPr>
                <p:spPr>
                  <a:xfrm>
                    <a:off x="666360" y="4158360"/>
                    <a:ext cx="113400" cy="12204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1" lang="en-US" sz="800" spc="-1" strike="noStrike">
                        <a:solidFill>
                          <a:srgbClr val="000000"/>
                        </a:solidFill>
                        <a:latin typeface="Arial"/>
                      </a:rPr>
                      <a:t>10</a:t>
                    </a:r>
                    <a:endParaRPr b="0" lang="en-US" sz="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296" name=""/>
                  <p:cNvSpPr/>
                  <p:nvPr/>
                </p:nvSpPr>
                <p:spPr>
                  <a:xfrm>
                    <a:off x="768240" y="4119120"/>
                    <a:ext cx="49320" cy="10692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1" lang="en-US" sz="700" spc="-1" strike="noStrike">
                        <a:solidFill>
                          <a:srgbClr val="000000"/>
                        </a:solidFill>
                        <a:latin typeface="Arial"/>
                      </a:rPr>
                      <a:t>0</a:t>
                    </a:r>
                    <a:endParaRPr b="0" lang="en-US" sz="7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297" name=""/>
                  <p:cNvSpPr/>
                  <p:nvPr/>
                </p:nvSpPr>
                <p:spPr>
                  <a:xfrm>
                    <a:off x="1026720" y="4158360"/>
                    <a:ext cx="113400" cy="12204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1" lang="en-US" sz="800" spc="-1" strike="noStrike">
                        <a:solidFill>
                          <a:srgbClr val="000000"/>
                        </a:solidFill>
                        <a:latin typeface="Arial"/>
                      </a:rPr>
                      <a:t>10</a:t>
                    </a:r>
                    <a:endParaRPr b="0" lang="en-US" sz="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298" name=""/>
                  <p:cNvSpPr/>
                  <p:nvPr/>
                </p:nvSpPr>
                <p:spPr>
                  <a:xfrm>
                    <a:off x="1128600" y="4119120"/>
                    <a:ext cx="49320" cy="10692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1" lang="en-US" sz="700" spc="-1" strike="noStrike">
                        <a:solidFill>
                          <a:srgbClr val="000000"/>
                        </a:solidFill>
                        <a:latin typeface="Arial"/>
                      </a:rPr>
                      <a:t>1</a:t>
                    </a:r>
                    <a:endParaRPr b="0" lang="en-US" sz="7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299" name=""/>
                  <p:cNvSpPr/>
                  <p:nvPr/>
                </p:nvSpPr>
                <p:spPr>
                  <a:xfrm>
                    <a:off x="1393560" y="4158360"/>
                    <a:ext cx="113400" cy="12204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1" lang="en-US" sz="800" spc="-1" strike="noStrike">
                        <a:solidFill>
                          <a:srgbClr val="000000"/>
                        </a:solidFill>
                        <a:latin typeface="Arial"/>
                      </a:rPr>
                      <a:t>10</a:t>
                    </a:r>
                    <a:endParaRPr b="0" lang="en-US" sz="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300" name=""/>
                  <p:cNvSpPr/>
                  <p:nvPr/>
                </p:nvSpPr>
                <p:spPr>
                  <a:xfrm>
                    <a:off x="1495440" y="4119120"/>
                    <a:ext cx="49320" cy="10692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1" lang="en-US" sz="700" spc="-1" strike="noStrike">
                        <a:solidFill>
                          <a:srgbClr val="000000"/>
                        </a:solidFill>
                        <a:latin typeface="Arial"/>
                      </a:rPr>
                      <a:t>2</a:t>
                    </a:r>
                    <a:endParaRPr b="0" lang="en-US" sz="7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301" name=""/>
                  <p:cNvSpPr/>
                  <p:nvPr/>
                </p:nvSpPr>
                <p:spPr>
                  <a:xfrm>
                    <a:off x="1760040" y="4158360"/>
                    <a:ext cx="113400" cy="12204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1" lang="en-US" sz="800" spc="-1" strike="noStrike">
                        <a:solidFill>
                          <a:srgbClr val="000000"/>
                        </a:solidFill>
                        <a:latin typeface="Arial"/>
                      </a:rPr>
                      <a:t>10</a:t>
                    </a:r>
                    <a:endParaRPr b="0" lang="en-US" sz="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302" name=""/>
                  <p:cNvSpPr/>
                  <p:nvPr/>
                </p:nvSpPr>
                <p:spPr>
                  <a:xfrm>
                    <a:off x="1862280" y="4119120"/>
                    <a:ext cx="49320" cy="10692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1" lang="en-US" sz="700" spc="-1" strike="noStrike">
                        <a:solidFill>
                          <a:srgbClr val="000000"/>
                        </a:solidFill>
                        <a:latin typeface="Arial"/>
                      </a:rPr>
                      <a:t>3</a:t>
                    </a:r>
                    <a:endParaRPr b="0" lang="en-US" sz="7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303" name=""/>
                  <p:cNvSpPr/>
                  <p:nvPr/>
                </p:nvSpPr>
                <p:spPr>
                  <a:xfrm>
                    <a:off x="2122200" y="4158360"/>
                    <a:ext cx="113400" cy="12204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1" lang="en-US" sz="800" spc="-1" strike="noStrike">
                        <a:solidFill>
                          <a:srgbClr val="000000"/>
                        </a:solidFill>
                        <a:latin typeface="Arial"/>
                      </a:rPr>
                      <a:t>10</a:t>
                    </a:r>
                    <a:endParaRPr b="0" lang="en-US" sz="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304" name=""/>
                  <p:cNvSpPr/>
                  <p:nvPr/>
                </p:nvSpPr>
                <p:spPr>
                  <a:xfrm>
                    <a:off x="2224080" y="4119120"/>
                    <a:ext cx="49320" cy="10692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1" lang="en-US" sz="700" spc="-1" strike="noStrike">
                        <a:solidFill>
                          <a:srgbClr val="000000"/>
                        </a:solidFill>
                        <a:latin typeface="Arial"/>
                      </a:rPr>
                      <a:t>4</a:t>
                    </a:r>
                    <a:endParaRPr b="0" lang="en-US" sz="7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</p:grpSp>
            <p:sp>
              <p:nvSpPr>
                <p:cNvPr id="305" name=""/>
                <p:cNvSpPr/>
                <p:nvPr/>
              </p:nvSpPr>
              <p:spPr>
                <a:xfrm>
                  <a:off x="1349280" y="4249080"/>
                  <a:ext cx="259920" cy="1220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800" spc="-1" strike="noStrike">
                      <a:solidFill>
                        <a:srgbClr val="000000"/>
                      </a:solidFill>
                      <a:latin typeface="Arial"/>
                    </a:rPr>
                    <a:t>CD69</a:t>
                  </a:r>
                  <a:endParaRPr b="0" lang="en-US" sz="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grpSp>
            <p:nvGrpSpPr>
              <p:cNvPr id="306" name=""/>
              <p:cNvGrpSpPr/>
              <p:nvPr/>
            </p:nvGrpSpPr>
            <p:grpSpPr>
              <a:xfrm>
                <a:off x="439560" y="2540160"/>
                <a:ext cx="300240" cy="1615320"/>
                <a:chOff x="439560" y="2540160"/>
                <a:chExt cx="300240" cy="1615320"/>
              </a:xfrm>
            </p:grpSpPr>
            <p:sp>
              <p:nvSpPr>
                <p:cNvPr id="307" name=""/>
                <p:cNvSpPr/>
                <p:nvPr/>
              </p:nvSpPr>
              <p:spPr>
                <a:xfrm flipV="1">
                  <a:off x="738000" y="2616120"/>
                  <a:ext cx="1800" cy="1455120"/>
                </a:xfrm>
                <a:prstGeom prst="line">
                  <a:avLst/>
                </a:prstGeom>
                <a:ln w="64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grpSp>
              <p:nvGrpSpPr>
                <p:cNvPr id="308" name=""/>
                <p:cNvGrpSpPr/>
                <p:nvPr/>
              </p:nvGrpSpPr>
              <p:grpSpPr>
                <a:xfrm>
                  <a:off x="704880" y="2616120"/>
                  <a:ext cx="33120" cy="1456560"/>
                  <a:chOff x="704880" y="2616120"/>
                  <a:chExt cx="33120" cy="1456560"/>
                </a:xfrm>
              </p:grpSpPr>
              <p:sp>
                <p:nvSpPr>
                  <p:cNvPr id="309" name=""/>
                  <p:cNvSpPr/>
                  <p:nvPr/>
                </p:nvSpPr>
                <p:spPr>
                  <a:xfrm flipH="1">
                    <a:off x="704880" y="4071240"/>
                    <a:ext cx="33120" cy="144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5360" bIns="-4536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310" name=""/>
                  <p:cNvSpPr/>
                  <p:nvPr/>
                </p:nvSpPr>
                <p:spPr>
                  <a:xfrm flipH="1">
                    <a:off x="727200" y="3965040"/>
                    <a:ext cx="10800" cy="108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5720" bIns="-4572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311" name=""/>
                  <p:cNvSpPr/>
                  <p:nvPr/>
                </p:nvSpPr>
                <p:spPr>
                  <a:xfrm flipH="1">
                    <a:off x="727200" y="3903120"/>
                    <a:ext cx="10800" cy="108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5720" bIns="-4572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312" name=""/>
                  <p:cNvSpPr/>
                  <p:nvPr/>
                </p:nvSpPr>
                <p:spPr>
                  <a:xfrm flipH="1">
                    <a:off x="727200" y="3857040"/>
                    <a:ext cx="10800" cy="108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5720" bIns="-4572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313" name=""/>
                  <p:cNvSpPr/>
                  <p:nvPr/>
                </p:nvSpPr>
                <p:spPr>
                  <a:xfrm flipH="1">
                    <a:off x="715680" y="3817440"/>
                    <a:ext cx="21960" cy="108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5720" bIns="-4572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314" name=""/>
                  <p:cNvSpPr/>
                  <p:nvPr/>
                </p:nvSpPr>
                <p:spPr>
                  <a:xfrm flipH="1">
                    <a:off x="727200" y="3790440"/>
                    <a:ext cx="10800" cy="108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5720" bIns="-4572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315" name=""/>
                  <p:cNvSpPr/>
                  <p:nvPr/>
                </p:nvSpPr>
                <p:spPr>
                  <a:xfrm flipH="1">
                    <a:off x="727200" y="3766680"/>
                    <a:ext cx="10800" cy="108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5720" bIns="-4572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316" name=""/>
                  <p:cNvSpPr/>
                  <p:nvPr/>
                </p:nvSpPr>
                <p:spPr>
                  <a:xfrm flipH="1">
                    <a:off x="727200" y="3744360"/>
                    <a:ext cx="10800" cy="108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5720" bIns="-4572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317" name=""/>
                  <p:cNvSpPr/>
                  <p:nvPr/>
                </p:nvSpPr>
                <p:spPr>
                  <a:xfrm flipH="1">
                    <a:off x="727200" y="3728520"/>
                    <a:ext cx="10800" cy="108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5720" bIns="-4572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318" name=""/>
                  <p:cNvSpPr/>
                  <p:nvPr/>
                </p:nvSpPr>
                <p:spPr>
                  <a:xfrm flipH="1">
                    <a:off x="704880" y="3710880"/>
                    <a:ext cx="33120" cy="144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5360" bIns="-4536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319" name=""/>
                  <p:cNvSpPr/>
                  <p:nvPr/>
                </p:nvSpPr>
                <p:spPr>
                  <a:xfrm flipH="1">
                    <a:off x="727200" y="3598200"/>
                    <a:ext cx="10800" cy="144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5360" bIns="-4536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320" name=""/>
                  <p:cNvSpPr/>
                  <p:nvPr/>
                </p:nvSpPr>
                <p:spPr>
                  <a:xfrm flipH="1">
                    <a:off x="727200" y="3536280"/>
                    <a:ext cx="10800" cy="144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5360" bIns="-4536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321" name=""/>
                  <p:cNvSpPr/>
                  <p:nvPr/>
                </p:nvSpPr>
                <p:spPr>
                  <a:xfrm flipH="1">
                    <a:off x="727200" y="3490200"/>
                    <a:ext cx="10800" cy="144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5360" bIns="-4536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322" name=""/>
                  <p:cNvSpPr/>
                  <p:nvPr/>
                </p:nvSpPr>
                <p:spPr>
                  <a:xfrm flipH="1">
                    <a:off x="715680" y="3457080"/>
                    <a:ext cx="21960" cy="108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5720" bIns="-4572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323" name=""/>
                  <p:cNvSpPr/>
                  <p:nvPr/>
                </p:nvSpPr>
                <p:spPr>
                  <a:xfrm flipH="1">
                    <a:off x="727200" y="3423600"/>
                    <a:ext cx="10800" cy="144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5360" bIns="-4536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324" name=""/>
                  <p:cNvSpPr/>
                  <p:nvPr/>
                </p:nvSpPr>
                <p:spPr>
                  <a:xfrm flipH="1">
                    <a:off x="727200" y="3399840"/>
                    <a:ext cx="10800" cy="108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5720" bIns="-4572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325" name=""/>
                  <p:cNvSpPr/>
                  <p:nvPr/>
                </p:nvSpPr>
                <p:spPr>
                  <a:xfrm flipH="1">
                    <a:off x="727200" y="3377520"/>
                    <a:ext cx="10800" cy="144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5360" bIns="-4536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326" name=""/>
                  <p:cNvSpPr/>
                  <p:nvPr/>
                </p:nvSpPr>
                <p:spPr>
                  <a:xfrm flipH="1">
                    <a:off x="727200" y="3361680"/>
                    <a:ext cx="10800" cy="144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5360" bIns="-4536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327" name=""/>
                  <p:cNvSpPr/>
                  <p:nvPr/>
                </p:nvSpPr>
                <p:spPr>
                  <a:xfrm flipH="1">
                    <a:off x="704880" y="3344400"/>
                    <a:ext cx="33120" cy="108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5720" bIns="-4572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328" name=""/>
                  <p:cNvSpPr/>
                  <p:nvPr/>
                </p:nvSpPr>
                <p:spPr>
                  <a:xfrm flipH="1">
                    <a:off x="727200" y="3236400"/>
                    <a:ext cx="10800" cy="108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5720" bIns="-4572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329" name=""/>
                  <p:cNvSpPr/>
                  <p:nvPr/>
                </p:nvSpPr>
                <p:spPr>
                  <a:xfrm flipH="1">
                    <a:off x="727200" y="3169800"/>
                    <a:ext cx="10800" cy="108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5720" bIns="-4572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330" name=""/>
                  <p:cNvSpPr/>
                  <p:nvPr/>
                </p:nvSpPr>
                <p:spPr>
                  <a:xfrm flipH="1">
                    <a:off x="727200" y="3123720"/>
                    <a:ext cx="10800" cy="108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5720" bIns="-4572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331" name=""/>
                  <p:cNvSpPr/>
                  <p:nvPr/>
                </p:nvSpPr>
                <p:spPr>
                  <a:xfrm flipH="1">
                    <a:off x="715680" y="3090240"/>
                    <a:ext cx="21960" cy="108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5720" bIns="-4572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332" name=""/>
                  <p:cNvSpPr/>
                  <p:nvPr/>
                </p:nvSpPr>
                <p:spPr>
                  <a:xfrm flipH="1">
                    <a:off x="727200" y="3061800"/>
                    <a:ext cx="10800" cy="108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5720" bIns="-4572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333" name=""/>
                  <p:cNvSpPr/>
                  <p:nvPr/>
                </p:nvSpPr>
                <p:spPr>
                  <a:xfrm flipH="1">
                    <a:off x="727200" y="3033000"/>
                    <a:ext cx="10800" cy="144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5360" bIns="-4536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334" name=""/>
                  <p:cNvSpPr/>
                  <p:nvPr/>
                </p:nvSpPr>
                <p:spPr>
                  <a:xfrm flipH="1">
                    <a:off x="727200" y="3017160"/>
                    <a:ext cx="10800" cy="144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5360" bIns="-4536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335" name=""/>
                  <p:cNvSpPr/>
                  <p:nvPr/>
                </p:nvSpPr>
                <p:spPr>
                  <a:xfrm flipH="1">
                    <a:off x="727200" y="2994840"/>
                    <a:ext cx="10800" cy="144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5360" bIns="-4536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336" name=""/>
                  <p:cNvSpPr/>
                  <p:nvPr/>
                </p:nvSpPr>
                <p:spPr>
                  <a:xfrm flipH="1">
                    <a:off x="704880" y="2977560"/>
                    <a:ext cx="33120" cy="108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5720" bIns="-4572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337" name=""/>
                  <p:cNvSpPr/>
                  <p:nvPr/>
                </p:nvSpPr>
                <p:spPr>
                  <a:xfrm flipH="1">
                    <a:off x="727200" y="2869560"/>
                    <a:ext cx="10800" cy="144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5360" bIns="-4536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338" name=""/>
                  <p:cNvSpPr/>
                  <p:nvPr/>
                </p:nvSpPr>
                <p:spPr>
                  <a:xfrm flipH="1">
                    <a:off x="727200" y="2802960"/>
                    <a:ext cx="10800" cy="108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5720" bIns="-4572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339" name=""/>
                  <p:cNvSpPr/>
                  <p:nvPr/>
                </p:nvSpPr>
                <p:spPr>
                  <a:xfrm flipH="1">
                    <a:off x="727200" y="2756880"/>
                    <a:ext cx="10800" cy="108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5720" bIns="-4572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340" name=""/>
                  <p:cNvSpPr/>
                  <p:nvPr/>
                </p:nvSpPr>
                <p:spPr>
                  <a:xfrm flipH="1">
                    <a:off x="715680" y="2723400"/>
                    <a:ext cx="21960" cy="144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5360" bIns="-4536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341" name=""/>
                  <p:cNvSpPr/>
                  <p:nvPr/>
                </p:nvSpPr>
                <p:spPr>
                  <a:xfrm flipH="1">
                    <a:off x="727200" y="2694960"/>
                    <a:ext cx="10800" cy="108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5720" bIns="-4572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342" name=""/>
                  <p:cNvSpPr/>
                  <p:nvPr/>
                </p:nvSpPr>
                <p:spPr>
                  <a:xfrm flipH="1">
                    <a:off x="727200" y="2672640"/>
                    <a:ext cx="10800" cy="144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5360" bIns="-4536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343" name=""/>
                  <p:cNvSpPr/>
                  <p:nvPr/>
                </p:nvSpPr>
                <p:spPr>
                  <a:xfrm flipH="1">
                    <a:off x="727200" y="2650680"/>
                    <a:ext cx="10800" cy="108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5720" bIns="-4572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344" name=""/>
                  <p:cNvSpPr/>
                  <p:nvPr/>
                </p:nvSpPr>
                <p:spPr>
                  <a:xfrm flipH="1">
                    <a:off x="727200" y="2633040"/>
                    <a:ext cx="10800" cy="108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5720" bIns="-4572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345" name=""/>
                  <p:cNvSpPr/>
                  <p:nvPr/>
                </p:nvSpPr>
                <p:spPr>
                  <a:xfrm flipH="1">
                    <a:off x="704880" y="2616120"/>
                    <a:ext cx="33120" cy="108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5720" bIns="-4572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</p:grpSp>
            <p:grpSp>
              <p:nvGrpSpPr>
                <p:cNvPr id="346" name=""/>
                <p:cNvGrpSpPr/>
                <p:nvPr/>
              </p:nvGrpSpPr>
              <p:grpSpPr>
                <a:xfrm>
                  <a:off x="536040" y="2540160"/>
                  <a:ext cx="151560" cy="1615320"/>
                  <a:chOff x="536040" y="2540160"/>
                  <a:chExt cx="151560" cy="1615320"/>
                </a:xfrm>
              </p:grpSpPr>
              <p:sp>
                <p:nvSpPr>
                  <p:cNvPr id="347" name=""/>
                  <p:cNvSpPr/>
                  <p:nvPr/>
                </p:nvSpPr>
                <p:spPr>
                  <a:xfrm>
                    <a:off x="536040" y="4033440"/>
                    <a:ext cx="113400" cy="12204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1" lang="en-US" sz="800" spc="-1" strike="noStrike">
                        <a:solidFill>
                          <a:srgbClr val="000000"/>
                        </a:solidFill>
                        <a:latin typeface="Arial"/>
                      </a:rPr>
                      <a:t>10</a:t>
                    </a:r>
                    <a:endParaRPr b="0" lang="en-US" sz="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348" name=""/>
                  <p:cNvSpPr/>
                  <p:nvPr/>
                </p:nvSpPr>
                <p:spPr>
                  <a:xfrm>
                    <a:off x="638280" y="3995640"/>
                    <a:ext cx="49320" cy="10692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1" lang="en-US" sz="700" spc="-1" strike="noStrike">
                        <a:solidFill>
                          <a:srgbClr val="000000"/>
                        </a:solidFill>
                        <a:latin typeface="Arial"/>
                      </a:rPr>
                      <a:t>0</a:t>
                    </a:r>
                    <a:endParaRPr b="0" lang="en-US" sz="7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349" name=""/>
                  <p:cNvSpPr/>
                  <p:nvPr/>
                </p:nvSpPr>
                <p:spPr>
                  <a:xfrm>
                    <a:off x="536040" y="3673080"/>
                    <a:ext cx="113400" cy="12204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1" lang="en-US" sz="800" spc="-1" strike="noStrike">
                        <a:solidFill>
                          <a:srgbClr val="000000"/>
                        </a:solidFill>
                        <a:latin typeface="Arial"/>
                      </a:rPr>
                      <a:t>10</a:t>
                    </a:r>
                    <a:endParaRPr b="0" lang="en-US" sz="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350" name=""/>
                  <p:cNvSpPr/>
                  <p:nvPr/>
                </p:nvSpPr>
                <p:spPr>
                  <a:xfrm>
                    <a:off x="638280" y="3635280"/>
                    <a:ext cx="49320" cy="10692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1" lang="en-US" sz="700" spc="-1" strike="noStrike">
                        <a:solidFill>
                          <a:srgbClr val="000000"/>
                        </a:solidFill>
                        <a:latin typeface="Arial"/>
                      </a:rPr>
                      <a:t>1</a:t>
                    </a:r>
                    <a:endParaRPr b="0" lang="en-US" sz="7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351" name=""/>
                  <p:cNvSpPr/>
                  <p:nvPr/>
                </p:nvSpPr>
                <p:spPr>
                  <a:xfrm>
                    <a:off x="536040" y="3306600"/>
                    <a:ext cx="113400" cy="12204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1" lang="en-US" sz="800" spc="-1" strike="noStrike">
                        <a:solidFill>
                          <a:srgbClr val="000000"/>
                        </a:solidFill>
                        <a:latin typeface="Arial"/>
                      </a:rPr>
                      <a:t>10</a:t>
                    </a:r>
                    <a:endParaRPr b="0" lang="en-US" sz="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352" name=""/>
                  <p:cNvSpPr/>
                  <p:nvPr/>
                </p:nvSpPr>
                <p:spPr>
                  <a:xfrm>
                    <a:off x="638280" y="3268440"/>
                    <a:ext cx="49320" cy="10692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1" lang="en-US" sz="700" spc="-1" strike="noStrike">
                        <a:solidFill>
                          <a:srgbClr val="000000"/>
                        </a:solidFill>
                        <a:latin typeface="Arial"/>
                      </a:rPr>
                      <a:t>2</a:t>
                    </a:r>
                    <a:endParaRPr b="0" lang="en-US" sz="7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353" name=""/>
                  <p:cNvSpPr/>
                  <p:nvPr/>
                </p:nvSpPr>
                <p:spPr>
                  <a:xfrm>
                    <a:off x="536040" y="2939760"/>
                    <a:ext cx="113400" cy="12204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1" lang="en-US" sz="800" spc="-1" strike="noStrike">
                        <a:solidFill>
                          <a:srgbClr val="000000"/>
                        </a:solidFill>
                        <a:latin typeface="Arial"/>
                      </a:rPr>
                      <a:t>10</a:t>
                    </a:r>
                    <a:endParaRPr b="0" lang="en-US" sz="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354" name=""/>
                  <p:cNvSpPr/>
                  <p:nvPr/>
                </p:nvSpPr>
                <p:spPr>
                  <a:xfrm>
                    <a:off x="638280" y="2901600"/>
                    <a:ext cx="49320" cy="10692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1" lang="en-US" sz="700" spc="-1" strike="noStrike">
                        <a:solidFill>
                          <a:srgbClr val="000000"/>
                        </a:solidFill>
                        <a:latin typeface="Arial"/>
                      </a:rPr>
                      <a:t>3</a:t>
                    </a:r>
                    <a:endParaRPr b="0" lang="en-US" sz="7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355" name=""/>
                  <p:cNvSpPr/>
                  <p:nvPr/>
                </p:nvSpPr>
                <p:spPr>
                  <a:xfrm>
                    <a:off x="536040" y="2579400"/>
                    <a:ext cx="113400" cy="12204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1" lang="en-US" sz="800" spc="-1" strike="noStrike">
                        <a:solidFill>
                          <a:srgbClr val="000000"/>
                        </a:solidFill>
                        <a:latin typeface="Arial"/>
                      </a:rPr>
                      <a:t>10</a:t>
                    </a:r>
                    <a:endParaRPr b="0" lang="en-US" sz="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356" name=""/>
                  <p:cNvSpPr/>
                  <p:nvPr/>
                </p:nvSpPr>
                <p:spPr>
                  <a:xfrm>
                    <a:off x="638280" y="2540160"/>
                    <a:ext cx="49320" cy="10692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1" lang="en-US" sz="700" spc="-1" strike="noStrike">
                        <a:solidFill>
                          <a:srgbClr val="000000"/>
                        </a:solidFill>
                        <a:latin typeface="Arial"/>
                      </a:rPr>
                      <a:t>4</a:t>
                    </a:r>
                    <a:endParaRPr b="0" lang="en-US" sz="7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</p:grpSp>
            <p:sp>
              <p:nvSpPr>
                <p:cNvPr id="357" name=""/>
                <p:cNvSpPr/>
                <p:nvPr/>
              </p:nvSpPr>
              <p:spPr>
                <a:xfrm rot="16200000">
                  <a:off x="398880" y="3268800"/>
                  <a:ext cx="203400" cy="1220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800" spc="-1" strike="noStrike">
                      <a:solidFill>
                        <a:srgbClr val="000000"/>
                      </a:solidFill>
                      <a:latin typeface="Arial"/>
                    </a:rPr>
                    <a:t>CD4</a:t>
                  </a:r>
                  <a:endParaRPr b="0" lang="en-US" sz="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</p:grpSp>
        <p:grpSp>
          <p:nvGrpSpPr>
            <p:cNvPr id="358" name=""/>
            <p:cNvGrpSpPr/>
            <p:nvPr/>
          </p:nvGrpSpPr>
          <p:grpSpPr>
            <a:xfrm>
              <a:off x="749160" y="2628720"/>
              <a:ext cx="1438560" cy="1437840"/>
              <a:chOff x="749160" y="2628720"/>
              <a:chExt cx="1438560" cy="1437840"/>
            </a:xfrm>
          </p:grpSpPr>
          <p:pic>
            <p:nvPicPr>
              <p:cNvPr id="359" name="" descr=""/>
              <p:cNvPicPr/>
              <p:nvPr/>
            </p:nvPicPr>
            <p:blipFill>
              <a:blip r:embed="rId6"/>
              <a:stretch/>
            </p:blipFill>
            <p:spPr>
              <a:xfrm>
                <a:off x="749160" y="2628720"/>
                <a:ext cx="1438560" cy="1437840"/>
              </a:xfrm>
              <a:prstGeom prst="rect">
                <a:avLst/>
              </a:prstGeom>
              <a:ln w="0">
                <a:noFill/>
              </a:ln>
            </p:spPr>
          </p:pic>
          <p:grpSp>
            <p:nvGrpSpPr>
              <p:cNvPr id="360" name=""/>
              <p:cNvGrpSpPr/>
              <p:nvPr/>
            </p:nvGrpSpPr>
            <p:grpSpPr>
              <a:xfrm>
                <a:off x="1160280" y="2887200"/>
                <a:ext cx="512280" cy="681840"/>
                <a:chOff x="1160280" y="2887200"/>
                <a:chExt cx="512280" cy="681840"/>
              </a:xfrm>
            </p:grpSpPr>
            <p:sp>
              <p:nvSpPr>
                <p:cNvPr id="361" name=""/>
                <p:cNvSpPr/>
                <p:nvPr/>
              </p:nvSpPr>
              <p:spPr>
                <a:xfrm>
                  <a:off x="1160280" y="3083400"/>
                  <a:ext cx="474840" cy="485640"/>
                </a:xfrm>
                <a:prstGeom prst="rect">
                  <a:avLst/>
                </a:prstGeom>
                <a:noFill/>
                <a:ln w="6480">
                  <a:solidFill>
                    <a:srgbClr val="0000ff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62" name=""/>
                <p:cNvSpPr/>
                <p:nvPr/>
              </p:nvSpPr>
              <p:spPr>
                <a:xfrm>
                  <a:off x="1392120" y="2887200"/>
                  <a:ext cx="271440" cy="163080"/>
                </a:xfrm>
                <a:custGeom>
                  <a:avLst/>
                  <a:gdLst/>
                  <a:ahLst/>
                  <a:rect l="l" t="t" r="r" b="b"/>
                  <a:pathLst>
                    <a:path w="171" h="103">
                      <a:moveTo>
                        <a:pt x="0" y="4"/>
                      </a:moveTo>
                      <a:lnTo>
                        <a:pt x="0" y="103"/>
                      </a:lnTo>
                      <a:lnTo>
                        <a:pt x="0" y="103"/>
                      </a:lnTo>
                      <a:lnTo>
                        <a:pt x="171" y="103"/>
                      </a:lnTo>
                      <a:lnTo>
                        <a:pt x="171" y="0"/>
                      </a:lnTo>
                      <a:lnTo>
                        <a:pt x="171" y="0"/>
                      </a:lnTo>
                      <a:lnTo>
                        <a:pt x="0" y="0"/>
                      </a:lnTo>
                      <a:lnTo>
                        <a:pt x="0" y="4"/>
                      </a:lnTo>
                      <a:close/>
                    </a:path>
                  </a:pathLst>
                </a:custGeom>
                <a:solidFill>
                  <a:srgbClr val="ffffff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63" name=""/>
                <p:cNvSpPr/>
                <p:nvPr/>
              </p:nvSpPr>
              <p:spPr>
                <a:xfrm>
                  <a:off x="1398960" y="2894760"/>
                  <a:ext cx="273600" cy="16776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1100" spc="-1" strike="noStrike">
                      <a:solidFill>
                        <a:srgbClr val="000000"/>
                      </a:solidFill>
                      <a:latin typeface="Arial"/>
                    </a:rPr>
                    <a:t>1.94</a:t>
                  </a:r>
                  <a:endParaRPr b="0" lang="en-US" sz="11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</p:grpSp>
      </p:grpSp>
      <p:grpSp>
        <p:nvGrpSpPr>
          <p:cNvPr id="364" name=""/>
          <p:cNvGrpSpPr/>
          <p:nvPr/>
        </p:nvGrpSpPr>
        <p:grpSpPr>
          <a:xfrm>
            <a:off x="442800" y="569880"/>
            <a:ext cx="1839960" cy="1753920"/>
            <a:chOff x="442800" y="569880"/>
            <a:chExt cx="1839960" cy="1753920"/>
          </a:xfrm>
        </p:grpSpPr>
        <p:grpSp>
          <p:nvGrpSpPr>
            <p:cNvPr id="365" name=""/>
            <p:cNvGrpSpPr/>
            <p:nvPr/>
          </p:nvGrpSpPr>
          <p:grpSpPr>
            <a:xfrm>
              <a:off x="442800" y="569880"/>
              <a:ext cx="1839960" cy="1753920"/>
              <a:chOff x="442800" y="569880"/>
              <a:chExt cx="1839960" cy="1753920"/>
            </a:xfrm>
          </p:grpSpPr>
          <p:sp>
            <p:nvSpPr>
              <p:cNvPr id="366" name=""/>
              <p:cNvSpPr/>
              <p:nvPr/>
            </p:nvSpPr>
            <p:spPr>
              <a:xfrm>
                <a:off x="747360" y="569880"/>
                <a:ext cx="1460520" cy="1460520"/>
              </a:xfrm>
              <a:prstGeom prst="rect">
                <a:avLst/>
              </a:prstGeom>
              <a:solidFill>
                <a:srgbClr val="ffffff"/>
              </a:solidFill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grpSp>
            <p:nvGrpSpPr>
              <p:cNvPr id="367" name=""/>
              <p:cNvGrpSpPr/>
              <p:nvPr/>
            </p:nvGrpSpPr>
            <p:grpSpPr>
              <a:xfrm>
                <a:off x="675720" y="2025720"/>
                <a:ext cx="1607040" cy="298080"/>
                <a:chOff x="675720" y="2025720"/>
                <a:chExt cx="1607040" cy="298080"/>
              </a:xfrm>
            </p:grpSpPr>
            <p:sp>
              <p:nvSpPr>
                <p:cNvPr id="368" name=""/>
                <p:cNvSpPr/>
                <p:nvPr/>
              </p:nvSpPr>
              <p:spPr>
                <a:xfrm>
                  <a:off x="747360" y="2025720"/>
                  <a:ext cx="1455840" cy="1440"/>
                </a:xfrm>
                <a:prstGeom prst="line">
                  <a:avLst/>
                </a:prstGeom>
                <a:ln w="64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grpSp>
              <p:nvGrpSpPr>
                <p:cNvPr id="369" name=""/>
                <p:cNvGrpSpPr/>
                <p:nvPr/>
              </p:nvGrpSpPr>
              <p:grpSpPr>
                <a:xfrm>
                  <a:off x="747360" y="2030400"/>
                  <a:ext cx="1457640" cy="34920"/>
                  <a:chOff x="747360" y="2030400"/>
                  <a:chExt cx="1457640" cy="34920"/>
                </a:xfrm>
              </p:grpSpPr>
              <p:sp>
                <p:nvSpPr>
                  <p:cNvPr id="370" name=""/>
                  <p:cNvSpPr/>
                  <p:nvPr/>
                </p:nvSpPr>
                <p:spPr>
                  <a:xfrm>
                    <a:off x="747360" y="2030400"/>
                    <a:ext cx="1800" cy="3492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11880" bIns="-1188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371" name=""/>
                  <p:cNvSpPr/>
                  <p:nvPr/>
                </p:nvSpPr>
                <p:spPr>
                  <a:xfrm>
                    <a:off x="853920" y="2030400"/>
                    <a:ext cx="1440" cy="1260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4200" bIns="-3420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372" name=""/>
                  <p:cNvSpPr/>
                  <p:nvPr/>
                </p:nvSpPr>
                <p:spPr>
                  <a:xfrm>
                    <a:off x="917280" y="2030400"/>
                    <a:ext cx="1800" cy="1260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4200" bIns="-3420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373" name=""/>
                  <p:cNvSpPr/>
                  <p:nvPr/>
                </p:nvSpPr>
                <p:spPr>
                  <a:xfrm>
                    <a:off x="961920" y="2030400"/>
                    <a:ext cx="1440" cy="1260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4200" bIns="-3420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374" name=""/>
                  <p:cNvSpPr/>
                  <p:nvPr/>
                </p:nvSpPr>
                <p:spPr>
                  <a:xfrm>
                    <a:off x="1001520" y="2030400"/>
                    <a:ext cx="1440" cy="2376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23040" bIns="-2304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375" name=""/>
                  <p:cNvSpPr/>
                  <p:nvPr/>
                </p:nvSpPr>
                <p:spPr>
                  <a:xfrm>
                    <a:off x="1029960" y="2030400"/>
                    <a:ext cx="1800" cy="1260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4200" bIns="-3420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376" name=""/>
                  <p:cNvSpPr/>
                  <p:nvPr/>
                </p:nvSpPr>
                <p:spPr>
                  <a:xfrm>
                    <a:off x="1052280" y="2030400"/>
                    <a:ext cx="1800" cy="1260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4200" bIns="-3420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377" name=""/>
                  <p:cNvSpPr/>
                  <p:nvPr/>
                </p:nvSpPr>
                <p:spPr>
                  <a:xfrm>
                    <a:off x="1074600" y="2030400"/>
                    <a:ext cx="1440" cy="1260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4200" bIns="-3420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378" name=""/>
                  <p:cNvSpPr/>
                  <p:nvPr/>
                </p:nvSpPr>
                <p:spPr>
                  <a:xfrm>
                    <a:off x="1091880" y="2030400"/>
                    <a:ext cx="1800" cy="1260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4200" bIns="-3420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379" name=""/>
                  <p:cNvSpPr/>
                  <p:nvPr/>
                </p:nvSpPr>
                <p:spPr>
                  <a:xfrm>
                    <a:off x="1107720" y="2030400"/>
                    <a:ext cx="1800" cy="3492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11880" bIns="-1188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380" name=""/>
                  <p:cNvSpPr/>
                  <p:nvPr/>
                </p:nvSpPr>
                <p:spPr>
                  <a:xfrm>
                    <a:off x="1220760" y="2030400"/>
                    <a:ext cx="1440" cy="1260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4200" bIns="-3420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381" name=""/>
                  <p:cNvSpPr/>
                  <p:nvPr/>
                </p:nvSpPr>
                <p:spPr>
                  <a:xfrm>
                    <a:off x="1284120" y="2030400"/>
                    <a:ext cx="1440" cy="1260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4200" bIns="-3420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382" name=""/>
                  <p:cNvSpPr/>
                  <p:nvPr/>
                </p:nvSpPr>
                <p:spPr>
                  <a:xfrm>
                    <a:off x="1328400" y="2030400"/>
                    <a:ext cx="1800" cy="1260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4200" bIns="-3420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383" name=""/>
                  <p:cNvSpPr/>
                  <p:nvPr/>
                </p:nvSpPr>
                <p:spPr>
                  <a:xfrm>
                    <a:off x="1361880" y="2030400"/>
                    <a:ext cx="1440" cy="2376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23040" bIns="-2304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384" name=""/>
                  <p:cNvSpPr/>
                  <p:nvPr/>
                </p:nvSpPr>
                <p:spPr>
                  <a:xfrm>
                    <a:off x="1396800" y="2030400"/>
                    <a:ext cx="1440" cy="1260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4200" bIns="-3420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385" name=""/>
                  <p:cNvSpPr/>
                  <p:nvPr/>
                </p:nvSpPr>
                <p:spPr>
                  <a:xfrm>
                    <a:off x="1419120" y="2030400"/>
                    <a:ext cx="1440" cy="1260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4200" bIns="-3420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386" name=""/>
                  <p:cNvSpPr/>
                  <p:nvPr/>
                </p:nvSpPr>
                <p:spPr>
                  <a:xfrm>
                    <a:off x="1441080" y="2030400"/>
                    <a:ext cx="1800" cy="1260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4200" bIns="-3420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387" name=""/>
                  <p:cNvSpPr/>
                  <p:nvPr/>
                </p:nvSpPr>
                <p:spPr>
                  <a:xfrm>
                    <a:off x="1458720" y="2030400"/>
                    <a:ext cx="1440" cy="1260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4200" bIns="-3420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388" name=""/>
                  <p:cNvSpPr/>
                  <p:nvPr/>
                </p:nvSpPr>
                <p:spPr>
                  <a:xfrm>
                    <a:off x="1474560" y="2030400"/>
                    <a:ext cx="1440" cy="3492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11880" bIns="-1188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389" name=""/>
                  <p:cNvSpPr/>
                  <p:nvPr/>
                </p:nvSpPr>
                <p:spPr>
                  <a:xfrm>
                    <a:off x="1582560" y="2030400"/>
                    <a:ext cx="1440" cy="1260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4200" bIns="-3420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390" name=""/>
                  <p:cNvSpPr/>
                  <p:nvPr/>
                </p:nvSpPr>
                <p:spPr>
                  <a:xfrm>
                    <a:off x="1649160" y="2030400"/>
                    <a:ext cx="1800" cy="1260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4200" bIns="-3420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391" name=""/>
                  <p:cNvSpPr/>
                  <p:nvPr/>
                </p:nvSpPr>
                <p:spPr>
                  <a:xfrm>
                    <a:off x="1695240" y="2030400"/>
                    <a:ext cx="1440" cy="1260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4200" bIns="-3420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392" name=""/>
                  <p:cNvSpPr/>
                  <p:nvPr/>
                </p:nvSpPr>
                <p:spPr>
                  <a:xfrm>
                    <a:off x="1728720" y="2030400"/>
                    <a:ext cx="1440" cy="2376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23040" bIns="-2304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393" name=""/>
                  <p:cNvSpPr/>
                  <p:nvPr/>
                </p:nvSpPr>
                <p:spPr>
                  <a:xfrm>
                    <a:off x="1757160" y="2030400"/>
                    <a:ext cx="1440" cy="1260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4200" bIns="-3420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394" name=""/>
                  <p:cNvSpPr/>
                  <p:nvPr/>
                </p:nvSpPr>
                <p:spPr>
                  <a:xfrm>
                    <a:off x="1785600" y="2030400"/>
                    <a:ext cx="1800" cy="1260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4200" bIns="-3420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395" name=""/>
                  <p:cNvSpPr/>
                  <p:nvPr/>
                </p:nvSpPr>
                <p:spPr>
                  <a:xfrm>
                    <a:off x="1801440" y="2030400"/>
                    <a:ext cx="1800" cy="1260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4200" bIns="-3420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396" name=""/>
                  <p:cNvSpPr/>
                  <p:nvPr/>
                </p:nvSpPr>
                <p:spPr>
                  <a:xfrm>
                    <a:off x="1825560" y="2030400"/>
                    <a:ext cx="1440" cy="1260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4200" bIns="-3420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397" name=""/>
                  <p:cNvSpPr/>
                  <p:nvPr/>
                </p:nvSpPr>
                <p:spPr>
                  <a:xfrm>
                    <a:off x="1841400" y="2030400"/>
                    <a:ext cx="1440" cy="3492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11880" bIns="-1188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398" name=""/>
                  <p:cNvSpPr/>
                  <p:nvPr/>
                </p:nvSpPr>
                <p:spPr>
                  <a:xfrm>
                    <a:off x="1949400" y="2030400"/>
                    <a:ext cx="1440" cy="1260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4200" bIns="-3420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399" name=""/>
                  <p:cNvSpPr/>
                  <p:nvPr/>
                </p:nvSpPr>
                <p:spPr>
                  <a:xfrm>
                    <a:off x="2016000" y="2030400"/>
                    <a:ext cx="1440" cy="1260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4200" bIns="-3420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400" name=""/>
                  <p:cNvSpPr/>
                  <p:nvPr/>
                </p:nvSpPr>
                <p:spPr>
                  <a:xfrm>
                    <a:off x="2062080" y="2030400"/>
                    <a:ext cx="1440" cy="1260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4200" bIns="-3420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401" name=""/>
                  <p:cNvSpPr/>
                  <p:nvPr/>
                </p:nvSpPr>
                <p:spPr>
                  <a:xfrm>
                    <a:off x="2095200" y="2030400"/>
                    <a:ext cx="1800" cy="2376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23040" bIns="-2304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402" name=""/>
                  <p:cNvSpPr/>
                  <p:nvPr/>
                </p:nvSpPr>
                <p:spPr>
                  <a:xfrm>
                    <a:off x="2124000" y="2030400"/>
                    <a:ext cx="1440" cy="1260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4200" bIns="-3420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403" name=""/>
                  <p:cNvSpPr/>
                  <p:nvPr/>
                </p:nvSpPr>
                <p:spPr>
                  <a:xfrm>
                    <a:off x="2145960" y="2030400"/>
                    <a:ext cx="1800" cy="1260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4200" bIns="-3420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404" name=""/>
                  <p:cNvSpPr/>
                  <p:nvPr/>
                </p:nvSpPr>
                <p:spPr>
                  <a:xfrm>
                    <a:off x="2168280" y="2030400"/>
                    <a:ext cx="1800" cy="1260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4200" bIns="-3420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405" name=""/>
                  <p:cNvSpPr/>
                  <p:nvPr/>
                </p:nvSpPr>
                <p:spPr>
                  <a:xfrm>
                    <a:off x="2185920" y="2030400"/>
                    <a:ext cx="1440" cy="1260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4200" bIns="-3420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406" name=""/>
                  <p:cNvSpPr/>
                  <p:nvPr/>
                </p:nvSpPr>
                <p:spPr>
                  <a:xfrm>
                    <a:off x="2203200" y="2030400"/>
                    <a:ext cx="1800" cy="3492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11880" bIns="-1188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</p:grpSp>
            <p:grpSp>
              <p:nvGrpSpPr>
                <p:cNvPr id="407" name=""/>
                <p:cNvGrpSpPr/>
                <p:nvPr/>
              </p:nvGrpSpPr>
              <p:grpSpPr>
                <a:xfrm>
                  <a:off x="675720" y="2073240"/>
                  <a:ext cx="1607040" cy="160200"/>
                  <a:chOff x="675720" y="2073240"/>
                  <a:chExt cx="1607040" cy="160200"/>
                </a:xfrm>
              </p:grpSpPr>
              <p:sp>
                <p:nvSpPr>
                  <p:cNvPr id="408" name=""/>
                  <p:cNvSpPr/>
                  <p:nvPr/>
                </p:nvSpPr>
                <p:spPr>
                  <a:xfrm>
                    <a:off x="675720" y="2111400"/>
                    <a:ext cx="113400" cy="12204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1" lang="en-US" sz="800" spc="-1" strike="noStrike">
                        <a:solidFill>
                          <a:srgbClr val="000000"/>
                        </a:solidFill>
                        <a:latin typeface="Arial"/>
                      </a:rPr>
                      <a:t>10</a:t>
                    </a:r>
                    <a:endParaRPr b="0" lang="en-US" sz="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409" name=""/>
                  <p:cNvSpPr/>
                  <p:nvPr/>
                </p:nvSpPr>
                <p:spPr>
                  <a:xfrm>
                    <a:off x="777600" y="2073240"/>
                    <a:ext cx="49320" cy="10692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1" lang="en-US" sz="700" spc="-1" strike="noStrike">
                        <a:solidFill>
                          <a:srgbClr val="000000"/>
                        </a:solidFill>
                        <a:latin typeface="Arial"/>
                      </a:rPr>
                      <a:t>0</a:t>
                    </a:r>
                    <a:endParaRPr b="0" lang="en-US" sz="7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410" name=""/>
                  <p:cNvSpPr/>
                  <p:nvPr/>
                </p:nvSpPr>
                <p:spPr>
                  <a:xfrm>
                    <a:off x="1036080" y="2111400"/>
                    <a:ext cx="113400" cy="12204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1" lang="en-US" sz="800" spc="-1" strike="noStrike">
                        <a:solidFill>
                          <a:srgbClr val="000000"/>
                        </a:solidFill>
                        <a:latin typeface="Arial"/>
                      </a:rPr>
                      <a:t>10</a:t>
                    </a:r>
                    <a:endParaRPr b="0" lang="en-US" sz="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411" name=""/>
                  <p:cNvSpPr/>
                  <p:nvPr/>
                </p:nvSpPr>
                <p:spPr>
                  <a:xfrm>
                    <a:off x="1137960" y="2073240"/>
                    <a:ext cx="49320" cy="10692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1" lang="en-US" sz="700" spc="-1" strike="noStrike">
                        <a:solidFill>
                          <a:srgbClr val="000000"/>
                        </a:solidFill>
                        <a:latin typeface="Arial"/>
                      </a:rPr>
                      <a:t>1</a:t>
                    </a:r>
                    <a:endParaRPr b="0" lang="en-US" sz="7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412" name=""/>
                  <p:cNvSpPr/>
                  <p:nvPr/>
                </p:nvSpPr>
                <p:spPr>
                  <a:xfrm>
                    <a:off x="1402920" y="2111400"/>
                    <a:ext cx="113400" cy="12204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1" lang="en-US" sz="800" spc="-1" strike="noStrike">
                        <a:solidFill>
                          <a:srgbClr val="000000"/>
                        </a:solidFill>
                        <a:latin typeface="Arial"/>
                      </a:rPr>
                      <a:t>10</a:t>
                    </a:r>
                    <a:endParaRPr b="0" lang="en-US" sz="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413" name=""/>
                  <p:cNvSpPr/>
                  <p:nvPr/>
                </p:nvSpPr>
                <p:spPr>
                  <a:xfrm>
                    <a:off x="1504800" y="2073240"/>
                    <a:ext cx="49320" cy="10692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1" lang="en-US" sz="700" spc="-1" strike="noStrike">
                        <a:solidFill>
                          <a:srgbClr val="000000"/>
                        </a:solidFill>
                        <a:latin typeface="Arial"/>
                      </a:rPr>
                      <a:t>2</a:t>
                    </a:r>
                    <a:endParaRPr b="0" lang="en-US" sz="7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414" name=""/>
                  <p:cNvSpPr/>
                  <p:nvPr/>
                </p:nvSpPr>
                <p:spPr>
                  <a:xfrm>
                    <a:off x="1769400" y="2111400"/>
                    <a:ext cx="113400" cy="12204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1" lang="en-US" sz="800" spc="-1" strike="noStrike">
                        <a:solidFill>
                          <a:srgbClr val="000000"/>
                        </a:solidFill>
                        <a:latin typeface="Arial"/>
                      </a:rPr>
                      <a:t>10</a:t>
                    </a:r>
                    <a:endParaRPr b="0" lang="en-US" sz="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415" name=""/>
                  <p:cNvSpPr/>
                  <p:nvPr/>
                </p:nvSpPr>
                <p:spPr>
                  <a:xfrm>
                    <a:off x="1871640" y="2073240"/>
                    <a:ext cx="49320" cy="10692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1" lang="en-US" sz="700" spc="-1" strike="noStrike">
                        <a:solidFill>
                          <a:srgbClr val="000000"/>
                        </a:solidFill>
                        <a:latin typeface="Arial"/>
                      </a:rPr>
                      <a:t>3</a:t>
                    </a:r>
                    <a:endParaRPr b="0" lang="en-US" sz="7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416" name=""/>
                  <p:cNvSpPr/>
                  <p:nvPr/>
                </p:nvSpPr>
                <p:spPr>
                  <a:xfrm>
                    <a:off x="2131560" y="2111400"/>
                    <a:ext cx="113400" cy="12204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1" lang="en-US" sz="800" spc="-1" strike="noStrike">
                        <a:solidFill>
                          <a:srgbClr val="000000"/>
                        </a:solidFill>
                        <a:latin typeface="Arial"/>
                      </a:rPr>
                      <a:t>10</a:t>
                    </a:r>
                    <a:endParaRPr b="0" lang="en-US" sz="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417" name=""/>
                  <p:cNvSpPr/>
                  <p:nvPr/>
                </p:nvSpPr>
                <p:spPr>
                  <a:xfrm>
                    <a:off x="2233440" y="2073240"/>
                    <a:ext cx="49320" cy="10692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1" lang="en-US" sz="700" spc="-1" strike="noStrike">
                        <a:solidFill>
                          <a:srgbClr val="000000"/>
                        </a:solidFill>
                        <a:latin typeface="Arial"/>
                      </a:rPr>
                      <a:t>4</a:t>
                    </a:r>
                    <a:endParaRPr b="0" lang="en-US" sz="7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</p:grpSp>
            <p:sp>
              <p:nvSpPr>
                <p:cNvPr id="418" name=""/>
                <p:cNvSpPr/>
                <p:nvPr/>
              </p:nvSpPr>
              <p:spPr>
                <a:xfrm>
                  <a:off x="1387440" y="2201760"/>
                  <a:ext cx="203400" cy="1220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800" spc="-1" strike="noStrike">
                      <a:solidFill>
                        <a:srgbClr val="000000"/>
                      </a:solidFill>
                      <a:latin typeface="Arial"/>
                    </a:rPr>
                    <a:t>CD4</a:t>
                  </a:r>
                  <a:endParaRPr b="0" lang="en-US" sz="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grpSp>
            <p:nvGrpSpPr>
              <p:cNvPr id="419" name=""/>
              <p:cNvGrpSpPr/>
              <p:nvPr/>
            </p:nvGrpSpPr>
            <p:grpSpPr>
              <a:xfrm>
                <a:off x="442800" y="569880"/>
                <a:ext cx="306360" cy="1539720"/>
                <a:chOff x="442800" y="569880"/>
                <a:chExt cx="306360" cy="1539720"/>
              </a:xfrm>
            </p:grpSpPr>
            <p:sp>
              <p:nvSpPr>
                <p:cNvPr id="420" name=""/>
                <p:cNvSpPr/>
                <p:nvPr/>
              </p:nvSpPr>
              <p:spPr>
                <a:xfrm flipV="1">
                  <a:off x="747360" y="569880"/>
                  <a:ext cx="1800" cy="1455840"/>
                </a:xfrm>
                <a:prstGeom prst="line">
                  <a:avLst/>
                </a:prstGeom>
                <a:ln w="64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grpSp>
              <p:nvGrpSpPr>
                <p:cNvPr id="421" name=""/>
                <p:cNvGrpSpPr/>
                <p:nvPr/>
              </p:nvGrpSpPr>
              <p:grpSpPr>
                <a:xfrm>
                  <a:off x="541080" y="684000"/>
                  <a:ext cx="169920" cy="1425600"/>
                  <a:chOff x="541080" y="684000"/>
                  <a:chExt cx="169920" cy="1425600"/>
                </a:xfrm>
              </p:grpSpPr>
              <p:sp>
                <p:nvSpPr>
                  <p:cNvPr id="422" name=""/>
                  <p:cNvSpPr/>
                  <p:nvPr/>
                </p:nvSpPr>
                <p:spPr>
                  <a:xfrm>
                    <a:off x="642600" y="1987560"/>
                    <a:ext cx="57240" cy="12204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1" lang="en-US" sz="800" spc="-1" strike="noStrike">
                        <a:solidFill>
                          <a:srgbClr val="000000"/>
                        </a:solidFill>
                        <a:latin typeface="Arial"/>
                      </a:rPr>
                      <a:t>0</a:t>
                    </a:r>
                    <a:endParaRPr b="0" lang="en-US" sz="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423" name=""/>
                  <p:cNvSpPr/>
                  <p:nvPr/>
                </p:nvSpPr>
                <p:spPr>
                  <a:xfrm>
                    <a:off x="541080" y="1728720"/>
                    <a:ext cx="169920" cy="12204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1" lang="en-US" sz="800" spc="-1" strike="noStrike">
                        <a:solidFill>
                          <a:srgbClr val="000000"/>
                        </a:solidFill>
                        <a:latin typeface="Arial"/>
                      </a:rPr>
                      <a:t>100</a:t>
                    </a:r>
                    <a:endParaRPr b="0" lang="en-US" sz="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424" name=""/>
                  <p:cNvSpPr/>
                  <p:nvPr/>
                </p:nvSpPr>
                <p:spPr>
                  <a:xfrm>
                    <a:off x="541080" y="1468440"/>
                    <a:ext cx="169920" cy="12204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1" lang="en-US" sz="800" spc="-1" strike="noStrike">
                        <a:solidFill>
                          <a:srgbClr val="000000"/>
                        </a:solidFill>
                        <a:latin typeface="Arial"/>
                      </a:rPr>
                      <a:t>200</a:t>
                    </a:r>
                    <a:endParaRPr b="0" lang="en-US" sz="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425" name=""/>
                  <p:cNvSpPr/>
                  <p:nvPr/>
                </p:nvSpPr>
                <p:spPr>
                  <a:xfrm>
                    <a:off x="541080" y="1209600"/>
                    <a:ext cx="169920" cy="12204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1" lang="en-US" sz="800" spc="-1" strike="noStrike">
                        <a:solidFill>
                          <a:srgbClr val="000000"/>
                        </a:solidFill>
                        <a:latin typeface="Arial"/>
                      </a:rPr>
                      <a:t>300</a:t>
                    </a:r>
                    <a:endParaRPr b="0" lang="en-US" sz="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426" name=""/>
                  <p:cNvSpPr/>
                  <p:nvPr/>
                </p:nvSpPr>
                <p:spPr>
                  <a:xfrm>
                    <a:off x="541080" y="944640"/>
                    <a:ext cx="169920" cy="12204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1" lang="en-US" sz="800" spc="-1" strike="noStrike">
                        <a:solidFill>
                          <a:srgbClr val="000000"/>
                        </a:solidFill>
                        <a:latin typeface="Arial"/>
                      </a:rPr>
                      <a:t>400</a:t>
                    </a:r>
                    <a:endParaRPr b="0" lang="en-US" sz="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427" name=""/>
                  <p:cNvSpPr/>
                  <p:nvPr/>
                </p:nvSpPr>
                <p:spPr>
                  <a:xfrm>
                    <a:off x="541080" y="684000"/>
                    <a:ext cx="169920" cy="12204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1" lang="en-US" sz="800" spc="-1" strike="noStrike">
                        <a:solidFill>
                          <a:srgbClr val="000000"/>
                        </a:solidFill>
                        <a:latin typeface="Arial"/>
                      </a:rPr>
                      <a:t>500</a:t>
                    </a:r>
                    <a:endParaRPr b="0" lang="en-US" sz="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</p:grpSp>
            <p:grpSp>
              <p:nvGrpSpPr>
                <p:cNvPr id="428" name=""/>
                <p:cNvGrpSpPr/>
                <p:nvPr/>
              </p:nvGrpSpPr>
              <p:grpSpPr>
                <a:xfrm>
                  <a:off x="714240" y="592200"/>
                  <a:ext cx="33120" cy="1434960"/>
                  <a:chOff x="714240" y="592200"/>
                  <a:chExt cx="33120" cy="1434960"/>
                </a:xfrm>
              </p:grpSpPr>
              <p:sp>
                <p:nvSpPr>
                  <p:cNvPr id="429" name=""/>
                  <p:cNvSpPr/>
                  <p:nvPr/>
                </p:nvSpPr>
                <p:spPr>
                  <a:xfrm flipH="1">
                    <a:off x="714240" y="2025720"/>
                    <a:ext cx="33120" cy="144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5360" bIns="-4536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430" name=""/>
                  <p:cNvSpPr/>
                  <p:nvPr/>
                </p:nvSpPr>
                <p:spPr>
                  <a:xfrm flipH="1">
                    <a:off x="736560" y="1963800"/>
                    <a:ext cx="10800" cy="144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5360" bIns="-4536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431" name=""/>
                  <p:cNvSpPr/>
                  <p:nvPr/>
                </p:nvSpPr>
                <p:spPr>
                  <a:xfrm flipH="1">
                    <a:off x="736560" y="1895400"/>
                    <a:ext cx="10800" cy="180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5000" bIns="-4500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432" name=""/>
                  <p:cNvSpPr/>
                  <p:nvPr/>
                </p:nvSpPr>
                <p:spPr>
                  <a:xfrm flipH="1">
                    <a:off x="736560" y="1833480"/>
                    <a:ext cx="10800" cy="180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5000" bIns="-4500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433" name=""/>
                  <p:cNvSpPr/>
                  <p:nvPr/>
                </p:nvSpPr>
                <p:spPr>
                  <a:xfrm flipH="1">
                    <a:off x="714240" y="1765440"/>
                    <a:ext cx="33120" cy="144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5360" bIns="-4536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434" name=""/>
                  <p:cNvSpPr/>
                  <p:nvPr/>
                </p:nvSpPr>
                <p:spPr>
                  <a:xfrm flipH="1">
                    <a:off x="736560" y="1703520"/>
                    <a:ext cx="10800" cy="144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5360" bIns="-4536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435" name=""/>
                  <p:cNvSpPr/>
                  <p:nvPr/>
                </p:nvSpPr>
                <p:spPr>
                  <a:xfrm flipH="1">
                    <a:off x="736560" y="1636560"/>
                    <a:ext cx="10800" cy="180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5000" bIns="-4500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436" name=""/>
                  <p:cNvSpPr/>
                  <p:nvPr/>
                </p:nvSpPr>
                <p:spPr>
                  <a:xfrm flipH="1">
                    <a:off x="736560" y="1568520"/>
                    <a:ext cx="10800" cy="144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5360" bIns="-4536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437" name=""/>
                  <p:cNvSpPr/>
                  <p:nvPr/>
                </p:nvSpPr>
                <p:spPr>
                  <a:xfrm flipH="1">
                    <a:off x="714240" y="1506600"/>
                    <a:ext cx="33120" cy="144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5360" bIns="-4536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438" name=""/>
                  <p:cNvSpPr/>
                  <p:nvPr/>
                </p:nvSpPr>
                <p:spPr>
                  <a:xfrm flipH="1">
                    <a:off x="736560" y="1438200"/>
                    <a:ext cx="10800" cy="180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5000" bIns="-4500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439" name=""/>
                  <p:cNvSpPr/>
                  <p:nvPr/>
                </p:nvSpPr>
                <p:spPr>
                  <a:xfrm flipH="1">
                    <a:off x="736560" y="1376280"/>
                    <a:ext cx="10800" cy="180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5000" bIns="-4500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440" name=""/>
                  <p:cNvSpPr/>
                  <p:nvPr/>
                </p:nvSpPr>
                <p:spPr>
                  <a:xfrm flipH="1">
                    <a:off x="736560" y="1309680"/>
                    <a:ext cx="10800" cy="144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5360" bIns="-4536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441" name=""/>
                  <p:cNvSpPr/>
                  <p:nvPr/>
                </p:nvSpPr>
                <p:spPr>
                  <a:xfrm flipH="1">
                    <a:off x="714240" y="1246320"/>
                    <a:ext cx="33120" cy="144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5360" bIns="-4536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442" name=""/>
                  <p:cNvSpPr/>
                  <p:nvPr/>
                </p:nvSpPr>
                <p:spPr>
                  <a:xfrm flipH="1">
                    <a:off x="736560" y="1179360"/>
                    <a:ext cx="10800" cy="180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5000" bIns="-4500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443" name=""/>
                  <p:cNvSpPr/>
                  <p:nvPr/>
                </p:nvSpPr>
                <p:spPr>
                  <a:xfrm flipH="1">
                    <a:off x="736560" y="1111320"/>
                    <a:ext cx="10800" cy="144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5360" bIns="-4536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444" name=""/>
                  <p:cNvSpPr/>
                  <p:nvPr/>
                </p:nvSpPr>
                <p:spPr>
                  <a:xfrm flipH="1">
                    <a:off x="736560" y="1049400"/>
                    <a:ext cx="10800" cy="144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5360" bIns="-4536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445" name=""/>
                  <p:cNvSpPr/>
                  <p:nvPr/>
                </p:nvSpPr>
                <p:spPr>
                  <a:xfrm flipH="1">
                    <a:off x="714240" y="981000"/>
                    <a:ext cx="33120" cy="180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5000" bIns="-4500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446" name=""/>
                  <p:cNvSpPr/>
                  <p:nvPr/>
                </p:nvSpPr>
                <p:spPr>
                  <a:xfrm flipH="1">
                    <a:off x="736560" y="919080"/>
                    <a:ext cx="10800" cy="180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5000" bIns="-4500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447" name=""/>
                  <p:cNvSpPr/>
                  <p:nvPr/>
                </p:nvSpPr>
                <p:spPr>
                  <a:xfrm flipH="1">
                    <a:off x="736560" y="852480"/>
                    <a:ext cx="10800" cy="144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5360" bIns="-4536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448" name=""/>
                  <p:cNvSpPr/>
                  <p:nvPr/>
                </p:nvSpPr>
                <p:spPr>
                  <a:xfrm flipH="1">
                    <a:off x="736560" y="784080"/>
                    <a:ext cx="10800" cy="180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5000" bIns="-4500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449" name=""/>
                  <p:cNvSpPr/>
                  <p:nvPr/>
                </p:nvSpPr>
                <p:spPr>
                  <a:xfrm flipH="1">
                    <a:off x="714240" y="722160"/>
                    <a:ext cx="33120" cy="180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5000" bIns="-4500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450" name=""/>
                  <p:cNvSpPr/>
                  <p:nvPr/>
                </p:nvSpPr>
                <p:spPr>
                  <a:xfrm flipH="1">
                    <a:off x="736560" y="654120"/>
                    <a:ext cx="10800" cy="144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5360" bIns="-4536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451" name=""/>
                  <p:cNvSpPr/>
                  <p:nvPr/>
                </p:nvSpPr>
                <p:spPr>
                  <a:xfrm flipH="1">
                    <a:off x="736560" y="592200"/>
                    <a:ext cx="10800" cy="144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5360" bIns="-4536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</p:grpSp>
            <p:sp>
              <p:nvSpPr>
                <p:cNvPr id="452" name=""/>
                <p:cNvSpPr/>
                <p:nvPr/>
              </p:nvSpPr>
              <p:spPr>
                <a:xfrm rot="16200000">
                  <a:off x="338760" y="1211400"/>
                  <a:ext cx="329760" cy="1220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800" spc="-1" strike="noStrike">
                      <a:solidFill>
                        <a:srgbClr val="000000"/>
                      </a:solidFill>
                      <a:latin typeface="Arial"/>
                    </a:rPr>
                    <a:t># Cells</a:t>
                  </a:r>
                  <a:endParaRPr b="0" lang="en-US" sz="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</p:grpSp>
        <p:grpSp>
          <p:nvGrpSpPr>
            <p:cNvPr id="453" name=""/>
            <p:cNvGrpSpPr/>
            <p:nvPr/>
          </p:nvGrpSpPr>
          <p:grpSpPr>
            <a:xfrm>
              <a:off x="758520" y="581040"/>
              <a:ext cx="1433520" cy="1438200"/>
              <a:chOff x="758520" y="581040"/>
              <a:chExt cx="1433520" cy="1438200"/>
            </a:xfrm>
          </p:grpSpPr>
          <p:sp>
            <p:nvSpPr>
              <p:cNvPr id="454" name=""/>
              <p:cNvSpPr/>
              <p:nvPr/>
            </p:nvSpPr>
            <p:spPr>
              <a:xfrm>
                <a:off x="758520" y="581040"/>
                <a:ext cx="1433520" cy="1438200"/>
              </a:xfrm>
              <a:custGeom>
                <a:avLst/>
                <a:gdLst/>
                <a:ahLst/>
                <a:rect l="l" t="t" r="r" b="b"/>
                <a:pathLst>
                  <a:path w="903" h="906">
                    <a:moveTo>
                      <a:pt x="0" y="906"/>
                    </a:moveTo>
                    <a:lnTo>
                      <a:pt x="0" y="0"/>
                    </a:lnTo>
                    <a:lnTo>
                      <a:pt x="4" y="867"/>
                    </a:lnTo>
                    <a:lnTo>
                      <a:pt x="7" y="903"/>
                    </a:lnTo>
                    <a:lnTo>
                      <a:pt x="11" y="903"/>
                    </a:lnTo>
                    <a:lnTo>
                      <a:pt x="14" y="903"/>
                    </a:lnTo>
                    <a:lnTo>
                      <a:pt x="18" y="903"/>
                    </a:lnTo>
                    <a:lnTo>
                      <a:pt x="21" y="903"/>
                    </a:lnTo>
                    <a:lnTo>
                      <a:pt x="25" y="903"/>
                    </a:lnTo>
                    <a:lnTo>
                      <a:pt x="29" y="903"/>
                    </a:lnTo>
                    <a:lnTo>
                      <a:pt x="32" y="903"/>
                    </a:lnTo>
                    <a:lnTo>
                      <a:pt x="36" y="903"/>
                    </a:lnTo>
                    <a:lnTo>
                      <a:pt x="39" y="903"/>
                    </a:lnTo>
                    <a:lnTo>
                      <a:pt x="43" y="903"/>
                    </a:lnTo>
                    <a:lnTo>
                      <a:pt x="46" y="903"/>
                    </a:lnTo>
                    <a:lnTo>
                      <a:pt x="50" y="903"/>
                    </a:lnTo>
                    <a:lnTo>
                      <a:pt x="53" y="903"/>
                    </a:lnTo>
                    <a:lnTo>
                      <a:pt x="57" y="903"/>
                    </a:lnTo>
                    <a:lnTo>
                      <a:pt x="60" y="903"/>
                    </a:lnTo>
                    <a:lnTo>
                      <a:pt x="64" y="903"/>
                    </a:lnTo>
                    <a:lnTo>
                      <a:pt x="68" y="903"/>
                    </a:lnTo>
                    <a:lnTo>
                      <a:pt x="71" y="903"/>
                    </a:lnTo>
                    <a:lnTo>
                      <a:pt x="75" y="903"/>
                    </a:lnTo>
                    <a:lnTo>
                      <a:pt x="78" y="903"/>
                    </a:lnTo>
                    <a:lnTo>
                      <a:pt x="82" y="903"/>
                    </a:lnTo>
                    <a:lnTo>
                      <a:pt x="85" y="903"/>
                    </a:lnTo>
                    <a:lnTo>
                      <a:pt x="89" y="903"/>
                    </a:lnTo>
                    <a:lnTo>
                      <a:pt x="92" y="903"/>
                    </a:lnTo>
                    <a:lnTo>
                      <a:pt x="96" y="903"/>
                    </a:lnTo>
                    <a:lnTo>
                      <a:pt x="100" y="903"/>
                    </a:lnTo>
                    <a:lnTo>
                      <a:pt x="103" y="903"/>
                    </a:lnTo>
                    <a:lnTo>
                      <a:pt x="107" y="903"/>
                    </a:lnTo>
                    <a:lnTo>
                      <a:pt x="110" y="903"/>
                    </a:lnTo>
                    <a:lnTo>
                      <a:pt x="114" y="903"/>
                    </a:lnTo>
                    <a:lnTo>
                      <a:pt x="117" y="903"/>
                    </a:lnTo>
                    <a:lnTo>
                      <a:pt x="121" y="903"/>
                    </a:lnTo>
                    <a:lnTo>
                      <a:pt x="124" y="903"/>
                    </a:lnTo>
                    <a:lnTo>
                      <a:pt x="128" y="903"/>
                    </a:lnTo>
                    <a:lnTo>
                      <a:pt x="132" y="903"/>
                    </a:lnTo>
                    <a:lnTo>
                      <a:pt x="135" y="903"/>
                    </a:lnTo>
                    <a:lnTo>
                      <a:pt x="139" y="903"/>
                    </a:lnTo>
                    <a:lnTo>
                      <a:pt x="142" y="903"/>
                    </a:lnTo>
                    <a:lnTo>
                      <a:pt x="146" y="903"/>
                    </a:lnTo>
                    <a:lnTo>
                      <a:pt x="149" y="903"/>
                    </a:lnTo>
                    <a:lnTo>
                      <a:pt x="153" y="903"/>
                    </a:lnTo>
                    <a:lnTo>
                      <a:pt x="156" y="903"/>
                    </a:lnTo>
                    <a:lnTo>
                      <a:pt x="160" y="903"/>
                    </a:lnTo>
                    <a:lnTo>
                      <a:pt x="164" y="903"/>
                    </a:lnTo>
                    <a:lnTo>
                      <a:pt x="167" y="903"/>
                    </a:lnTo>
                    <a:lnTo>
                      <a:pt x="171" y="903"/>
                    </a:lnTo>
                    <a:lnTo>
                      <a:pt x="174" y="903"/>
                    </a:lnTo>
                    <a:lnTo>
                      <a:pt x="178" y="903"/>
                    </a:lnTo>
                    <a:lnTo>
                      <a:pt x="181" y="903"/>
                    </a:lnTo>
                    <a:lnTo>
                      <a:pt x="185" y="903"/>
                    </a:lnTo>
                    <a:lnTo>
                      <a:pt x="188" y="903"/>
                    </a:lnTo>
                    <a:lnTo>
                      <a:pt x="192" y="903"/>
                    </a:lnTo>
                    <a:lnTo>
                      <a:pt x="196" y="903"/>
                    </a:lnTo>
                    <a:lnTo>
                      <a:pt x="199" y="903"/>
                    </a:lnTo>
                    <a:lnTo>
                      <a:pt x="203" y="903"/>
                    </a:lnTo>
                    <a:lnTo>
                      <a:pt x="206" y="903"/>
                    </a:lnTo>
                    <a:lnTo>
                      <a:pt x="210" y="903"/>
                    </a:lnTo>
                    <a:lnTo>
                      <a:pt x="213" y="903"/>
                    </a:lnTo>
                    <a:lnTo>
                      <a:pt x="217" y="903"/>
                    </a:lnTo>
                    <a:lnTo>
                      <a:pt x="220" y="903"/>
                    </a:lnTo>
                    <a:lnTo>
                      <a:pt x="224" y="903"/>
                    </a:lnTo>
                    <a:lnTo>
                      <a:pt x="227" y="903"/>
                    </a:lnTo>
                    <a:lnTo>
                      <a:pt x="231" y="903"/>
                    </a:lnTo>
                    <a:lnTo>
                      <a:pt x="235" y="903"/>
                    </a:lnTo>
                    <a:lnTo>
                      <a:pt x="238" y="903"/>
                    </a:lnTo>
                    <a:lnTo>
                      <a:pt x="242" y="903"/>
                    </a:lnTo>
                    <a:lnTo>
                      <a:pt x="245" y="903"/>
                    </a:lnTo>
                    <a:lnTo>
                      <a:pt x="249" y="903"/>
                    </a:lnTo>
                    <a:lnTo>
                      <a:pt x="252" y="903"/>
                    </a:lnTo>
                    <a:lnTo>
                      <a:pt x="256" y="903"/>
                    </a:lnTo>
                    <a:lnTo>
                      <a:pt x="259" y="903"/>
                    </a:lnTo>
                    <a:lnTo>
                      <a:pt x="263" y="903"/>
                    </a:lnTo>
                    <a:lnTo>
                      <a:pt x="267" y="903"/>
                    </a:lnTo>
                    <a:lnTo>
                      <a:pt x="270" y="903"/>
                    </a:lnTo>
                    <a:lnTo>
                      <a:pt x="274" y="903"/>
                    </a:lnTo>
                    <a:lnTo>
                      <a:pt x="277" y="903"/>
                    </a:lnTo>
                    <a:lnTo>
                      <a:pt x="281" y="903"/>
                    </a:lnTo>
                    <a:lnTo>
                      <a:pt x="284" y="903"/>
                    </a:lnTo>
                    <a:lnTo>
                      <a:pt x="288" y="903"/>
                    </a:lnTo>
                    <a:lnTo>
                      <a:pt x="291" y="903"/>
                    </a:lnTo>
                    <a:lnTo>
                      <a:pt x="295" y="903"/>
                    </a:lnTo>
                    <a:lnTo>
                      <a:pt x="299" y="903"/>
                    </a:lnTo>
                    <a:lnTo>
                      <a:pt x="302" y="903"/>
                    </a:lnTo>
                    <a:lnTo>
                      <a:pt x="306" y="903"/>
                    </a:lnTo>
                    <a:lnTo>
                      <a:pt x="309" y="903"/>
                    </a:lnTo>
                    <a:lnTo>
                      <a:pt x="313" y="903"/>
                    </a:lnTo>
                    <a:lnTo>
                      <a:pt x="316" y="903"/>
                    </a:lnTo>
                    <a:lnTo>
                      <a:pt x="320" y="903"/>
                    </a:lnTo>
                    <a:lnTo>
                      <a:pt x="323" y="903"/>
                    </a:lnTo>
                    <a:lnTo>
                      <a:pt x="327" y="903"/>
                    </a:lnTo>
                    <a:lnTo>
                      <a:pt x="331" y="903"/>
                    </a:lnTo>
                    <a:lnTo>
                      <a:pt x="334" y="903"/>
                    </a:lnTo>
                    <a:lnTo>
                      <a:pt x="338" y="903"/>
                    </a:lnTo>
                    <a:lnTo>
                      <a:pt x="341" y="903"/>
                    </a:lnTo>
                    <a:lnTo>
                      <a:pt x="345" y="903"/>
                    </a:lnTo>
                    <a:lnTo>
                      <a:pt x="348" y="903"/>
                    </a:lnTo>
                    <a:lnTo>
                      <a:pt x="352" y="903"/>
                    </a:lnTo>
                    <a:lnTo>
                      <a:pt x="355" y="903"/>
                    </a:lnTo>
                    <a:lnTo>
                      <a:pt x="359" y="903"/>
                    </a:lnTo>
                    <a:lnTo>
                      <a:pt x="363" y="903"/>
                    </a:lnTo>
                    <a:lnTo>
                      <a:pt x="366" y="903"/>
                    </a:lnTo>
                    <a:lnTo>
                      <a:pt x="370" y="903"/>
                    </a:lnTo>
                    <a:lnTo>
                      <a:pt x="373" y="903"/>
                    </a:lnTo>
                    <a:lnTo>
                      <a:pt x="377" y="903"/>
                    </a:lnTo>
                    <a:lnTo>
                      <a:pt x="380" y="903"/>
                    </a:lnTo>
                    <a:lnTo>
                      <a:pt x="384" y="903"/>
                    </a:lnTo>
                    <a:lnTo>
                      <a:pt x="387" y="903"/>
                    </a:lnTo>
                    <a:lnTo>
                      <a:pt x="391" y="903"/>
                    </a:lnTo>
                    <a:lnTo>
                      <a:pt x="394" y="903"/>
                    </a:lnTo>
                    <a:lnTo>
                      <a:pt x="398" y="903"/>
                    </a:lnTo>
                    <a:lnTo>
                      <a:pt x="402" y="903"/>
                    </a:lnTo>
                    <a:lnTo>
                      <a:pt x="405" y="903"/>
                    </a:lnTo>
                    <a:lnTo>
                      <a:pt x="409" y="903"/>
                    </a:lnTo>
                    <a:lnTo>
                      <a:pt x="412" y="903"/>
                    </a:lnTo>
                    <a:lnTo>
                      <a:pt x="416" y="903"/>
                    </a:lnTo>
                    <a:lnTo>
                      <a:pt x="419" y="903"/>
                    </a:lnTo>
                    <a:lnTo>
                      <a:pt x="423" y="903"/>
                    </a:lnTo>
                    <a:lnTo>
                      <a:pt x="426" y="903"/>
                    </a:lnTo>
                    <a:lnTo>
                      <a:pt x="430" y="899"/>
                    </a:lnTo>
                    <a:lnTo>
                      <a:pt x="434" y="899"/>
                    </a:lnTo>
                    <a:lnTo>
                      <a:pt x="437" y="896"/>
                    </a:lnTo>
                    <a:lnTo>
                      <a:pt x="441" y="896"/>
                    </a:lnTo>
                    <a:lnTo>
                      <a:pt x="444" y="892"/>
                    </a:lnTo>
                    <a:lnTo>
                      <a:pt x="448" y="892"/>
                    </a:lnTo>
                    <a:lnTo>
                      <a:pt x="451" y="892"/>
                    </a:lnTo>
                    <a:lnTo>
                      <a:pt x="455" y="889"/>
                    </a:lnTo>
                    <a:lnTo>
                      <a:pt x="458" y="885"/>
                    </a:lnTo>
                    <a:lnTo>
                      <a:pt x="462" y="881"/>
                    </a:lnTo>
                    <a:lnTo>
                      <a:pt x="466" y="878"/>
                    </a:lnTo>
                    <a:lnTo>
                      <a:pt x="469" y="874"/>
                    </a:lnTo>
                    <a:lnTo>
                      <a:pt x="473" y="871"/>
                    </a:lnTo>
                    <a:lnTo>
                      <a:pt x="476" y="867"/>
                    </a:lnTo>
                    <a:lnTo>
                      <a:pt x="480" y="860"/>
                    </a:lnTo>
                    <a:lnTo>
                      <a:pt x="483" y="857"/>
                    </a:lnTo>
                    <a:lnTo>
                      <a:pt x="487" y="846"/>
                    </a:lnTo>
                    <a:lnTo>
                      <a:pt x="490" y="839"/>
                    </a:lnTo>
                    <a:lnTo>
                      <a:pt x="494" y="828"/>
                    </a:lnTo>
                    <a:lnTo>
                      <a:pt x="498" y="821"/>
                    </a:lnTo>
                    <a:lnTo>
                      <a:pt x="501" y="810"/>
                    </a:lnTo>
                    <a:lnTo>
                      <a:pt x="505" y="796"/>
                    </a:lnTo>
                    <a:lnTo>
                      <a:pt x="508" y="778"/>
                    </a:lnTo>
                    <a:lnTo>
                      <a:pt x="512" y="764"/>
                    </a:lnTo>
                    <a:lnTo>
                      <a:pt x="515" y="753"/>
                    </a:lnTo>
                    <a:lnTo>
                      <a:pt x="519" y="739"/>
                    </a:lnTo>
                    <a:lnTo>
                      <a:pt x="522" y="707"/>
                    </a:lnTo>
                    <a:lnTo>
                      <a:pt x="526" y="686"/>
                    </a:lnTo>
                    <a:lnTo>
                      <a:pt x="530" y="675"/>
                    </a:lnTo>
                    <a:lnTo>
                      <a:pt x="533" y="647"/>
                    </a:lnTo>
                    <a:lnTo>
                      <a:pt x="537" y="608"/>
                    </a:lnTo>
                    <a:lnTo>
                      <a:pt x="540" y="590"/>
                    </a:lnTo>
                    <a:lnTo>
                      <a:pt x="544" y="572"/>
                    </a:lnTo>
                    <a:lnTo>
                      <a:pt x="547" y="526"/>
                    </a:lnTo>
                    <a:lnTo>
                      <a:pt x="551" y="487"/>
                    </a:lnTo>
                    <a:lnTo>
                      <a:pt x="554" y="498"/>
                    </a:lnTo>
                    <a:lnTo>
                      <a:pt x="558" y="476"/>
                    </a:lnTo>
                    <a:lnTo>
                      <a:pt x="561" y="427"/>
                    </a:lnTo>
                    <a:lnTo>
                      <a:pt x="565" y="387"/>
                    </a:lnTo>
                    <a:lnTo>
                      <a:pt x="569" y="341"/>
                    </a:lnTo>
                    <a:lnTo>
                      <a:pt x="572" y="284"/>
                    </a:lnTo>
                    <a:lnTo>
                      <a:pt x="576" y="228"/>
                    </a:lnTo>
                    <a:lnTo>
                      <a:pt x="579" y="174"/>
                    </a:lnTo>
                    <a:lnTo>
                      <a:pt x="583" y="135"/>
                    </a:lnTo>
                    <a:lnTo>
                      <a:pt x="586" y="110"/>
                    </a:lnTo>
                    <a:lnTo>
                      <a:pt x="590" y="68"/>
                    </a:lnTo>
                    <a:lnTo>
                      <a:pt x="593" y="43"/>
                    </a:lnTo>
                    <a:lnTo>
                      <a:pt x="597" y="53"/>
                    </a:lnTo>
                    <a:lnTo>
                      <a:pt x="601" y="78"/>
                    </a:lnTo>
                    <a:lnTo>
                      <a:pt x="604" y="121"/>
                    </a:lnTo>
                    <a:lnTo>
                      <a:pt x="608" y="196"/>
                    </a:lnTo>
                    <a:lnTo>
                      <a:pt x="611" y="306"/>
                    </a:lnTo>
                    <a:lnTo>
                      <a:pt x="615" y="402"/>
                    </a:lnTo>
                    <a:lnTo>
                      <a:pt x="618" y="444"/>
                    </a:lnTo>
                    <a:lnTo>
                      <a:pt x="622" y="526"/>
                    </a:lnTo>
                    <a:lnTo>
                      <a:pt x="625" y="636"/>
                    </a:lnTo>
                    <a:lnTo>
                      <a:pt x="629" y="718"/>
                    </a:lnTo>
                    <a:lnTo>
                      <a:pt x="633" y="778"/>
                    </a:lnTo>
                    <a:lnTo>
                      <a:pt x="636" y="821"/>
                    </a:lnTo>
                    <a:lnTo>
                      <a:pt x="640" y="846"/>
                    </a:lnTo>
                    <a:lnTo>
                      <a:pt x="643" y="864"/>
                    </a:lnTo>
                    <a:lnTo>
                      <a:pt x="647" y="874"/>
                    </a:lnTo>
                    <a:lnTo>
                      <a:pt x="650" y="881"/>
                    </a:lnTo>
                    <a:lnTo>
                      <a:pt x="654" y="889"/>
                    </a:lnTo>
                    <a:lnTo>
                      <a:pt x="657" y="892"/>
                    </a:lnTo>
                    <a:lnTo>
                      <a:pt x="661" y="892"/>
                    </a:lnTo>
                    <a:lnTo>
                      <a:pt x="665" y="896"/>
                    </a:lnTo>
                    <a:lnTo>
                      <a:pt x="668" y="899"/>
                    </a:lnTo>
                    <a:lnTo>
                      <a:pt x="672" y="899"/>
                    </a:lnTo>
                    <a:lnTo>
                      <a:pt x="675" y="899"/>
                    </a:lnTo>
                    <a:lnTo>
                      <a:pt x="679" y="899"/>
                    </a:lnTo>
                    <a:lnTo>
                      <a:pt x="682" y="899"/>
                    </a:lnTo>
                    <a:lnTo>
                      <a:pt x="686" y="903"/>
                    </a:lnTo>
                    <a:lnTo>
                      <a:pt x="689" y="903"/>
                    </a:lnTo>
                    <a:lnTo>
                      <a:pt x="693" y="903"/>
                    </a:lnTo>
                    <a:lnTo>
                      <a:pt x="697" y="903"/>
                    </a:lnTo>
                    <a:lnTo>
                      <a:pt x="700" y="903"/>
                    </a:lnTo>
                    <a:lnTo>
                      <a:pt x="704" y="903"/>
                    </a:lnTo>
                    <a:lnTo>
                      <a:pt x="707" y="903"/>
                    </a:lnTo>
                    <a:lnTo>
                      <a:pt x="711" y="903"/>
                    </a:lnTo>
                    <a:lnTo>
                      <a:pt x="714" y="903"/>
                    </a:lnTo>
                    <a:lnTo>
                      <a:pt x="718" y="903"/>
                    </a:lnTo>
                    <a:lnTo>
                      <a:pt x="721" y="903"/>
                    </a:lnTo>
                    <a:lnTo>
                      <a:pt x="725" y="903"/>
                    </a:lnTo>
                    <a:lnTo>
                      <a:pt x="728" y="903"/>
                    </a:lnTo>
                    <a:lnTo>
                      <a:pt x="732" y="903"/>
                    </a:lnTo>
                    <a:lnTo>
                      <a:pt x="736" y="903"/>
                    </a:lnTo>
                    <a:lnTo>
                      <a:pt x="739" y="903"/>
                    </a:lnTo>
                    <a:lnTo>
                      <a:pt x="743" y="903"/>
                    </a:lnTo>
                    <a:lnTo>
                      <a:pt x="746" y="903"/>
                    </a:lnTo>
                    <a:lnTo>
                      <a:pt x="750" y="903"/>
                    </a:lnTo>
                    <a:lnTo>
                      <a:pt x="753" y="903"/>
                    </a:lnTo>
                    <a:lnTo>
                      <a:pt x="757" y="903"/>
                    </a:lnTo>
                    <a:lnTo>
                      <a:pt x="760" y="903"/>
                    </a:lnTo>
                    <a:lnTo>
                      <a:pt x="764" y="903"/>
                    </a:lnTo>
                    <a:lnTo>
                      <a:pt x="768" y="903"/>
                    </a:lnTo>
                    <a:lnTo>
                      <a:pt x="771" y="903"/>
                    </a:lnTo>
                    <a:lnTo>
                      <a:pt x="775" y="903"/>
                    </a:lnTo>
                    <a:lnTo>
                      <a:pt x="778" y="903"/>
                    </a:lnTo>
                    <a:lnTo>
                      <a:pt x="782" y="903"/>
                    </a:lnTo>
                    <a:lnTo>
                      <a:pt x="785" y="903"/>
                    </a:lnTo>
                    <a:lnTo>
                      <a:pt x="789" y="903"/>
                    </a:lnTo>
                    <a:lnTo>
                      <a:pt x="792" y="903"/>
                    </a:lnTo>
                    <a:lnTo>
                      <a:pt x="796" y="903"/>
                    </a:lnTo>
                    <a:lnTo>
                      <a:pt x="800" y="903"/>
                    </a:lnTo>
                    <a:lnTo>
                      <a:pt x="803" y="903"/>
                    </a:lnTo>
                    <a:lnTo>
                      <a:pt x="807" y="906"/>
                    </a:lnTo>
                    <a:lnTo>
                      <a:pt x="810" y="903"/>
                    </a:lnTo>
                    <a:lnTo>
                      <a:pt x="814" y="903"/>
                    </a:lnTo>
                    <a:lnTo>
                      <a:pt x="817" y="903"/>
                    </a:lnTo>
                    <a:lnTo>
                      <a:pt x="821" y="903"/>
                    </a:lnTo>
                    <a:lnTo>
                      <a:pt x="824" y="903"/>
                    </a:lnTo>
                    <a:lnTo>
                      <a:pt x="828" y="903"/>
                    </a:lnTo>
                    <a:lnTo>
                      <a:pt x="832" y="903"/>
                    </a:lnTo>
                    <a:lnTo>
                      <a:pt x="835" y="903"/>
                    </a:lnTo>
                    <a:lnTo>
                      <a:pt x="839" y="903"/>
                    </a:lnTo>
                    <a:lnTo>
                      <a:pt x="842" y="903"/>
                    </a:lnTo>
                    <a:lnTo>
                      <a:pt x="846" y="903"/>
                    </a:lnTo>
                    <a:lnTo>
                      <a:pt x="849" y="903"/>
                    </a:lnTo>
                    <a:lnTo>
                      <a:pt x="853" y="903"/>
                    </a:lnTo>
                    <a:lnTo>
                      <a:pt x="856" y="903"/>
                    </a:lnTo>
                    <a:lnTo>
                      <a:pt x="860" y="903"/>
                    </a:lnTo>
                    <a:lnTo>
                      <a:pt x="864" y="903"/>
                    </a:lnTo>
                    <a:lnTo>
                      <a:pt x="867" y="903"/>
                    </a:lnTo>
                    <a:lnTo>
                      <a:pt x="871" y="903"/>
                    </a:lnTo>
                    <a:lnTo>
                      <a:pt x="874" y="903"/>
                    </a:lnTo>
                    <a:lnTo>
                      <a:pt x="878" y="903"/>
                    </a:lnTo>
                    <a:lnTo>
                      <a:pt x="881" y="903"/>
                    </a:lnTo>
                    <a:lnTo>
                      <a:pt x="885" y="903"/>
                    </a:lnTo>
                    <a:lnTo>
                      <a:pt x="888" y="903"/>
                    </a:lnTo>
                    <a:lnTo>
                      <a:pt x="892" y="903"/>
                    </a:lnTo>
                    <a:lnTo>
                      <a:pt x="895" y="903"/>
                    </a:lnTo>
                    <a:lnTo>
                      <a:pt x="899" y="903"/>
                    </a:lnTo>
                    <a:lnTo>
                      <a:pt x="903" y="903"/>
                    </a:lnTo>
                  </a:path>
                </a:pathLst>
              </a:custGeom>
              <a:noFill/>
              <a:ln w="648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grpSp>
            <p:nvGrpSpPr>
              <p:cNvPr id="455" name=""/>
              <p:cNvGrpSpPr/>
              <p:nvPr/>
            </p:nvGrpSpPr>
            <p:grpSpPr>
              <a:xfrm>
                <a:off x="1542960" y="1133280"/>
                <a:ext cx="528120" cy="249480"/>
                <a:chOff x="1542960" y="1133280"/>
                <a:chExt cx="528120" cy="249480"/>
              </a:xfrm>
            </p:grpSpPr>
            <p:grpSp>
              <p:nvGrpSpPr>
                <p:cNvPr id="456" name=""/>
                <p:cNvGrpSpPr/>
                <p:nvPr/>
              </p:nvGrpSpPr>
              <p:grpSpPr>
                <a:xfrm>
                  <a:off x="1542960" y="1314360"/>
                  <a:ext cx="323640" cy="68400"/>
                  <a:chOff x="1542960" y="1314360"/>
                  <a:chExt cx="323640" cy="68400"/>
                </a:xfrm>
              </p:grpSpPr>
              <p:sp>
                <p:nvSpPr>
                  <p:cNvPr id="457" name=""/>
                  <p:cNvSpPr/>
                  <p:nvPr/>
                </p:nvSpPr>
                <p:spPr>
                  <a:xfrm>
                    <a:off x="1542960" y="1314360"/>
                    <a:ext cx="1440" cy="6840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21600" bIns="2160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458" name=""/>
                  <p:cNvSpPr/>
                  <p:nvPr/>
                </p:nvSpPr>
                <p:spPr>
                  <a:xfrm>
                    <a:off x="1865160" y="1314360"/>
                    <a:ext cx="1440" cy="6840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21600" bIns="2160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459" name=""/>
                  <p:cNvSpPr/>
                  <p:nvPr/>
                </p:nvSpPr>
                <p:spPr>
                  <a:xfrm>
                    <a:off x="1542960" y="1343160"/>
                    <a:ext cx="315720" cy="1440"/>
                  </a:xfrm>
                  <a:prstGeom prst="line">
                    <a:avLst/>
                  </a:prstGeom>
                  <a:ln w="111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5360" bIns="-4536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</p:grpSp>
            <p:sp>
              <p:nvSpPr>
                <p:cNvPr id="460" name=""/>
                <p:cNvSpPr/>
                <p:nvPr/>
              </p:nvSpPr>
              <p:spPr>
                <a:xfrm>
                  <a:off x="1790640" y="1133280"/>
                  <a:ext cx="271440" cy="163800"/>
                </a:xfrm>
                <a:custGeom>
                  <a:avLst/>
                  <a:gdLst/>
                  <a:ahLst/>
                  <a:rect l="l" t="t" r="r" b="b"/>
                  <a:pathLst>
                    <a:path w="171" h="103">
                      <a:moveTo>
                        <a:pt x="0" y="4"/>
                      </a:moveTo>
                      <a:lnTo>
                        <a:pt x="0" y="103"/>
                      </a:lnTo>
                      <a:lnTo>
                        <a:pt x="0" y="103"/>
                      </a:lnTo>
                      <a:lnTo>
                        <a:pt x="171" y="103"/>
                      </a:lnTo>
                      <a:lnTo>
                        <a:pt x="171" y="0"/>
                      </a:lnTo>
                      <a:lnTo>
                        <a:pt x="171" y="0"/>
                      </a:lnTo>
                      <a:lnTo>
                        <a:pt x="0" y="0"/>
                      </a:lnTo>
                      <a:lnTo>
                        <a:pt x="0" y="4"/>
                      </a:lnTo>
                      <a:close/>
                    </a:path>
                  </a:pathLst>
                </a:custGeom>
                <a:solidFill>
                  <a:srgbClr val="ffffff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61" name=""/>
                <p:cNvSpPr/>
                <p:nvPr/>
              </p:nvSpPr>
              <p:spPr>
                <a:xfrm>
                  <a:off x="1797480" y="1141200"/>
                  <a:ext cx="273600" cy="16776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1100" spc="-1" strike="noStrike">
                      <a:solidFill>
                        <a:srgbClr val="000000"/>
                      </a:solidFill>
                      <a:latin typeface="Arial"/>
                    </a:rPr>
                    <a:t>65.3</a:t>
                  </a:r>
                  <a:endParaRPr b="0" lang="en-US" sz="11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</p:grpSp>
      </p:grpSp>
      <p:grpSp>
        <p:nvGrpSpPr>
          <p:cNvPr id="462" name=""/>
          <p:cNvGrpSpPr/>
          <p:nvPr/>
        </p:nvGrpSpPr>
        <p:grpSpPr>
          <a:xfrm>
            <a:off x="2633760" y="2543040"/>
            <a:ext cx="1796760" cy="1818720"/>
            <a:chOff x="2633760" y="2543040"/>
            <a:chExt cx="1796760" cy="1818720"/>
          </a:xfrm>
        </p:grpSpPr>
        <p:grpSp>
          <p:nvGrpSpPr>
            <p:cNvPr id="463" name=""/>
            <p:cNvGrpSpPr/>
            <p:nvPr/>
          </p:nvGrpSpPr>
          <p:grpSpPr>
            <a:xfrm>
              <a:off x="2633760" y="2543040"/>
              <a:ext cx="1796760" cy="1818720"/>
              <a:chOff x="2633760" y="2543040"/>
              <a:chExt cx="1796760" cy="1818720"/>
            </a:xfrm>
          </p:grpSpPr>
          <p:sp>
            <p:nvSpPr>
              <p:cNvPr id="464" name=""/>
              <p:cNvSpPr/>
              <p:nvPr/>
            </p:nvSpPr>
            <p:spPr>
              <a:xfrm>
                <a:off x="2925720" y="2619000"/>
                <a:ext cx="1431000" cy="1451160"/>
              </a:xfrm>
              <a:prstGeom prst="rect">
                <a:avLst/>
              </a:prstGeom>
              <a:solidFill>
                <a:srgbClr val="ffffff"/>
              </a:solidFill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grpSp>
            <p:nvGrpSpPr>
              <p:cNvPr id="465" name=""/>
              <p:cNvGrpSpPr/>
              <p:nvPr/>
            </p:nvGrpSpPr>
            <p:grpSpPr>
              <a:xfrm>
                <a:off x="2856600" y="4064400"/>
                <a:ext cx="1573920" cy="297360"/>
                <a:chOff x="2856600" y="4064400"/>
                <a:chExt cx="1573920" cy="297360"/>
              </a:xfrm>
            </p:grpSpPr>
            <p:sp>
              <p:nvSpPr>
                <p:cNvPr id="466" name=""/>
                <p:cNvSpPr/>
                <p:nvPr/>
              </p:nvSpPr>
              <p:spPr>
                <a:xfrm>
                  <a:off x="2925720" y="4064400"/>
                  <a:ext cx="1426320" cy="1440"/>
                </a:xfrm>
                <a:prstGeom prst="line">
                  <a:avLst/>
                </a:prstGeom>
                <a:ln w="64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grpSp>
              <p:nvGrpSpPr>
                <p:cNvPr id="467" name=""/>
                <p:cNvGrpSpPr/>
                <p:nvPr/>
              </p:nvGrpSpPr>
              <p:grpSpPr>
                <a:xfrm>
                  <a:off x="2925720" y="4070160"/>
                  <a:ext cx="1427400" cy="32400"/>
                  <a:chOff x="2925720" y="4070160"/>
                  <a:chExt cx="1427400" cy="32400"/>
                </a:xfrm>
              </p:grpSpPr>
              <p:sp>
                <p:nvSpPr>
                  <p:cNvPr id="468" name=""/>
                  <p:cNvSpPr/>
                  <p:nvPr/>
                </p:nvSpPr>
                <p:spPr>
                  <a:xfrm>
                    <a:off x="2925720" y="4070160"/>
                    <a:ext cx="1440" cy="3240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14400" bIns="-1440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469" name=""/>
                  <p:cNvSpPr/>
                  <p:nvPr/>
                </p:nvSpPr>
                <p:spPr>
                  <a:xfrm>
                    <a:off x="3031560" y="4070160"/>
                    <a:ext cx="1080" cy="1008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6720" bIns="-3672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470" name=""/>
                  <p:cNvSpPr/>
                  <p:nvPr/>
                </p:nvSpPr>
                <p:spPr>
                  <a:xfrm>
                    <a:off x="3091320" y="4070160"/>
                    <a:ext cx="1440" cy="1008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6720" bIns="-3672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471" name=""/>
                  <p:cNvSpPr/>
                  <p:nvPr/>
                </p:nvSpPr>
                <p:spPr>
                  <a:xfrm>
                    <a:off x="3135600" y="4070160"/>
                    <a:ext cx="1080" cy="1008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6720" bIns="-3672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472" name=""/>
                  <p:cNvSpPr/>
                  <p:nvPr/>
                </p:nvSpPr>
                <p:spPr>
                  <a:xfrm>
                    <a:off x="3175560" y="4070160"/>
                    <a:ext cx="1080" cy="2196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24840" bIns="-2484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473" name=""/>
                  <p:cNvSpPr/>
                  <p:nvPr/>
                </p:nvSpPr>
                <p:spPr>
                  <a:xfrm>
                    <a:off x="3201840" y="4070160"/>
                    <a:ext cx="1440" cy="1008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6720" bIns="-3672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474" name=""/>
                  <p:cNvSpPr/>
                  <p:nvPr/>
                </p:nvSpPr>
                <p:spPr>
                  <a:xfrm>
                    <a:off x="3223800" y="4070160"/>
                    <a:ext cx="1440" cy="1008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6720" bIns="-3672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475" name=""/>
                  <p:cNvSpPr/>
                  <p:nvPr/>
                </p:nvSpPr>
                <p:spPr>
                  <a:xfrm>
                    <a:off x="3245760" y="4070160"/>
                    <a:ext cx="1440" cy="1008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6720" bIns="-3672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476" name=""/>
                  <p:cNvSpPr/>
                  <p:nvPr/>
                </p:nvSpPr>
                <p:spPr>
                  <a:xfrm>
                    <a:off x="3263400" y="4070160"/>
                    <a:ext cx="1440" cy="1008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6720" bIns="-3672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477" name=""/>
                  <p:cNvSpPr/>
                  <p:nvPr/>
                </p:nvSpPr>
                <p:spPr>
                  <a:xfrm>
                    <a:off x="3279600" y="4070160"/>
                    <a:ext cx="1080" cy="3240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14400" bIns="-1440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478" name=""/>
                  <p:cNvSpPr/>
                  <p:nvPr/>
                </p:nvSpPr>
                <p:spPr>
                  <a:xfrm>
                    <a:off x="3389760" y="4070160"/>
                    <a:ext cx="1080" cy="1008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6720" bIns="-3672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479" name=""/>
                  <p:cNvSpPr/>
                  <p:nvPr/>
                </p:nvSpPr>
                <p:spPr>
                  <a:xfrm>
                    <a:off x="3451680" y="4070160"/>
                    <a:ext cx="1080" cy="1008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6720" bIns="-3672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480" name=""/>
                  <p:cNvSpPr/>
                  <p:nvPr/>
                </p:nvSpPr>
                <p:spPr>
                  <a:xfrm>
                    <a:off x="3495600" y="4070160"/>
                    <a:ext cx="1080" cy="1008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6720" bIns="-3672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481" name=""/>
                  <p:cNvSpPr/>
                  <p:nvPr/>
                </p:nvSpPr>
                <p:spPr>
                  <a:xfrm>
                    <a:off x="3528000" y="4070160"/>
                    <a:ext cx="1440" cy="2196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24840" bIns="-2484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482" name=""/>
                  <p:cNvSpPr/>
                  <p:nvPr/>
                </p:nvSpPr>
                <p:spPr>
                  <a:xfrm>
                    <a:off x="3561840" y="4070160"/>
                    <a:ext cx="1080" cy="1008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6720" bIns="-3672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483" name=""/>
                  <p:cNvSpPr/>
                  <p:nvPr/>
                </p:nvSpPr>
                <p:spPr>
                  <a:xfrm>
                    <a:off x="3583800" y="4070160"/>
                    <a:ext cx="1080" cy="1008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6720" bIns="-3672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484" name=""/>
                  <p:cNvSpPr/>
                  <p:nvPr/>
                </p:nvSpPr>
                <p:spPr>
                  <a:xfrm>
                    <a:off x="3605760" y="4070160"/>
                    <a:ext cx="1080" cy="1008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6720" bIns="-3672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485" name=""/>
                  <p:cNvSpPr/>
                  <p:nvPr/>
                </p:nvSpPr>
                <p:spPr>
                  <a:xfrm>
                    <a:off x="3621600" y="4070160"/>
                    <a:ext cx="1440" cy="1008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6720" bIns="-3672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486" name=""/>
                  <p:cNvSpPr/>
                  <p:nvPr/>
                </p:nvSpPr>
                <p:spPr>
                  <a:xfrm>
                    <a:off x="3638160" y="4070160"/>
                    <a:ext cx="1080" cy="3240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14400" bIns="-1440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487" name=""/>
                  <p:cNvSpPr/>
                  <p:nvPr/>
                </p:nvSpPr>
                <p:spPr>
                  <a:xfrm>
                    <a:off x="3743640" y="4070160"/>
                    <a:ext cx="1440" cy="1008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6720" bIns="-3672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488" name=""/>
                  <p:cNvSpPr/>
                  <p:nvPr/>
                </p:nvSpPr>
                <p:spPr>
                  <a:xfrm>
                    <a:off x="3809880" y="4070160"/>
                    <a:ext cx="1080" cy="1008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6720" bIns="-3672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489" name=""/>
                  <p:cNvSpPr/>
                  <p:nvPr/>
                </p:nvSpPr>
                <p:spPr>
                  <a:xfrm>
                    <a:off x="3853800" y="4070160"/>
                    <a:ext cx="1080" cy="1008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6720" bIns="-3672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490" name=""/>
                  <p:cNvSpPr/>
                  <p:nvPr/>
                </p:nvSpPr>
                <p:spPr>
                  <a:xfrm>
                    <a:off x="3887640" y="4070160"/>
                    <a:ext cx="1440" cy="2196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24840" bIns="-2484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491" name=""/>
                  <p:cNvSpPr/>
                  <p:nvPr/>
                </p:nvSpPr>
                <p:spPr>
                  <a:xfrm>
                    <a:off x="3915720" y="4070160"/>
                    <a:ext cx="1440" cy="1008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6720" bIns="-3672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492" name=""/>
                  <p:cNvSpPr/>
                  <p:nvPr/>
                </p:nvSpPr>
                <p:spPr>
                  <a:xfrm>
                    <a:off x="3942360" y="4070160"/>
                    <a:ext cx="1080" cy="1008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6720" bIns="-3672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493" name=""/>
                  <p:cNvSpPr/>
                  <p:nvPr/>
                </p:nvSpPr>
                <p:spPr>
                  <a:xfrm>
                    <a:off x="3960000" y="4070160"/>
                    <a:ext cx="1080" cy="1008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6720" bIns="-3672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494" name=""/>
                  <p:cNvSpPr/>
                  <p:nvPr/>
                </p:nvSpPr>
                <p:spPr>
                  <a:xfrm>
                    <a:off x="3981960" y="4070160"/>
                    <a:ext cx="1080" cy="1008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6720" bIns="-3672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495" name=""/>
                  <p:cNvSpPr/>
                  <p:nvPr/>
                </p:nvSpPr>
                <p:spPr>
                  <a:xfrm>
                    <a:off x="3997800" y="4070160"/>
                    <a:ext cx="1440" cy="3240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14400" bIns="-1440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496" name=""/>
                  <p:cNvSpPr/>
                  <p:nvPr/>
                </p:nvSpPr>
                <p:spPr>
                  <a:xfrm>
                    <a:off x="4102200" y="4070160"/>
                    <a:ext cx="1440" cy="1008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6720" bIns="-3672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497" name=""/>
                  <p:cNvSpPr/>
                  <p:nvPr/>
                </p:nvSpPr>
                <p:spPr>
                  <a:xfrm>
                    <a:off x="4168440" y="4070160"/>
                    <a:ext cx="1080" cy="1008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6720" bIns="-3672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498" name=""/>
                  <p:cNvSpPr/>
                  <p:nvPr/>
                </p:nvSpPr>
                <p:spPr>
                  <a:xfrm>
                    <a:off x="4213800" y="4070160"/>
                    <a:ext cx="1440" cy="1008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6720" bIns="-3672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499" name=""/>
                  <p:cNvSpPr/>
                  <p:nvPr/>
                </p:nvSpPr>
                <p:spPr>
                  <a:xfrm>
                    <a:off x="4246200" y="4070160"/>
                    <a:ext cx="1440" cy="2196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24840" bIns="-2484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500" name=""/>
                  <p:cNvSpPr/>
                  <p:nvPr/>
                </p:nvSpPr>
                <p:spPr>
                  <a:xfrm>
                    <a:off x="4273920" y="4070160"/>
                    <a:ext cx="1440" cy="1008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6720" bIns="-3672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501" name=""/>
                  <p:cNvSpPr/>
                  <p:nvPr/>
                </p:nvSpPr>
                <p:spPr>
                  <a:xfrm>
                    <a:off x="4295880" y="4070160"/>
                    <a:ext cx="1440" cy="1008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6720" bIns="-3672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502" name=""/>
                  <p:cNvSpPr/>
                  <p:nvPr/>
                </p:nvSpPr>
                <p:spPr>
                  <a:xfrm>
                    <a:off x="4318200" y="4070160"/>
                    <a:ext cx="1080" cy="1008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6720" bIns="-3672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503" name=""/>
                  <p:cNvSpPr/>
                  <p:nvPr/>
                </p:nvSpPr>
                <p:spPr>
                  <a:xfrm>
                    <a:off x="4334400" y="4070160"/>
                    <a:ext cx="1080" cy="1008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6720" bIns="-3672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504" name=""/>
                  <p:cNvSpPr/>
                  <p:nvPr/>
                </p:nvSpPr>
                <p:spPr>
                  <a:xfrm>
                    <a:off x="4352040" y="4070160"/>
                    <a:ext cx="1080" cy="3240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14400" bIns="-1440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</p:grpSp>
            <p:grpSp>
              <p:nvGrpSpPr>
                <p:cNvPr id="505" name=""/>
                <p:cNvGrpSpPr/>
                <p:nvPr/>
              </p:nvGrpSpPr>
              <p:grpSpPr>
                <a:xfrm>
                  <a:off x="2856600" y="4110480"/>
                  <a:ext cx="1573920" cy="160560"/>
                  <a:chOff x="2856600" y="4110480"/>
                  <a:chExt cx="1573920" cy="160560"/>
                </a:xfrm>
              </p:grpSpPr>
              <p:sp>
                <p:nvSpPr>
                  <p:cNvPr id="506" name=""/>
                  <p:cNvSpPr/>
                  <p:nvPr/>
                </p:nvSpPr>
                <p:spPr>
                  <a:xfrm>
                    <a:off x="2856600" y="4149000"/>
                    <a:ext cx="113400" cy="12204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1" lang="en-US" sz="800" spc="-1" strike="noStrike">
                        <a:solidFill>
                          <a:srgbClr val="000000"/>
                        </a:solidFill>
                        <a:latin typeface="Arial"/>
                      </a:rPr>
                      <a:t>10</a:t>
                    </a:r>
                    <a:endParaRPr b="0" lang="en-US" sz="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507" name=""/>
                  <p:cNvSpPr/>
                  <p:nvPr/>
                </p:nvSpPr>
                <p:spPr>
                  <a:xfrm>
                    <a:off x="2956680" y="4110480"/>
                    <a:ext cx="49320" cy="10692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1" lang="en-US" sz="700" spc="-1" strike="noStrike">
                        <a:solidFill>
                          <a:srgbClr val="000000"/>
                        </a:solidFill>
                        <a:latin typeface="Arial"/>
                      </a:rPr>
                      <a:t>0</a:t>
                    </a:r>
                    <a:endParaRPr b="0" lang="en-US" sz="7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508" name=""/>
                  <p:cNvSpPr/>
                  <p:nvPr/>
                </p:nvSpPr>
                <p:spPr>
                  <a:xfrm>
                    <a:off x="3210480" y="4149000"/>
                    <a:ext cx="113400" cy="12204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1" lang="en-US" sz="800" spc="-1" strike="noStrike">
                        <a:solidFill>
                          <a:srgbClr val="000000"/>
                        </a:solidFill>
                        <a:latin typeface="Arial"/>
                      </a:rPr>
                      <a:t>10</a:t>
                    </a:r>
                    <a:endParaRPr b="0" lang="en-US" sz="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509" name=""/>
                  <p:cNvSpPr/>
                  <p:nvPr/>
                </p:nvSpPr>
                <p:spPr>
                  <a:xfrm>
                    <a:off x="3309120" y="4110480"/>
                    <a:ext cx="49320" cy="10692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1" lang="en-US" sz="700" spc="-1" strike="noStrike">
                        <a:solidFill>
                          <a:srgbClr val="000000"/>
                        </a:solidFill>
                        <a:latin typeface="Arial"/>
                      </a:rPr>
                      <a:t>1</a:t>
                    </a:r>
                    <a:endParaRPr b="0" lang="en-US" sz="7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510" name=""/>
                  <p:cNvSpPr/>
                  <p:nvPr/>
                </p:nvSpPr>
                <p:spPr>
                  <a:xfrm>
                    <a:off x="3569040" y="4149000"/>
                    <a:ext cx="113400" cy="12204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1" lang="en-US" sz="800" spc="-1" strike="noStrike">
                        <a:solidFill>
                          <a:srgbClr val="000000"/>
                        </a:solidFill>
                        <a:latin typeface="Arial"/>
                      </a:rPr>
                      <a:t>10</a:t>
                    </a:r>
                    <a:endParaRPr b="0" lang="en-US" sz="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511" name=""/>
                  <p:cNvSpPr/>
                  <p:nvPr/>
                </p:nvSpPr>
                <p:spPr>
                  <a:xfrm>
                    <a:off x="3669120" y="4110480"/>
                    <a:ext cx="49320" cy="10692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1" lang="en-US" sz="700" spc="-1" strike="noStrike">
                        <a:solidFill>
                          <a:srgbClr val="000000"/>
                        </a:solidFill>
                        <a:latin typeface="Arial"/>
                      </a:rPr>
                      <a:t>2</a:t>
                    </a:r>
                    <a:endParaRPr b="0" lang="en-US" sz="7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512" name=""/>
                  <p:cNvSpPr/>
                  <p:nvPr/>
                </p:nvSpPr>
                <p:spPr>
                  <a:xfrm>
                    <a:off x="3928680" y="4149000"/>
                    <a:ext cx="113400" cy="12204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1" lang="en-US" sz="800" spc="-1" strike="noStrike">
                        <a:solidFill>
                          <a:srgbClr val="000000"/>
                        </a:solidFill>
                        <a:latin typeface="Arial"/>
                      </a:rPr>
                      <a:t>10</a:t>
                    </a:r>
                    <a:endParaRPr b="0" lang="en-US" sz="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513" name=""/>
                  <p:cNvSpPr/>
                  <p:nvPr/>
                </p:nvSpPr>
                <p:spPr>
                  <a:xfrm>
                    <a:off x="4027320" y="4110480"/>
                    <a:ext cx="49320" cy="10692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1" lang="en-US" sz="700" spc="-1" strike="noStrike">
                        <a:solidFill>
                          <a:srgbClr val="000000"/>
                        </a:solidFill>
                        <a:latin typeface="Arial"/>
                      </a:rPr>
                      <a:t>3</a:t>
                    </a:r>
                    <a:endParaRPr b="0" lang="en-US" sz="7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514" name=""/>
                  <p:cNvSpPr/>
                  <p:nvPr/>
                </p:nvSpPr>
                <p:spPr>
                  <a:xfrm>
                    <a:off x="4282560" y="4147560"/>
                    <a:ext cx="113400" cy="12204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1" lang="en-US" sz="800" spc="-1" strike="noStrike">
                        <a:solidFill>
                          <a:srgbClr val="000000"/>
                        </a:solidFill>
                        <a:latin typeface="Arial"/>
                      </a:rPr>
                      <a:t>10</a:t>
                    </a:r>
                    <a:endParaRPr b="0" lang="en-US" sz="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515" name=""/>
                  <p:cNvSpPr/>
                  <p:nvPr/>
                </p:nvSpPr>
                <p:spPr>
                  <a:xfrm>
                    <a:off x="4381200" y="4110480"/>
                    <a:ext cx="49320" cy="10692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1" lang="en-US" sz="700" spc="-1" strike="noStrike">
                        <a:solidFill>
                          <a:srgbClr val="000000"/>
                        </a:solidFill>
                        <a:latin typeface="Arial"/>
                      </a:rPr>
                      <a:t>4</a:t>
                    </a:r>
                    <a:endParaRPr b="0" lang="en-US" sz="7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</p:grpSp>
            <p:sp>
              <p:nvSpPr>
                <p:cNvPr id="516" name=""/>
                <p:cNvSpPr/>
                <p:nvPr/>
              </p:nvSpPr>
              <p:spPr>
                <a:xfrm>
                  <a:off x="3525120" y="4239720"/>
                  <a:ext cx="259920" cy="1220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800" spc="-1" strike="noStrike">
                      <a:solidFill>
                        <a:srgbClr val="000000"/>
                      </a:solidFill>
                      <a:latin typeface="Arial"/>
                    </a:rPr>
                    <a:t>CD69</a:t>
                  </a:r>
                  <a:endParaRPr b="0" lang="en-US" sz="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grpSp>
            <p:nvGrpSpPr>
              <p:cNvPr id="517" name=""/>
              <p:cNvGrpSpPr/>
              <p:nvPr/>
            </p:nvGrpSpPr>
            <p:grpSpPr>
              <a:xfrm>
                <a:off x="2633760" y="2543040"/>
                <a:ext cx="293400" cy="1605960"/>
                <a:chOff x="2633760" y="2543040"/>
                <a:chExt cx="293400" cy="1605960"/>
              </a:xfrm>
            </p:grpSpPr>
            <p:sp>
              <p:nvSpPr>
                <p:cNvPr id="518" name=""/>
                <p:cNvSpPr/>
                <p:nvPr/>
              </p:nvSpPr>
              <p:spPr>
                <a:xfrm flipV="1">
                  <a:off x="2925720" y="2619000"/>
                  <a:ext cx="1440" cy="1445040"/>
                </a:xfrm>
                <a:prstGeom prst="line">
                  <a:avLst/>
                </a:prstGeom>
                <a:ln w="64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grpSp>
              <p:nvGrpSpPr>
                <p:cNvPr id="519" name=""/>
                <p:cNvGrpSpPr/>
                <p:nvPr/>
              </p:nvGrpSpPr>
              <p:grpSpPr>
                <a:xfrm>
                  <a:off x="2892960" y="2619000"/>
                  <a:ext cx="32040" cy="1446480"/>
                  <a:chOff x="2892960" y="2619000"/>
                  <a:chExt cx="32040" cy="1446480"/>
                </a:xfrm>
              </p:grpSpPr>
              <p:sp>
                <p:nvSpPr>
                  <p:cNvPr id="520" name=""/>
                  <p:cNvSpPr/>
                  <p:nvPr/>
                </p:nvSpPr>
                <p:spPr>
                  <a:xfrm flipH="1">
                    <a:off x="2892960" y="4064040"/>
                    <a:ext cx="32040" cy="144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5360" bIns="-4536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521" name=""/>
                  <p:cNvSpPr/>
                  <p:nvPr/>
                </p:nvSpPr>
                <p:spPr>
                  <a:xfrm flipH="1">
                    <a:off x="2914920" y="3958200"/>
                    <a:ext cx="10080" cy="108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5720" bIns="-4572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522" name=""/>
                  <p:cNvSpPr/>
                  <p:nvPr/>
                </p:nvSpPr>
                <p:spPr>
                  <a:xfrm flipH="1">
                    <a:off x="2914920" y="3895560"/>
                    <a:ext cx="10080" cy="108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5720" bIns="-4572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523" name=""/>
                  <p:cNvSpPr/>
                  <p:nvPr/>
                </p:nvSpPr>
                <p:spPr>
                  <a:xfrm flipH="1">
                    <a:off x="2914920" y="3851280"/>
                    <a:ext cx="10080" cy="108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5720" bIns="-4572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524" name=""/>
                  <p:cNvSpPr/>
                  <p:nvPr/>
                </p:nvSpPr>
                <p:spPr>
                  <a:xfrm flipH="1">
                    <a:off x="2903400" y="3812400"/>
                    <a:ext cx="21600" cy="108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5720" bIns="-4572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525" name=""/>
                  <p:cNvSpPr/>
                  <p:nvPr/>
                </p:nvSpPr>
                <p:spPr>
                  <a:xfrm flipH="1">
                    <a:off x="2914920" y="3783960"/>
                    <a:ext cx="10080" cy="144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5360" bIns="-4536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526" name=""/>
                  <p:cNvSpPr/>
                  <p:nvPr/>
                </p:nvSpPr>
                <p:spPr>
                  <a:xfrm flipH="1">
                    <a:off x="2914920" y="3761640"/>
                    <a:ext cx="10080" cy="108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5720" bIns="-4572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527" name=""/>
                  <p:cNvSpPr/>
                  <p:nvPr/>
                </p:nvSpPr>
                <p:spPr>
                  <a:xfrm flipH="1">
                    <a:off x="2914920" y="3739320"/>
                    <a:ext cx="10080" cy="108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5720" bIns="-4572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528" name=""/>
                  <p:cNvSpPr/>
                  <p:nvPr/>
                </p:nvSpPr>
                <p:spPr>
                  <a:xfrm flipH="1">
                    <a:off x="2914920" y="3722760"/>
                    <a:ext cx="10080" cy="144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5360" bIns="-4536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529" name=""/>
                  <p:cNvSpPr/>
                  <p:nvPr/>
                </p:nvSpPr>
                <p:spPr>
                  <a:xfrm flipH="1">
                    <a:off x="2892960" y="3706560"/>
                    <a:ext cx="32040" cy="108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5720" bIns="-4572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530" name=""/>
                  <p:cNvSpPr/>
                  <p:nvPr/>
                </p:nvSpPr>
                <p:spPr>
                  <a:xfrm flipH="1">
                    <a:off x="2914920" y="3593160"/>
                    <a:ext cx="10080" cy="108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5720" bIns="-4572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531" name=""/>
                  <p:cNvSpPr/>
                  <p:nvPr/>
                </p:nvSpPr>
                <p:spPr>
                  <a:xfrm flipH="1">
                    <a:off x="2914920" y="3532320"/>
                    <a:ext cx="10080" cy="108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5720" bIns="-4572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532" name=""/>
                  <p:cNvSpPr/>
                  <p:nvPr/>
                </p:nvSpPr>
                <p:spPr>
                  <a:xfrm flipH="1">
                    <a:off x="2914920" y="3487680"/>
                    <a:ext cx="10080" cy="108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5720" bIns="-4572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533" name=""/>
                  <p:cNvSpPr/>
                  <p:nvPr/>
                </p:nvSpPr>
                <p:spPr>
                  <a:xfrm flipH="1">
                    <a:off x="2903400" y="3453120"/>
                    <a:ext cx="21600" cy="144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5360" bIns="-4536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534" name=""/>
                  <p:cNvSpPr/>
                  <p:nvPr/>
                </p:nvSpPr>
                <p:spPr>
                  <a:xfrm flipH="1">
                    <a:off x="2914920" y="3420360"/>
                    <a:ext cx="10080" cy="144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5360" bIns="-4536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535" name=""/>
                  <p:cNvSpPr/>
                  <p:nvPr/>
                </p:nvSpPr>
                <p:spPr>
                  <a:xfrm flipH="1">
                    <a:off x="2914920" y="3398040"/>
                    <a:ext cx="10080" cy="108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5720" bIns="-4572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536" name=""/>
                  <p:cNvSpPr/>
                  <p:nvPr/>
                </p:nvSpPr>
                <p:spPr>
                  <a:xfrm flipH="1">
                    <a:off x="2914920" y="3375720"/>
                    <a:ext cx="10080" cy="108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5720" bIns="-4572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537" name=""/>
                  <p:cNvSpPr/>
                  <p:nvPr/>
                </p:nvSpPr>
                <p:spPr>
                  <a:xfrm flipH="1">
                    <a:off x="2914920" y="3359160"/>
                    <a:ext cx="10080" cy="144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5360" bIns="-4536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538" name=""/>
                  <p:cNvSpPr/>
                  <p:nvPr/>
                </p:nvSpPr>
                <p:spPr>
                  <a:xfrm flipH="1">
                    <a:off x="2892960" y="3341160"/>
                    <a:ext cx="32040" cy="144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5360" bIns="-4536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539" name=""/>
                  <p:cNvSpPr/>
                  <p:nvPr/>
                </p:nvSpPr>
                <p:spPr>
                  <a:xfrm flipH="1">
                    <a:off x="2914920" y="3235320"/>
                    <a:ext cx="10080" cy="144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5360" bIns="-4536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540" name=""/>
                  <p:cNvSpPr/>
                  <p:nvPr/>
                </p:nvSpPr>
                <p:spPr>
                  <a:xfrm flipH="1">
                    <a:off x="2914920" y="3168720"/>
                    <a:ext cx="10080" cy="108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5720" bIns="-4572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541" name=""/>
                  <p:cNvSpPr/>
                  <p:nvPr/>
                </p:nvSpPr>
                <p:spPr>
                  <a:xfrm flipH="1">
                    <a:off x="2914920" y="3124080"/>
                    <a:ext cx="10080" cy="108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5720" bIns="-4572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542" name=""/>
                  <p:cNvSpPr/>
                  <p:nvPr/>
                </p:nvSpPr>
                <p:spPr>
                  <a:xfrm flipH="1">
                    <a:off x="2903400" y="3089520"/>
                    <a:ext cx="21600" cy="144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5360" bIns="-4536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543" name=""/>
                  <p:cNvSpPr/>
                  <p:nvPr/>
                </p:nvSpPr>
                <p:spPr>
                  <a:xfrm flipH="1">
                    <a:off x="2914920" y="3061080"/>
                    <a:ext cx="10080" cy="144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5360" bIns="-4536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544" name=""/>
                  <p:cNvSpPr/>
                  <p:nvPr/>
                </p:nvSpPr>
                <p:spPr>
                  <a:xfrm flipH="1">
                    <a:off x="2914920" y="3034440"/>
                    <a:ext cx="10080" cy="108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5720" bIns="-4572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545" name=""/>
                  <p:cNvSpPr/>
                  <p:nvPr/>
                </p:nvSpPr>
                <p:spPr>
                  <a:xfrm flipH="1">
                    <a:off x="2914920" y="3016440"/>
                    <a:ext cx="10080" cy="144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5360" bIns="-4536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546" name=""/>
                  <p:cNvSpPr/>
                  <p:nvPr/>
                </p:nvSpPr>
                <p:spPr>
                  <a:xfrm flipH="1">
                    <a:off x="2914920" y="2994120"/>
                    <a:ext cx="10080" cy="108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5720" bIns="-4572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547" name=""/>
                  <p:cNvSpPr/>
                  <p:nvPr/>
                </p:nvSpPr>
                <p:spPr>
                  <a:xfrm flipH="1">
                    <a:off x="2892960" y="2977560"/>
                    <a:ext cx="32040" cy="144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5360" bIns="-4536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548" name=""/>
                  <p:cNvSpPr/>
                  <p:nvPr/>
                </p:nvSpPr>
                <p:spPr>
                  <a:xfrm flipH="1">
                    <a:off x="2914920" y="2872080"/>
                    <a:ext cx="10080" cy="144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5360" bIns="-4536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549" name=""/>
                  <p:cNvSpPr/>
                  <p:nvPr/>
                </p:nvSpPr>
                <p:spPr>
                  <a:xfrm flipH="1">
                    <a:off x="2914920" y="2803680"/>
                    <a:ext cx="10080" cy="108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5720" bIns="-4572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550" name=""/>
                  <p:cNvSpPr/>
                  <p:nvPr/>
                </p:nvSpPr>
                <p:spPr>
                  <a:xfrm flipH="1">
                    <a:off x="2914920" y="2758680"/>
                    <a:ext cx="10080" cy="144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5360" bIns="-4536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551" name=""/>
                  <p:cNvSpPr/>
                  <p:nvPr/>
                </p:nvSpPr>
                <p:spPr>
                  <a:xfrm flipH="1">
                    <a:off x="2903400" y="2725920"/>
                    <a:ext cx="21600" cy="144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5360" bIns="-4536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552" name=""/>
                  <p:cNvSpPr/>
                  <p:nvPr/>
                </p:nvSpPr>
                <p:spPr>
                  <a:xfrm flipH="1">
                    <a:off x="2914920" y="2697480"/>
                    <a:ext cx="10080" cy="144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5360" bIns="-4536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553" name=""/>
                  <p:cNvSpPr/>
                  <p:nvPr/>
                </p:nvSpPr>
                <p:spPr>
                  <a:xfrm flipH="1">
                    <a:off x="2914920" y="2675160"/>
                    <a:ext cx="10080" cy="144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5360" bIns="-4536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554" name=""/>
                  <p:cNvSpPr/>
                  <p:nvPr/>
                </p:nvSpPr>
                <p:spPr>
                  <a:xfrm flipH="1">
                    <a:off x="2914920" y="2652840"/>
                    <a:ext cx="10080" cy="144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5360" bIns="-4536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555" name=""/>
                  <p:cNvSpPr/>
                  <p:nvPr/>
                </p:nvSpPr>
                <p:spPr>
                  <a:xfrm flipH="1">
                    <a:off x="2914920" y="2636640"/>
                    <a:ext cx="10080" cy="108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5720" bIns="-4572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556" name=""/>
                  <p:cNvSpPr/>
                  <p:nvPr/>
                </p:nvSpPr>
                <p:spPr>
                  <a:xfrm flipH="1">
                    <a:off x="2892960" y="2619000"/>
                    <a:ext cx="32040" cy="108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5720" bIns="-4572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</p:grpSp>
            <p:grpSp>
              <p:nvGrpSpPr>
                <p:cNvPr id="557" name=""/>
                <p:cNvGrpSpPr/>
                <p:nvPr/>
              </p:nvGrpSpPr>
              <p:grpSpPr>
                <a:xfrm>
                  <a:off x="2728800" y="2543040"/>
                  <a:ext cx="148680" cy="1605960"/>
                  <a:chOff x="2728800" y="2543040"/>
                  <a:chExt cx="148680" cy="1605960"/>
                </a:xfrm>
              </p:grpSpPr>
              <p:sp>
                <p:nvSpPr>
                  <p:cNvPr id="558" name=""/>
                  <p:cNvSpPr/>
                  <p:nvPr/>
                </p:nvSpPr>
                <p:spPr>
                  <a:xfrm>
                    <a:off x="2728800" y="4026960"/>
                    <a:ext cx="113400" cy="12204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1" lang="en-US" sz="800" spc="-1" strike="noStrike">
                        <a:solidFill>
                          <a:srgbClr val="000000"/>
                        </a:solidFill>
                        <a:latin typeface="Arial"/>
                      </a:rPr>
                      <a:t>10</a:t>
                    </a:r>
                    <a:endParaRPr b="0" lang="en-US" sz="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559" name=""/>
                  <p:cNvSpPr/>
                  <p:nvPr/>
                </p:nvSpPr>
                <p:spPr>
                  <a:xfrm>
                    <a:off x="2828160" y="3989880"/>
                    <a:ext cx="49320" cy="10692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1" lang="en-US" sz="700" spc="-1" strike="noStrike">
                        <a:solidFill>
                          <a:srgbClr val="000000"/>
                        </a:solidFill>
                        <a:latin typeface="Arial"/>
                      </a:rPr>
                      <a:t>0</a:t>
                    </a:r>
                    <a:endParaRPr b="0" lang="en-US" sz="7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560" name=""/>
                  <p:cNvSpPr/>
                  <p:nvPr/>
                </p:nvSpPr>
                <p:spPr>
                  <a:xfrm>
                    <a:off x="2728800" y="3669480"/>
                    <a:ext cx="113400" cy="12204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1" lang="en-US" sz="800" spc="-1" strike="noStrike">
                        <a:solidFill>
                          <a:srgbClr val="000000"/>
                        </a:solidFill>
                        <a:latin typeface="Arial"/>
                      </a:rPr>
                      <a:t>10</a:t>
                    </a:r>
                    <a:endParaRPr b="0" lang="en-US" sz="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561" name=""/>
                  <p:cNvSpPr/>
                  <p:nvPr/>
                </p:nvSpPr>
                <p:spPr>
                  <a:xfrm>
                    <a:off x="2828160" y="3629160"/>
                    <a:ext cx="49320" cy="10692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1" lang="en-US" sz="700" spc="-1" strike="noStrike">
                        <a:solidFill>
                          <a:srgbClr val="000000"/>
                        </a:solidFill>
                        <a:latin typeface="Arial"/>
                      </a:rPr>
                      <a:t>1</a:t>
                    </a:r>
                    <a:endParaRPr b="0" lang="en-US" sz="7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562" name=""/>
                  <p:cNvSpPr/>
                  <p:nvPr/>
                </p:nvSpPr>
                <p:spPr>
                  <a:xfrm>
                    <a:off x="2728800" y="3305880"/>
                    <a:ext cx="113400" cy="12204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1" lang="en-US" sz="800" spc="-1" strike="noStrike">
                        <a:solidFill>
                          <a:srgbClr val="000000"/>
                        </a:solidFill>
                        <a:latin typeface="Arial"/>
                      </a:rPr>
                      <a:t>10</a:t>
                    </a:r>
                    <a:endParaRPr b="0" lang="en-US" sz="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563" name=""/>
                  <p:cNvSpPr/>
                  <p:nvPr/>
                </p:nvSpPr>
                <p:spPr>
                  <a:xfrm>
                    <a:off x="2828160" y="3265560"/>
                    <a:ext cx="49320" cy="10692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1" lang="en-US" sz="700" spc="-1" strike="noStrike">
                        <a:solidFill>
                          <a:srgbClr val="000000"/>
                        </a:solidFill>
                        <a:latin typeface="Arial"/>
                      </a:rPr>
                      <a:t>2</a:t>
                    </a:r>
                    <a:endParaRPr b="0" lang="en-US" sz="7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564" name=""/>
                  <p:cNvSpPr/>
                  <p:nvPr/>
                </p:nvSpPr>
                <p:spPr>
                  <a:xfrm>
                    <a:off x="2728800" y="2940480"/>
                    <a:ext cx="113400" cy="12204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1" lang="en-US" sz="800" spc="-1" strike="noStrike">
                        <a:solidFill>
                          <a:srgbClr val="000000"/>
                        </a:solidFill>
                        <a:latin typeface="Arial"/>
                      </a:rPr>
                      <a:t>10</a:t>
                    </a:r>
                    <a:endParaRPr b="0" lang="en-US" sz="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565" name=""/>
                  <p:cNvSpPr/>
                  <p:nvPr/>
                </p:nvSpPr>
                <p:spPr>
                  <a:xfrm>
                    <a:off x="2828160" y="2901960"/>
                    <a:ext cx="49320" cy="10692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1" lang="en-US" sz="700" spc="-1" strike="noStrike">
                        <a:solidFill>
                          <a:srgbClr val="000000"/>
                        </a:solidFill>
                        <a:latin typeface="Arial"/>
                      </a:rPr>
                      <a:t>3</a:t>
                    </a:r>
                    <a:endParaRPr b="0" lang="en-US" sz="7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566" name=""/>
                  <p:cNvSpPr/>
                  <p:nvPr/>
                </p:nvSpPr>
                <p:spPr>
                  <a:xfrm>
                    <a:off x="2728800" y="2581200"/>
                    <a:ext cx="113400" cy="12204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1" lang="en-US" sz="800" spc="-1" strike="noStrike">
                        <a:solidFill>
                          <a:srgbClr val="000000"/>
                        </a:solidFill>
                        <a:latin typeface="Arial"/>
                      </a:rPr>
                      <a:t>10</a:t>
                    </a:r>
                    <a:endParaRPr b="0" lang="en-US" sz="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567" name=""/>
                  <p:cNvSpPr/>
                  <p:nvPr/>
                </p:nvSpPr>
                <p:spPr>
                  <a:xfrm>
                    <a:off x="2828160" y="2543040"/>
                    <a:ext cx="49320" cy="10692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1" lang="en-US" sz="700" spc="-1" strike="noStrike">
                        <a:solidFill>
                          <a:srgbClr val="000000"/>
                        </a:solidFill>
                        <a:latin typeface="Arial"/>
                      </a:rPr>
                      <a:t>4</a:t>
                    </a:r>
                    <a:endParaRPr b="0" lang="en-US" sz="7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</p:grpSp>
            <p:sp>
              <p:nvSpPr>
                <p:cNvPr id="568" name=""/>
                <p:cNvSpPr/>
                <p:nvPr/>
              </p:nvSpPr>
              <p:spPr>
                <a:xfrm rot="16200000">
                  <a:off x="2593080" y="3265920"/>
                  <a:ext cx="203400" cy="1220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800" spc="-1" strike="noStrike">
                      <a:solidFill>
                        <a:srgbClr val="000000"/>
                      </a:solidFill>
                      <a:latin typeface="Arial"/>
                    </a:rPr>
                    <a:t>CD4</a:t>
                  </a:r>
                  <a:endParaRPr b="0" lang="en-US" sz="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</p:grpSp>
        <p:grpSp>
          <p:nvGrpSpPr>
            <p:cNvPr id="569" name=""/>
            <p:cNvGrpSpPr/>
            <p:nvPr/>
          </p:nvGrpSpPr>
          <p:grpSpPr>
            <a:xfrm>
              <a:off x="2937600" y="2630880"/>
              <a:ext cx="1409040" cy="1427760"/>
              <a:chOff x="2937600" y="2630880"/>
              <a:chExt cx="1409040" cy="1427760"/>
            </a:xfrm>
          </p:grpSpPr>
          <p:pic>
            <p:nvPicPr>
              <p:cNvPr id="570" name="" descr=""/>
              <p:cNvPicPr/>
              <p:nvPr/>
            </p:nvPicPr>
            <p:blipFill>
              <a:blip r:embed="rId7"/>
              <a:stretch/>
            </p:blipFill>
            <p:spPr>
              <a:xfrm>
                <a:off x="2937600" y="2630880"/>
                <a:ext cx="1409040" cy="1427760"/>
              </a:xfrm>
              <a:prstGeom prst="rect">
                <a:avLst/>
              </a:prstGeom>
              <a:ln w="0">
                <a:noFill/>
              </a:ln>
            </p:spPr>
          </p:pic>
          <p:grpSp>
            <p:nvGrpSpPr>
              <p:cNvPr id="571" name=""/>
              <p:cNvGrpSpPr/>
              <p:nvPr/>
            </p:nvGrpSpPr>
            <p:grpSpPr>
              <a:xfrm>
                <a:off x="3340080" y="2904840"/>
                <a:ext cx="515160" cy="660960"/>
                <a:chOff x="3340080" y="2904840"/>
                <a:chExt cx="515160" cy="660960"/>
              </a:xfrm>
            </p:grpSpPr>
            <p:sp>
              <p:nvSpPr>
                <p:cNvPr id="572" name=""/>
                <p:cNvSpPr/>
                <p:nvPr/>
              </p:nvSpPr>
              <p:spPr>
                <a:xfrm>
                  <a:off x="3340080" y="3083760"/>
                  <a:ext cx="464040" cy="482040"/>
                </a:xfrm>
                <a:prstGeom prst="rect">
                  <a:avLst/>
                </a:prstGeom>
                <a:noFill/>
                <a:ln w="6480">
                  <a:solidFill>
                    <a:srgbClr val="0000ff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73" name=""/>
                <p:cNvSpPr/>
                <p:nvPr/>
              </p:nvSpPr>
              <p:spPr>
                <a:xfrm>
                  <a:off x="3549960" y="2904840"/>
                  <a:ext cx="265680" cy="162360"/>
                </a:xfrm>
                <a:custGeom>
                  <a:avLst/>
                  <a:gdLst/>
                  <a:ahLst/>
                  <a:rect l="l" t="t" r="r" b="b"/>
                  <a:pathLst>
                    <a:path w="181" h="109">
                      <a:moveTo>
                        <a:pt x="0" y="4"/>
                      </a:moveTo>
                      <a:lnTo>
                        <a:pt x="0" y="109"/>
                      </a:lnTo>
                      <a:lnTo>
                        <a:pt x="0" y="109"/>
                      </a:lnTo>
                      <a:lnTo>
                        <a:pt x="181" y="109"/>
                      </a:lnTo>
                      <a:lnTo>
                        <a:pt x="181" y="0"/>
                      </a:lnTo>
                      <a:lnTo>
                        <a:pt x="181" y="0"/>
                      </a:lnTo>
                      <a:lnTo>
                        <a:pt x="0" y="0"/>
                      </a:lnTo>
                      <a:lnTo>
                        <a:pt x="0" y="4"/>
                      </a:lnTo>
                      <a:close/>
                    </a:path>
                  </a:pathLst>
                </a:custGeom>
                <a:solidFill>
                  <a:srgbClr val="ffffff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74" name=""/>
                <p:cNvSpPr/>
                <p:nvPr/>
              </p:nvSpPr>
              <p:spPr>
                <a:xfrm>
                  <a:off x="3555720" y="2912040"/>
                  <a:ext cx="299520" cy="1828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1200" spc="-1" strike="noStrike">
                      <a:solidFill>
                        <a:srgbClr val="000000"/>
                      </a:solidFill>
                      <a:latin typeface="Arial"/>
                    </a:rPr>
                    <a:t>17.3</a:t>
                  </a:r>
                  <a:endParaRPr b="0" lang="en-US" sz="1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</p:grpSp>
      </p:grpSp>
      <p:grpSp>
        <p:nvGrpSpPr>
          <p:cNvPr id="575" name=""/>
          <p:cNvGrpSpPr/>
          <p:nvPr/>
        </p:nvGrpSpPr>
        <p:grpSpPr>
          <a:xfrm>
            <a:off x="4791240" y="541440"/>
            <a:ext cx="1796040" cy="1818360"/>
            <a:chOff x="4791240" y="541440"/>
            <a:chExt cx="1796040" cy="1818360"/>
          </a:xfrm>
        </p:grpSpPr>
        <p:grpSp>
          <p:nvGrpSpPr>
            <p:cNvPr id="576" name=""/>
            <p:cNvGrpSpPr/>
            <p:nvPr/>
          </p:nvGrpSpPr>
          <p:grpSpPr>
            <a:xfrm>
              <a:off x="4791240" y="541440"/>
              <a:ext cx="1796040" cy="1818360"/>
              <a:chOff x="4791240" y="541440"/>
              <a:chExt cx="1796040" cy="1818360"/>
            </a:xfrm>
          </p:grpSpPr>
          <p:sp>
            <p:nvSpPr>
              <p:cNvPr id="577" name=""/>
              <p:cNvSpPr/>
              <p:nvPr/>
            </p:nvSpPr>
            <p:spPr>
              <a:xfrm>
                <a:off x="5083200" y="617400"/>
                <a:ext cx="1430640" cy="1450800"/>
              </a:xfrm>
              <a:prstGeom prst="rect">
                <a:avLst/>
              </a:prstGeom>
              <a:solidFill>
                <a:srgbClr val="ffffff"/>
              </a:solidFill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grpSp>
            <p:nvGrpSpPr>
              <p:cNvPr id="578" name=""/>
              <p:cNvGrpSpPr/>
              <p:nvPr/>
            </p:nvGrpSpPr>
            <p:grpSpPr>
              <a:xfrm>
                <a:off x="5014440" y="2062440"/>
                <a:ext cx="1572840" cy="297360"/>
                <a:chOff x="5014440" y="2062440"/>
                <a:chExt cx="1572840" cy="297360"/>
              </a:xfrm>
            </p:grpSpPr>
            <p:sp>
              <p:nvSpPr>
                <p:cNvPr id="579" name=""/>
                <p:cNvSpPr/>
                <p:nvPr/>
              </p:nvSpPr>
              <p:spPr>
                <a:xfrm>
                  <a:off x="5083200" y="2062440"/>
                  <a:ext cx="1426320" cy="1080"/>
                </a:xfrm>
                <a:prstGeom prst="line">
                  <a:avLst/>
                </a:prstGeom>
                <a:ln w="64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720" bIns="-4572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grpSp>
              <p:nvGrpSpPr>
                <p:cNvPr id="580" name=""/>
                <p:cNvGrpSpPr/>
                <p:nvPr/>
              </p:nvGrpSpPr>
              <p:grpSpPr>
                <a:xfrm>
                  <a:off x="5083200" y="2068200"/>
                  <a:ext cx="1427760" cy="32400"/>
                  <a:chOff x="5083200" y="2068200"/>
                  <a:chExt cx="1427760" cy="32400"/>
                </a:xfrm>
              </p:grpSpPr>
              <p:sp>
                <p:nvSpPr>
                  <p:cNvPr id="581" name=""/>
                  <p:cNvSpPr/>
                  <p:nvPr/>
                </p:nvSpPr>
                <p:spPr>
                  <a:xfrm>
                    <a:off x="5083200" y="2068200"/>
                    <a:ext cx="1440" cy="3240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14400" bIns="-1440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582" name=""/>
                  <p:cNvSpPr/>
                  <p:nvPr/>
                </p:nvSpPr>
                <p:spPr>
                  <a:xfrm>
                    <a:off x="5189040" y="2068200"/>
                    <a:ext cx="1080" cy="1008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6720" bIns="-3672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583" name=""/>
                  <p:cNvSpPr/>
                  <p:nvPr/>
                </p:nvSpPr>
                <p:spPr>
                  <a:xfrm>
                    <a:off x="5249160" y="2068200"/>
                    <a:ext cx="1080" cy="1008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6720" bIns="-3672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584" name=""/>
                  <p:cNvSpPr/>
                  <p:nvPr/>
                </p:nvSpPr>
                <p:spPr>
                  <a:xfrm>
                    <a:off x="5293080" y="2068200"/>
                    <a:ext cx="1080" cy="1008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6720" bIns="-3672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585" name=""/>
                  <p:cNvSpPr/>
                  <p:nvPr/>
                </p:nvSpPr>
                <p:spPr>
                  <a:xfrm>
                    <a:off x="5333040" y="2068200"/>
                    <a:ext cx="1080" cy="2196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24840" bIns="-2484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586" name=""/>
                  <p:cNvSpPr/>
                  <p:nvPr/>
                </p:nvSpPr>
                <p:spPr>
                  <a:xfrm>
                    <a:off x="5359320" y="2068200"/>
                    <a:ext cx="1440" cy="1008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6720" bIns="-3672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587" name=""/>
                  <p:cNvSpPr/>
                  <p:nvPr/>
                </p:nvSpPr>
                <p:spPr>
                  <a:xfrm>
                    <a:off x="5382720" y="2068200"/>
                    <a:ext cx="1080" cy="1008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6720" bIns="-3672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588" name=""/>
                  <p:cNvSpPr/>
                  <p:nvPr/>
                </p:nvSpPr>
                <p:spPr>
                  <a:xfrm>
                    <a:off x="5404680" y="2068200"/>
                    <a:ext cx="1440" cy="1008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6720" bIns="-3672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589" name=""/>
                  <p:cNvSpPr/>
                  <p:nvPr/>
                </p:nvSpPr>
                <p:spPr>
                  <a:xfrm>
                    <a:off x="5421240" y="2068200"/>
                    <a:ext cx="1080" cy="1008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6720" bIns="-3672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590" name=""/>
                  <p:cNvSpPr/>
                  <p:nvPr/>
                </p:nvSpPr>
                <p:spPr>
                  <a:xfrm>
                    <a:off x="5437080" y="2068200"/>
                    <a:ext cx="1440" cy="3240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14400" bIns="-1440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591" name=""/>
                  <p:cNvSpPr/>
                  <p:nvPr/>
                </p:nvSpPr>
                <p:spPr>
                  <a:xfrm>
                    <a:off x="5547240" y="2068200"/>
                    <a:ext cx="1080" cy="1008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6720" bIns="-3672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592" name=""/>
                  <p:cNvSpPr/>
                  <p:nvPr/>
                </p:nvSpPr>
                <p:spPr>
                  <a:xfrm>
                    <a:off x="5609160" y="2068200"/>
                    <a:ext cx="1440" cy="1008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6720" bIns="-3672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593" name=""/>
                  <p:cNvSpPr/>
                  <p:nvPr/>
                </p:nvSpPr>
                <p:spPr>
                  <a:xfrm>
                    <a:off x="5653080" y="2068200"/>
                    <a:ext cx="1440" cy="1008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6720" bIns="-3672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594" name=""/>
                  <p:cNvSpPr/>
                  <p:nvPr/>
                </p:nvSpPr>
                <p:spPr>
                  <a:xfrm>
                    <a:off x="5685480" y="2068200"/>
                    <a:ext cx="1440" cy="2196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24840" bIns="-2484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595" name=""/>
                  <p:cNvSpPr/>
                  <p:nvPr/>
                </p:nvSpPr>
                <p:spPr>
                  <a:xfrm>
                    <a:off x="5719320" y="2068200"/>
                    <a:ext cx="1080" cy="1008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6720" bIns="-3672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596" name=""/>
                  <p:cNvSpPr/>
                  <p:nvPr/>
                </p:nvSpPr>
                <p:spPr>
                  <a:xfrm>
                    <a:off x="5741280" y="2068200"/>
                    <a:ext cx="1080" cy="1008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6720" bIns="-3672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597" name=""/>
                  <p:cNvSpPr/>
                  <p:nvPr/>
                </p:nvSpPr>
                <p:spPr>
                  <a:xfrm>
                    <a:off x="5763240" y="2068200"/>
                    <a:ext cx="1440" cy="1008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6720" bIns="-3672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598" name=""/>
                  <p:cNvSpPr/>
                  <p:nvPr/>
                </p:nvSpPr>
                <p:spPr>
                  <a:xfrm>
                    <a:off x="5779440" y="2068200"/>
                    <a:ext cx="1080" cy="1008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6720" bIns="-3672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599" name=""/>
                  <p:cNvSpPr/>
                  <p:nvPr/>
                </p:nvSpPr>
                <p:spPr>
                  <a:xfrm>
                    <a:off x="5797440" y="2068200"/>
                    <a:ext cx="1080" cy="3240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14400" bIns="-1440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600" name=""/>
                  <p:cNvSpPr/>
                  <p:nvPr/>
                </p:nvSpPr>
                <p:spPr>
                  <a:xfrm>
                    <a:off x="5901480" y="2068200"/>
                    <a:ext cx="1080" cy="1008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6720" bIns="-3672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601" name=""/>
                  <p:cNvSpPr/>
                  <p:nvPr/>
                </p:nvSpPr>
                <p:spPr>
                  <a:xfrm>
                    <a:off x="5967360" y="2068200"/>
                    <a:ext cx="1080" cy="1008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6720" bIns="-3672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602" name=""/>
                  <p:cNvSpPr/>
                  <p:nvPr/>
                </p:nvSpPr>
                <p:spPr>
                  <a:xfrm>
                    <a:off x="6011640" y="2068200"/>
                    <a:ext cx="1440" cy="1008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6720" bIns="-3672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603" name=""/>
                  <p:cNvSpPr/>
                  <p:nvPr/>
                </p:nvSpPr>
                <p:spPr>
                  <a:xfrm>
                    <a:off x="6045480" y="2068200"/>
                    <a:ext cx="1080" cy="2196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24840" bIns="-2484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604" name=""/>
                  <p:cNvSpPr/>
                  <p:nvPr/>
                </p:nvSpPr>
                <p:spPr>
                  <a:xfrm>
                    <a:off x="6073560" y="2068200"/>
                    <a:ext cx="1080" cy="1008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6720" bIns="-3672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605" name=""/>
                  <p:cNvSpPr/>
                  <p:nvPr/>
                </p:nvSpPr>
                <p:spPr>
                  <a:xfrm>
                    <a:off x="6099840" y="2068200"/>
                    <a:ext cx="1080" cy="1008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6720" bIns="-3672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606" name=""/>
                  <p:cNvSpPr/>
                  <p:nvPr/>
                </p:nvSpPr>
                <p:spPr>
                  <a:xfrm>
                    <a:off x="6117480" y="2068200"/>
                    <a:ext cx="1080" cy="1008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6720" bIns="-3672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607" name=""/>
                  <p:cNvSpPr/>
                  <p:nvPr/>
                </p:nvSpPr>
                <p:spPr>
                  <a:xfrm>
                    <a:off x="6139440" y="2068200"/>
                    <a:ext cx="1080" cy="1008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6720" bIns="-3672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608" name=""/>
                  <p:cNvSpPr/>
                  <p:nvPr/>
                </p:nvSpPr>
                <p:spPr>
                  <a:xfrm>
                    <a:off x="6155640" y="2068200"/>
                    <a:ext cx="1080" cy="3240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14400" bIns="-1440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609" name=""/>
                  <p:cNvSpPr/>
                  <p:nvPr/>
                </p:nvSpPr>
                <p:spPr>
                  <a:xfrm>
                    <a:off x="6260040" y="2068200"/>
                    <a:ext cx="1080" cy="1008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6720" bIns="-3672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610" name=""/>
                  <p:cNvSpPr/>
                  <p:nvPr/>
                </p:nvSpPr>
                <p:spPr>
                  <a:xfrm>
                    <a:off x="6327360" y="2068200"/>
                    <a:ext cx="1440" cy="1008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6720" bIns="-3672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611" name=""/>
                  <p:cNvSpPr/>
                  <p:nvPr/>
                </p:nvSpPr>
                <p:spPr>
                  <a:xfrm>
                    <a:off x="6371640" y="2068200"/>
                    <a:ext cx="1080" cy="1008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6720" bIns="-3672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612" name=""/>
                  <p:cNvSpPr/>
                  <p:nvPr/>
                </p:nvSpPr>
                <p:spPr>
                  <a:xfrm>
                    <a:off x="6404040" y="2068200"/>
                    <a:ext cx="1080" cy="2196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24840" bIns="-2484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613" name=""/>
                  <p:cNvSpPr/>
                  <p:nvPr/>
                </p:nvSpPr>
                <p:spPr>
                  <a:xfrm>
                    <a:off x="6431760" y="2068200"/>
                    <a:ext cx="1080" cy="1008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6720" bIns="-3672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614" name=""/>
                  <p:cNvSpPr/>
                  <p:nvPr/>
                </p:nvSpPr>
                <p:spPr>
                  <a:xfrm>
                    <a:off x="6453720" y="2068200"/>
                    <a:ext cx="1080" cy="1008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6720" bIns="-3672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615" name=""/>
                  <p:cNvSpPr/>
                  <p:nvPr/>
                </p:nvSpPr>
                <p:spPr>
                  <a:xfrm>
                    <a:off x="6475680" y="2068200"/>
                    <a:ext cx="1080" cy="1008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6720" bIns="-3672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616" name=""/>
                  <p:cNvSpPr/>
                  <p:nvPr/>
                </p:nvSpPr>
                <p:spPr>
                  <a:xfrm>
                    <a:off x="6491880" y="2068200"/>
                    <a:ext cx="1440" cy="1008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6720" bIns="-3672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617" name=""/>
                  <p:cNvSpPr/>
                  <p:nvPr/>
                </p:nvSpPr>
                <p:spPr>
                  <a:xfrm>
                    <a:off x="6509520" y="2068200"/>
                    <a:ext cx="1440" cy="3240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14400" bIns="-1440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</p:grpSp>
            <p:grpSp>
              <p:nvGrpSpPr>
                <p:cNvPr id="618" name=""/>
                <p:cNvGrpSpPr/>
                <p:nvPr/>
              </p:nvGrpSpPr>
              <p:grpSpPr>
                <a:xfrm>
                  <a:off x="5014440" y="2108520"/>
                  <a:ext cx="1572840" cy="160200"/>
                  <a:chOff x="5014440" y="2108520"/>
                  <a:chExt cx="1572840" cy="160200"/>
                </a:xfrm>
              </p:grpSpPr>
              <p:sp>
                <p:nvSpPr>
                  <p:cNvPr id="619" name=""/>
                  <p:cNvSpPr/>
                  <p:nvPr/>
                </p:nvSpPr>
                <p:spPr>
                  <a:xfrm>
                    <a:off x="5014440" y="2146680"/>
                    <a:ext cx="113400" cy="12204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1" lang="en-US" sz="800" spc="-1" strike="noStrike">
                        <a:solidFill>
                          <a:srgbClr val="000000"/>
                        </a:solidFill>
                        <a:latin typeface="Arial"/>
                      </a:rPr>
                      <a:t>10</a:t>
                    </a:r>
                    <a:endParaRPr b="0" lang="en-US" sz="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620" name=""/>
                  <p:cNvSpPr/>
                  <p:nvPr/>
                </p:nvSpPr>
                <p:spPr>
                  <a:xfrm>
                    <a:off x="5114160" y="2108520"/>
                    <a:ext cx="49320" cy="10692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1" lang="en-US" sz="700" spc="-1" strike="noStrike">
                        <a:solidFill>
                          <a:srgbClr val="000000"/>
                        </a:solidFill>
                        <a:latin typeface="Arial"/>
                      </a:rPr>
                      <a:t>0</a:t>
                    </a:r>
                    <a:endParaRPr b="0" lang="en-US" sz="7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621" name=""/>
                  <p:cNvSpPr/>
                  <p:nvPr/>
                </p:nvSpPr>
                <p:spPr>
                  <a:xfrm>
                    <a:off x="5367960" y="2146680"/>
                    <a:ext cx="113400" cy="12204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1" lang="en-US" sz="800" spc="-1" strike="noStrike">
                        <a:solidFill>
                          <a:srgbClr val="000000"/>
                        </a:solidFill>
                        <a:latin typeface="Arial"/>
                      </a:rPr>
                      <a:t>10</a:t>
                    </a:r>
                    <a:endParaRPr b="0" lang="en-US" sz="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622" name=""/>
                  <p:cNvSpPr/>
                  <p:nvPr/>
                </p:nvSpPr>
                <p:spPr>
                  <a:xfrm>
                    <a:off x="5466600" y="2108520"/>
                    <a:ext cx="49320" cy="10692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1" lang="en-US" sz="700" spc="-1" strike="noStrike">
                        <a:solidFill>
                          <a:srgbClr val="000000"/>
                        </a:solidFill>
                        <a:latin typeface="Arial"/>
                      </a:rPr>
                      <a:t>1</a:t>
                    </a:r>
                    <a:endParaRPr b="0" lang="en-US" sz="7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623" name=""/>
                  <p:cNvSpPr/>
                  <p:nvPr/>
                </p:nvSpPr>
                <p:spPr>
                  <a:xfrm>
                    <a:off x="5726520" y="2146680"/>
                    <a:ext cx="113400" cy="12204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1" lang="en-US" sz="800" spc="-1" strike="noStrike">
                        <a:solidFill>
                          <a:srgbClr val="000000"/>
                        </a:solidFill>
                        <a:latin typeface="Arial"/>
                      </a:rPr>
                      <a:t>10</a:t>
                    </a:r>
                    <a:endParaRPr b="0" lang="en-US" sz="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624" name=""/>
                  <p:cNvSpPr/>
                  <p:nvPr/>
                </p:nvSpPr>
                <p:spPr>
                  <a:xfrm>
                    <a:off x="5826960" y="2108520"/>
                    <a:ext cx="49320" cy="10692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1" lang="en-US" sz="700" spc="-1" strike="noStrike">
                        <a:solidFill>
                          <a:srgbClr val="000000"/>
                        </a:solidFill>
                        <a:latin typeface="Arial"/>
                      </a:rPr>
                      <a:t>2</a:t>
                    </a:r>
                    <a:endParaRPr b="0" lang="en-US" sz="7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625" name=""/>
                  <p:cNvSpPr/>
                  <p:nvPr/>
                </p:nvSpPr>
                <p:spPr>
                  <a:xfrm>
                    <a:off x="6086160" y="2146680"/>
                    <a:ext cx="113400" cy="12204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1" lang="en-US" sz="800" spc="-1" strike="noStrike">
                        <a:solidFill>
                          <a:srgbClr val="000000"/>
                        </a:solidFill>
                        <a:latin typeface="Arial"/>
                      </a:rPr>
                      <a:t>10</a:t>
                    </a:r>
                    <a:endParaRPr b="0" lang="en-US" sz="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626" name=""/>
                  <p:cNvSpPr/>
                  <p:nvPr/>
                </p:nvSpPr>
                <p:spPr>
                  <a:xfrm>
                    <a:off x="6185160" y="2108520"/>
                    <a:ext cx="49320" cy="10692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1" lang="en-US" sz="700" spc="-1" strike="noStrike">
                        <a:solidFill>
                          <a:srgbClr val="000000"/>
                        </a:solidFill>
                        <a:latin typeface="Arial"/>
                      </a:rPr>
                      <a:t>3</a:t>
                    </a:r>
                    <a:endParaRPr b="0" lang="en-US" sz="7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627" name=""/>
                  <p:cNvSpPr/>
                  <p:nvPr/>
                </p:nvSpPr>
                <p:spPr>
                  <a:xfrm>
                    <a:off x="6439320" y="2146680"/>
                    <a:ext cx="113400" cy="12204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1" lang="en-US" sz="800" spc="-1" strike="noStrike">
                        <a:solidFill>
                          <a:srgbClr val="000000"/>
                        </a:solidFill>
                        <a:latin typeface="Arial"/>
                      </a:rPr>
                      <a:t>10</a:t>
                    </a:r>
                    <a:endParaRPr b="0" lang="en-US" sz="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628" name=""/>
                  <p:cNvSpPr/>
                  <p:nvPr/>
                </p:nvSpPr>
                <p:spPr>
                  <a:xfrm>
                    <a:off x="6537960" y="2108520"/>
                    <a:ext cx="49320" cy="10692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1" lang="en-US" sz="700" spc="-1" strike="noStrike">
                        <a:solidFill>
                          <a:srgbClr val="000000"/>
                        </a:solidFill>
                        <a:latin typeface="Arial"/>
                      </a:rPr>
                      <a:t>4</a:t>
                    </a:r>
                    <a:endParaRPr b="0" lang="en-US" sz="7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</p:grpSp>
            <p:sp>
              <p:nvSpPr>
                <p:cNvPr id="629" name=""/>
                <p:cNvSpPr/>
                <p:nvPr/>
              </p:nvSpPr>
              <p:spPr>
                <a:xfrm>
                  <a:off x="5682960" y="2237760"/>
                  <a:ext cx="259920" cy="1220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800" spc="-1" strike="noStrike">
                      <a:solidFill>
                        <a:srgbClr val="000000"/>
                      </a:solidFill>
                      <a:latin typeface="Arial"/>
                    </a:rPr>
                    <a:t>CD69</a:t>
                  </a:r>
                  <a:endParaRPr b="0" lang="en-US" sz="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grpSp>
            <p:nvGrpSpPr>
              <p:cNvPr id="630" name=""/>
              <p:cNvGrpSpPr/>
              <p:nvPr/>
            </p:nvGrpSpPr>
            <p:grpSpPr>
              <a:xfrm>
                <a:off x="4791240" y="541440"/>
                <a:ext cx="293400" cy="1605600"/>
                <a:chOff x="4791240" y="541440"/>
                <a:chExt cx="293400" cy="1605600"/>
              </a:xfrm>
            </p:grpSpPr>
            <p:sp>
              <p:nvSpPr>
                <p:cNvPr id="631" name=""/>
                <p:cNvSpPr/>
                <p:nvPr/>
              </p:nvSpPr>
              <p:spPr>
                <a:xfrm flipV="1">
                  <a:off x="5083200" y="617040"/>
                  <a:ext cx="1440" cy="1444680"/>
                </a:xfrm>
                <a:prstGeom prst="line">
                  <a:avLst/>
                </a:prstGeom>
                <a:ln w="64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grpSp>
              <p:nvGrpSpPr>
                <p:cNvPr id="632" name=""/>
                <p:cNvGrpSpPr/>
                <p:nvPr/>
              </p:nvGrpSpPr>
              <p:grpSpPr>
                <a:xfrm>
                  <a:off x="5050440" y="617400"/>
                  <a:ext cx="32040" cy="1445760"/>
                  <a:chOff x="5050440" y="617400"/>
                  <a:chExt cx="32040" cy="1445760"/>
                </a:xfrm>
              </p:grpSpPr>
              <p:sp>
                <p:nvSpPr>
                  <p:cNvPr id="633" name=""/>
                  <p:cNvSpPr/>
                  <p:nvPr/>
                </p:nvSpPr>
                <p:spPr>
                  <a:xfrm flipH="1">
                    <a:off x="5050440" y="2062080"/>
                    <a:ext cx="32040" cy="108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5720" bIns="-4572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634" name=""/>
                  <p:cNvSpPr/>
                  <p:nvPr/>
                </p:nvSpPr>
                <p:spPr>
                  <a:xfrm flipH="1">
                    <a:off x="5072400" y="1956240"/>
                    <a:ext cx="9720" cy="108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5720" bIns="-4572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635" name=""/>
                  <p:cNvSpPr/>
                  <p:nvPr/>
                </p:nvSpPr>
                <p:spPr>
                  <a:xfrm flipH="1">
                    <a:off x="5072400" y="1893960"/>
                    <a:ext cx="9720" cy="108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5720" bIns="-4572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636" name=""/>
                  <p:cNvSpPr/>
                  <p:nvPr/>
                </p:nvSpPr>
                <p:spPr>
                  <a:xfrm flipH="1">
                    <a:off x="5072400" y="1848960"/>
                    <a:ext cx="9720" cy="144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5360" bIns="-4536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637" name=""/>
                  <p:cNvSpPr/>
                  <p:nvPr/>
                </p:nvSpPr>
                <p:spPr>
                  <a:xfrm flipH="1">
                    <a:off x="5060880" y="1810440"/>
                    <a:ext cx="21600" cy="108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5720" bIns="-4572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638" name=""/>
                  <p:cNvSpPr/>
                  <p:nvPr/>
                </p:nvSpPr>
                <p:spPr>
                  <a:xfrm flipH="1">
                    <a:off x="5072400" y="1782000"/>
                    <a:ext cx="9720" cy="108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5720" bIns="-4572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639" name=""/>
                  <p:cNvSpPr/>
                  <p:nvPr/>
                </p:nvSpPr>
                <p:spPr>
                  <a:xfrm flipH="1">
                    <a:off x="5072400" y="1759680"/>
                    <a:ext cx="9720" cy="108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5720" bIns="-4572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640" name=""/>
                  <p:cNvSpPr/>
                  <p:nvPr/>
                </p:nvSpPr>
                <p:spPr>
                  <a:xfrm flipH="1">
                    <a:off x="5072400" y="1737360"/>
                    <a:ext cx="9720" cy="108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5720" bIns="-4572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641" name=""/>
                  <p:cNvSpPr/>
                  <p:nvPr/>
                </p:nvSpPr>
                <p:spPr>
                  <a:xfrm flipH="1">
                    <a:off x="5072400" y="1720800"/>
                    <a:ext cx="9720" cy="144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5360" bIns="-4536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642" name=""/>
                  <p:cNvSpPr/>
                  <p:nvPr/>
                </p:nvSpPr>
                <p:spPr>
                  <a:xfrm flipH="1">
                    <a:off x="5050440" y="1704600"/>
                    <a:ext cx="32040" cy="108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5720" bIns="-4572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643" name=""/>
                  <p:cNvSpPr/>
                  <p:nvPr/>
                </p:nvSpPr>
                <p:spPr>
                  <a:xfrm flipH="1">
                    <a:off x="5072400" y="1591560"/>
                    <a:ext cx="9720" cy="108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5720" bIns="-4572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644" name=""/>
                  <p:cNvSpPr/>
                  <p:nvPr/>
                </p:nvSpPr>
                <p:spPr>
                  <a:xfrm flipH="1">
                    <a:off x="5072400" y="1530360"/>
                    <a:ext cx="9720" cy="108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5720" bIns="-4572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645" name=""/>
                  <p:cNvSpPr/>
                  <p:nvPr/>
                </p:nvSpPr>
                <p:spPr>
                  <a:xfrm flipH="1">
                    <a:off x="5072400" y="1485360"/>
                    <a:ext cx="9720" cy="144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5360" bIns="-4536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646" name=""/>
                  <p:cNvSpPr/>
                  <p:nvPr/>
                </p:nvSpPr>
                <p:spPr>
                  <a:xfrm flipH="1">
                    <a:off x="5060880" y="1451160"/>
                    <a:ext cx="21600" cy="108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5720" bIns="-4572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647" name=""/>
                  <p:cNvSpPr/>
                  <p:nvPr/>
                </p:nvSpPr>
                <p:spPr>
                  <a:xfrm flipH="1">
                    <a:off x="5072400" y="1418400"/>
                    <a:ext cx="9720" cy="108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5720" bIns="-4572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648" name=""/>
                  <p:cNvSpPr/>
                  <p:nvPr/>
                </p:nvSpPr>
                <p:spPr>
                  <a:xfrm flipH="1">
                    <a:off x="5072400" y="1396080"/>
                    <a:ext cx="9720" cy="108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5720" bIns="-4572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649" name=""/>
                  <p:cNvSpPr/>
                  <p:nvPr/>
                </p:nvSpPr>
                <p:spPr>
                  <a:xfrm flipH="1">
                    <a:off x="5072400" y="1373760"/>
                    <a:ext cx="9720" cy="108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5720" bIns="-4572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650" name=""/>
                  <p:cNvSpPr/>
                  <p:nvPr/>
                </p:nvSpPr>
                <p:spPr>
                  <a:xfrm flipH="1">
                    <a:off x="5072400" y="1357200"/>
                    <a:ext cx="9720" cy="144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5360" bIns="-4536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651" name=""/>
                  <p:cNvSpPr/>
                  <p:nvPr/>
                </p:nvSpPr>
                <p:spPr>
                  <a:xfrm flipH="1">
                    <a:off x="5050440" y="1339560"/>
                    <a:ext cx="32040" cy="144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5360" bIns="-4536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652" name=""/>
                  <p:cNvSpPr/>
                  <p:nvPr/>
                </p:nvSpPr>
                <p:spPr>
                  <a:xfrm flipH="1">
                    <a:off x="5072400" y="1233720"/>
                    <a:ext cx="9720" cy="144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5360" bIns="-4536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653" name=""/>
                  <p:cNvSpPr/>
                  <p:nvPr/>
                </p:nvSpPr>
                <p:spPr>
                  <a:xfrm flipH="1">
                    <a:off x="5072400" y="1166760"/>
                    <a:ext cx="9720" cy="108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5720" bIns="-4572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654" name=""/>
                  <p:cNvSpPr/>
                  <p:nvPr/>
                </p:nvSpPr>
                <p:spPr>
                  <a:xfrm flipH="1">
                    <a:off x="5072400" y="1121760"/>
                    <a:ext cx="9720" cy="144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5360" bIns="-4536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655" name=""/>
                  <p:cNvSpPr/>
                  <p:nvPr/>
                </p:nvSpPr>
                <p:spPr>
                  <a:xfrm flipH="1">
                    <a:off x="5060880" y="1087920"/>
                    <a:ext cx="21600" cy="108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5720" bIns="-4572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656" name=""/>
                  <p:cNvSpPr/>
                  <p:nvPr/>
                </p:nvSpPr>
                <p:spPr>
                  <a:xfrm flipH="1">
                    <a:off x="5072400" y="1059480"/>
                    <a:ext cx="9720" cy="144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5360" bIns="-4536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657" name=""/>
                  <p:cNvSpPr/>
                  <p:nvPr/>
                </p:nvSpPr>
                <p:spPr>
                  <a:xfrm flipH="1">
                    <a:off x="5072400" y="1032840"/>
                    <a:ext cx="9720" cy="108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5720" bIns="-4572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658" name=""/>
                  <p:cNvSpPr/>
                  <p:nvPr/>
                </p:nvSpPr>
                <p:spPr>
                  <a:xfrm flipH="1">
                    <a:off x="5072400" y="1014840"/>
                    <a:ext cx="9720" cy="108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5720" bIns="-4572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659" name=""/>
                  <p:cNvSpPr/>
                  <p:nvPr/>
                </p:nvSpPr>
                <p:spPr>
                  <a:xfrm flipH="1">
                    <a:off x="5072400" y="992520"/>
                    <a:ext cx="9720" cy="108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5720" bIns="-4572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660" name=""/>
                  <p:cNvSpPr/>
                  <p:nvPr/>
                </p:nvSpPr>
                <p:spPr>
                  <a:xfrm flipH="1">
                    <a:off x="5050440" y="975960"/>
                    <a:ext cx="32040" cy="144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5360" bIns="-4536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661" name=""/>
                  <p:cNvSpPr/>
                  <p:nvPr/>
                </p:nvSpPr>
                <p:spPr>
                  <a:xfrm flipH="1">
                    <a:off x="5072400" y="870120"/>
                    <a:ext cx="9720" cy="144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5360" bIns="-4536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662" name=""/>
                  <p:cNvSpPr/>
                  <p:nvPr/>
                </p:nvSpPr>
                <p:spPr>
                  <a:xfrm flipH="1">
                    <a:off x="5072400" y="801720"/>
                    <a:ext cx="9720" cy="144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5360" bIns="-4536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663" name=""/>
                  <p:cNvSpPr/>
                  <p:nvPr/>
                </p:nvSpPr>
                <p:spPr>
                  <a:xfrm flipH="1">
                    <a:off x="5072400" y="757080"/>
                    <a:ext cx="9720" cy="108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5720" bIns="-4572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664" name=""/>
                  <p:cNvSpPr/>
                  <p:nvPr/>
                </p:nvSpPr>
                <p:spPr>
                  <a:xfrm flipH="1">
                    <a:off x="5060880" y="724320"/>
                    <a:ext cx="21600" cy="108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5720" bIns="-4572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665" name=""/>
                  <p:cNvSpPr/>
                  <p:nvPr/>
                </p:nvSpPr>
                <p:spPr>
                  <a:xfrm flipH="1">
                    <a:off x="5072400" y="695880"/>
                    <a:ext cx="9720" cy="144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5360" bIns="-4536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666" name=""/>
                  <p:cNvSpPr/>
                  <p:nvPr/>
                </p:nvSpPr>
                <p:spPr>
                  <a:xfrm flipH="1">
                    <a:off x="5072400" y="673560"/>
                    <a:ext cx="9720" cy="144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5360" bIns="-4536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667" name=""/>
                  <p:cNvSpPr/>
                  <p:nvPr/>
                </p:nvSpPr>
                <p:spPr>
                  <a:xfrm flipH="1">
                    <a:off x="5072400" y="651240"/>
                    <a:ext cx="9720" cy="108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5720" bIns="-4572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668" name=""/>
                  <p:cNvSpPr/>
                  <p:nvPr/>
                </p:nvSpPr>
                <p:spPr>
                  <a:xfrm flipH="1">
                    <a:off x="5072400" y="634680"/>
                    <a:ext cx="9720" cy="144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5360" bIns="-4536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669" name=""/>
                  <p:cNvSpPr/>
                  <p:nvPr/>
                </p:nvSpPr>
                <p:spPr>
                  <a:xfrm flipH="1">
                    <a:off x="5050440" y="617400"/>
                    <a:ext cx="32040" cy="108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5720" bIns="-4572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</p:grpSp>
            <p:grpSp>
              <p:nvGrpSpPr>
                <p:cNvPr id="670" name=""/>
                <p:cNvGrpSpPr/>
                <p:nvPr/>
              </p:nvGrpSpPr>
              <p:grpSpPr>
                <a:xfrm>
                  <a:off x="4886280" y="541440"/>
                  <a:ext cx="148680" cy="1605600"/>
                  <a:chOff x="4886280" y="541440"/>
                  <a:chExt cx="148680" cy="1605600"/>
                </a:xfrm>
              </p:grpSpPr>
              <p:sp>
                <p:nvSpPr>
                  <p:cNvPr id="671" name=""/>
                  <p:cNvSpPr/>
                  <p:nvPr/>
                </p:nvSpPr>
                <p:spPr>
                  <a:xfrm>
                    <a:off x="4886280" y="2025000"/>
                    <a:ext cx="113400" cy="12204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1" lang="en-US" sz="800" spc="-1" strike="noStrike">
                        <a:solidFill>
                          <a:srgbClr val="000000"/>
                        </a:solidFill>
                        <a:latin typeface="Arial"/>
                      </a:rPr>
                      <a:t>10</a:t>
                    </a:r>
                    <a:endParaRPr b="0" lang="en-US" sz="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672" name=""/>
                  <p:cNvSpPr/>
                  <p:nvPr/>
                </p:nvSpPr>
                <p:spPr>
                  <a:xfrm>
                    <a:off x="4985640" y="1989000"/>
                    <a:ext cx="49320" cy="10692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1" lang="en-US" sz="700" spc="-1" strike="noStrike">
                        <a:solidFill>
                          <a:srgbClr val="000000"/>
                        </a:solidFill>
                        <a:latin typeface="Arial"/>
                      </a:rPr>
                      <a:t>0</a:t>
                    </a:r>
                    <a:endParaRPr b="0" lang="en-US" sz="7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673" name=""/>
                  <p:cNvSpPr/>
                  <p:nvPr/>
                </p:nvSpPr>
                <p:spPr>
                  <a:xfrm>
                    <a:off x="4886280" y="1665720"/>
                    <a:ext cx="113400" cy="12204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1" lang="en-US" sz="800" spc="-1" strike="noStrike">
                        <a:solidFill>
                          <a:srgbClr val="000000"/>
                        </a:solidFill>
                        <a:latin typeface="Arial"/>
                      </a:rPr>
                      <a:t>10</a:t>
                    </a:r>
                    <a:endParaRPr b="0" lang="en-US" sz="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674" name=""/>
                  <p:cNvSpPr/>
                  <p:nvPr/>
                </p:nvSpPr>
                <p:spPr>
                  <a:xfrm>
                    <a:off x="4985640" y="1626840"/>
                    <a:ext cx="49320" cy="10692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1" lang="en-US" sz="700" spc="-1" strike="noStrike">
                        <a:solidFill>
                          <a:srgbClr val="000000"/>
                        </a:solidFill>
                        <a:latin typeface="Arial"/>
                      </a:rPr>
                      <a:t>1</a:t>
                    </a:r>
                    <a:endParaRPr b="0" lang="en-US" sz="7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675" name=""/>
                  <p:cNvSpPr/>
                  <p:nvPr/>
                </p:nvSpPr>
                <p:spPr>
                  <a:xfrm>
                    <a:off x="4886280" y="1302480"/>
                    <a:ext cx="113400" cy="12204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1" lang="en-US" sz="800" spc="-1" strike="noStrike">
                        <a:solidFill>
                          <a:srgbClr val="000000"/>
                        </a:solidFill>
                        <a:latin typeface="Arial"/>
                      </a:rPr>
                      <a:t>10</a:t>
                    </a:r>
                    <a:endParaRPr b="0" lang="en-US" sz="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676" name=""/>
                  <p:cNvSpPr/>
                  <p:nvPr/>
                </p:nvSpPr>
                <p:spPr>
                  <a:xfrm>
                    <a:off x="4985640" y="1263600"/>
                    <a:ext cx="49320" cy="10692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1" lang="en-US" sz="700" spc="-1" strike="noStrike">
                        <a:solidFill>
                          <a:srgbClr val="000000"/>
                        </a:solidFill>
                        <a:latin typeface="Arial"/>
                      </a:rPr>
                      <a:t>2</a:t>
                    </a:r>
                    <a:endParaRPr b="0" lang="en-US" sz="7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677" name=""/>
                  <p:cNvSpPr/>
                  <p:nvPr/>
                </p:nvSpPr>
                <p:spPr>
                  <a:xfrm>
                    <a:off x="4886280" y="938880"/>
                    <a:ext cx="113400" cy="12204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1" lang="en-US" sz="800" spc="-1" strike="noStrike">
                        <a:solidFill>
                          <a:srgbClr val="000000"/>
                        </a:solidFill>
                        <a:latin typeface="Arial"/>
                      </a:rPr>
                      <a:t>10</a:t>
                    </a:r>
                    <a:endParaRPr b="0" lang="en-US" sz="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678" name=""/>
                  <p:cNvSpPr/>
                  <p:nvPr/>
                </p:nvSpPr>
                <p:spPr>
                  <a:xfrm>
                    <a:off x="4985640" y="900000"/>
                    <a:ext cx="49320" cy="10692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1" lang="en-US" sz="700" spc="-1" strike="noStrike">
                        <a:solidFill>
                          <a:srgbClr val="000000"/>
                        </a:solidFill>
                        <a:latin typeface="Arial"/>
                      </a:rPr>
                      <a:t>3</a:t>
                    </a:r>
                    <a:endParaRPr b="0" lang="en-US" sz="7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679" name=""/>
                  <p:cNvSpPr/>
                  <p:nvPr/>
                </p:nvSpPr>
                <p:spPr>
                  <a:xfrm>
                    <a:off x="4886280" y="579600"/>
                    <a:ext cx="113400" cy="12204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1" lang="en-US" sz="800" spc="-1" strike="noStrike">
                        <a:solidFill>
                          <a:srgbClr val="000000"/>
                        </a:solidFill>
                        <a:latin typeface="Arial"/>
                      </a:rPr>
                      <a:t>10</a:t>
                    </a:r>
                    <a:endParaRPr b="0" lang="en-US" sz="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680" name=""/>
                  <p:cNvSpPr/>
                  <p:nvPr/>
                </p:nvSpPr>
                <p:spPr>
                  <a:xfrm>
                    <a:off x="4985640" y="541440"/>
                    <a:ext cx="49320" cy="10692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1" lang="en-US" sz="700" spc="-1" strike="noStrike">
                        <a:solidFill>
                          <a:srgbClr val="000000"/>
                        </a:solidFill>
                        <a:latin typeface="Arial"/>
                      </a:rPr>
                      <a:t>4</a:t>
                    </a:r>
                    <a:endParaRPr b="0" lang="en-US" sz="7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</p:grpSp>
            <p:sp>
              <p:nvSpPr>
                <p:cNvPr id="681" name=""/>
                <p:cNvSpPr/>
                <p:nvPr/>
              </p:nvSpPr>
              <p:spPr>
                <a:xfrm rot="16200000">
                  <a:off x="4750560" y="1266120"/>
                  <a:ext cx="203400" cy="1220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800" spc="-1" strike="noStrike">
                      <a:solidFill>
                        <a:srgbClr val="000000"/>
                      </a:solidFill>
                      <a:latin typeface="Arial"/>
                    </a:rPr>
                    <a:t>CD4</a:t>
                  </a:r>
                  <a:endParaRPr b="0" lang="en-US" sz="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</p:grpSp>
        <p:grpSp>
          <p:nvGrpSpPr>
            <p:cNvPr id="682" name=""/>
            <p:cNvGrpSpPr/>
            <p:nvPr/>
          </p:nvGrpSpPr>
          <p:grpSpPr>
            <a:xfrm>
              <a:off x="5095080" y="629280"/>
              <a:ext cx="1408680" cy="1427040"/>
              <a:chOff x="5095080" y="629280"/>
              <a:chExt cx="1408680" cy="1427040"/>
            </a:xfrm>
          </p:grpSpPr>
          <p:pic>
            <p:nvPicPr>
              <p:cNvPr id="683" name="" descr=""/>
              <p:cNvPicPr/>
              <p:nvPr/>
            </p:nvPicPr>
            <p:blipFill>
              <a:blip r:embed="rId8"/>
              <a:stretch/>
            </p:blipFill>
            <p:spPr>
              <a:xfrm>
                <a:off x="5095080" y="629280"/>
                <a:ext cx="1408680" cy="1427040"/>
              </a:xfrm>
              <a:prstGeom prst="rect">
                <a:avLst/>
              </a:prstGeom>
              <a:ln w="0">
                <a:noFill/>
              </a:ln>
            </p:spPr>
          </p:pic>
          <p:grpSp>
            <p:nvGrpSpPr>
              <p:cNvPr id="684" name=""/>
              <p:cNvGrpSpPr/>
              <p:nvPr/>
            </p:nvGrpSpPr>
            <p:grpSpPr>
              <a:xfrm>
                <a:off x="5498640" y="903240"/>
                <a:ext cx="515160" cy="660960"/>
                <a:chOff x="5498640" y="903240"/>
                <a:chExt cx="515160" cy="660960"/>
              </a:xfrm>
            </p:grpSpPr>
            <p:sp>
              <p:nvSpPr>
                <p:cNvPr id="685" name=""/>
                <p:cNvSpPr/>
                <p:nvPr/>
              </p:nvSpPr>
              <p:spPr>
                <a:xfrm>
                  <a:off x="5498640" y="1081800"/>
                  <a:ext cx="462240" cy="482400"/>
                </a:xfrm>
                <a:prstGeom prst="rect">
                  <a:avLst/>
                </a:prstGeom>
                <a:noFill/>
                <a:ln w="6480">
                  <a:solidFill>
                    <a:srgbClr val="0000ff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86" name=""/>
                <p:cNvSpPr/>
                <p:nvPr/>
              </p:nvSpPr>
              <p:spPr>
                <a:xfrm>
                  <a:off x="5707080" y="903240"/>
                  <a:ext cx="265680" cy="162360"/>
                </a:xfrm>
                <a:custGeom>
                  <a:avLst/>
                  <a:gdLst/>
                  <a:ahLst/>
                  <a:rect l="l" t="t" r="r" b="b"/>
                  <a:pathLst>
                    <a:path w="181" h="109">
                      <a:moveTo>
                        <a:pt x="0" y="4"/>
                      </a:moveTo>
                      <a:lnTo>
                        <a:pt x="0" y="109"/>
                      </a:lnTo>
                      <a:lnTo>
                        <a:pt x="0" y="109"/>
                      </a:lnTo>
                      <a:lnTo>
                        <a:pt x="181" y="109"/>
                      </a:lnTo>
                      <a:lnTo>
                        <a:pt x="181" y="0"/>
                      </a:lnTo>
                      <a:lnTo>
                        <a:pt x="181" y="0"/>
                      </a:lnTo>
                      <a:lnTo>
                        <a:pt x="0" y="0"/>
                      </a:lnTo>
                      <a:lnTo>
                        <a:pt x="0" y="4"/>
                      </a:lnTo>
                      <a:close/>
                    </a:path>
                  </a:pathLst>
                </a:custGeom>
                <a:solidFill>
                  <a:srgbClr val="ffffff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87" name=""/>
                <p:cNvSpPr/>
                <p:nvPr/>
              </p:nvSpPr>
              <p:spPr>
                <a:xfrm>
                  <a:off x="5714280" y="910440"/>
                  <a:ext cx="299520" cy="1828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1200" spc="-1" strike="noStrike">
                      <a:solidFill>
                        <a:srgbClr val="000000"/>
                      </a:solidFill>
                      <a:latin typeface="Arial"/>
                    </a:rPr>
                    <a:t>85.3</a:t>
                  </a:r>
                  <a:endParaRPr b="0" lang="en-US" sz="1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</p:grpSp>
      </p:grpSp>
      <p:grpSp>
        <p:nvGrpSpPr>
          <p:cNvPr id="688" name=""/>
          <p:cNvGrpSpPr/>
          <p:nvPr/>
        </p:nvGrpSpPr>
        <p:grpSpPr>
          <a:xfrm>
            <a:off x="2738520" y="506520"/>
            <a:ext cx="1794240" cy="1816920"/>
            <a:chOff x="2738520" y="506520"/>
            <a:chExt cx="1794240" cy="1816920"/>
          </a:xfrm>
        </p:grpSpPr>
        <p:grpSp>
          <p:nvGrpSpPr>
            <p:cNvPr id="689" name=""/>
            <p:cNvGrpSpPr/>
            <p:nvPr/>
          </p:nvGrpSpPr>
          <p:grpSpPr>
            <a:xfrm>
              <a:off x="2738520" y="506520"/>
              <a:ext cx="1794240" cy="1816920"/>
              <a:chOff x="2738520" y="506520"/>
              <a:chExt cx="1794240" cy="1816920"/>
            </a:xfrm>
          </p:grpSpPr>
          <p:sp>
            <p:nvSpPr>
              <p:cNvPr id="690" name=""/>
              <p:cNvSpPr/>
              <p:nvPr/>
            </p:nvSpPr>
            <p:spPr>
              <a:xfrm>
                <a:off x="3030840" y="582480"/>
                <a:ext cx="1430640" cy="1449360"/>
              </a:xfrm>
              <a:prstGeom prst="rect">
                <a:avLst/>
              </a:prstGeom>
              <a:solidFill>
                <a:srgbClr val="ffffff"/>
              </a:solidFill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grpSp>
            <p:nvGrpSpPr>
              <p:cNvPr id="691" name=""/>
              <p:cNvGrpSpPr/>
              <p:nvPr/>
            </p:nvGrpSpPr>
            <p:grpSpPr>
              <a:xfrm>
                <a:off x="2960280" y="2027520"/>
                <a:ext cx="1572480" cy="295920"/>
                <a:chOff x="2960280" y="2027520"/>
                <a:chExt cx="1572480" cy="295920"/>
              </a:xfrm>
            </p:grpSpPr>
            <p:sp>
              <p:nvSpPr>
                <p:cNvPr id="692" name=""/>
                <p:cNvSpPr/>
                <p:nvPr/>
              </p:nvSpPr>
              <p:spPr>
                <a:xfrm>
                  <a:off x="3030840" y="2027520"/>
                  <a:ext cx="1424520" cy="1080"/>
                </a:xfrm>
                <a:prstGeom prst="line">
                  <a:avLst/>
                </a:prstGeom>
                <a:ln w="64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720" bIns="-4572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grpSp>
              <p:nvGrpSpPr>
                <p:cNvPr id="693" name=""/>
                <p:cNvGrpSpPr/>
                <p:nvPr/>
              </p:nvGrpSpPr>
              <p:grpSpPr>
                <a:xfrm>
                  <a:off x="3030840" y="2031840"/>
                  <a:ext cx="1425600" cy="34200"/>
                  <a:chOff x="3030840" y="2031840"/>
                  <a:chExt cx="1425600" cy="34200"/>
                </a:xfrm>
              </p:grpSpPr>
              <p:sp>
                <p:nvSpPr>
                  <p:cNvPr id="694" name=""/>
                  <p:cNvSpPr/>
                  <p:nvPr/>
                </p:nvSpPr>
                <p:spPr>
                  <a:xfrm>
                    <a:off x="3030840" y="2031840"/>
                    <a:ext cx="1080" cy="3420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12600" bIns="-1260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695" name=""/>
                  <p:cNvSpPr/>
                  <p:nvPr/>
                </p:nvSpPr>
                <p:spPr>
                  <a:xfrm>
                    <a:off x="3134880" y="2031840"/>
                    <a:ext cx="1080" cy="1152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5280" bIns="-3528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696" name=""/>
                  <p:cNvSpPr/>
                  <p:nvPr/>
                </p:nvSpPr>
                <p:spPr>
                  <a:xfrm>
                    <a:off x="3196440" y="2031840"/>
                    <a:ext cx="1080" cy="1152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5280" bIns="-3528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697" name=""/>
                  <p:cNvSpPr/>
                  <p:nvPr/>
                </p:nvSpPr>
                <p:spPr>
                  <a:xfrm>
                    <a:off x="3240360" y="2031840"/>
                    <a:ext cx="1440" cy="1152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5280" bIns="-3528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698" name=""/>
                  <p:cNvSpPr/>
                  <p:nvPr/>
                </p:nvSpPr>
                <p:spPr>
                  <a:xfrm>
                    <a:off x="3278880" y="2031840"/>
                    <a:ext cx="1080" cy="2196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24840" bIns="-2484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699" name=""/>
                  <p:cNvSpPr/>
                  <p:nvPr/>
                </p:nvSpPr>
                <p:spPr>
                  <a:xfrm>
                    <a:off x="3306960" y="2031840"/>
                    <a:ext cx="1080" cy="1152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5280" bIns="-3528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700" name=""/>
                  <p:cNvSpPr/>
                  <p:nvPr/>
                </p:nvSpPr>
                <p:spPr>
                  <a:xfrm>
                    <a:off x="3328920" y="2031840"/>
                    <a:ext cx="1080" cy="1152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5280" bIns="-3528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701" name=""/>
                  <p:cNvSpPr/>
                  <p:nvPr/>
                </p:nvSpPr>
                <p:spPr>
                  <a:xfrm>
                    <a:off x="3350880" y="2031840"/>
                    <a:ext cx="1080" cy="1152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5280" bIns="-3528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702" name=""/>
                  <p:cNvSpPr/>
                  <p:nvPr/>
                </p:nvSpPr>
                <p:spPr>
                  <a:xfrm>
                    <a:off x="3366720" y="2031840"/>
                    <a:ext cx="1440" cy="1152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5280" bIns="-3528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703" name=""/>
                  <p:cNvSpPr/>
                  <p:nvPr/>
                </p:nvSpPr>
                <p:spPr>
                  <a:xfrm>
                    <a:off x="3384360" y="2031840"/>
                    <a:ext cx="1440" cy="3420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12600" bIns="-1260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704" name=""/>
                  <p:cNvSpPr/>
                  <p:nvPr/>
                </p:nvSpPr>
                <p:spPr>
                  <a:xfrm>
                    <a:off x="3494520" y="2031840"/>
                    <a:ext cx="1440" cy="1152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5280" bIns="-3528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705" name=""/>
                  <p:cNvSpPr/>
                  <p:nvPr/>
                </p:nvSpPr>
                <p:spPr>
                  <a:xfrm>
                    <a:off x="3555000" y="2031840"/>
                    <a:ext cx="1080" cy="1152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5280" bIns="-3528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706" name=""/>
                  <p:cNvSpPr/>
                  <p:nvPr/>
                </p:nvSpPr>
                <p:spPr>
                  <a:xfrm>
                    <a:off x="3598920" y="2031840"/>
                    <a:ext cx="1440" cy="1152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5280" bIns="-3528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707" name=""/>
                  <p:cNvSpPr/>
                  <p:nvPr/>
                </p:nvSpPr>
                <p:spPr>
                  <a:xfrm>
                    <a:off x="3632760" y="2031840"/>
                    <a:ext cx="1080" cy="2196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24840" bIns="-2484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708" name=""/>
                  <p:cNvSpPr/>
                  <p:nvPr/>
                </p:nvSpPr>
                <p:spPr>
                  <a:xfrm>
                    <a:off x="3665160" y="2031840"/>
                    <a:ext cx="1080" cy="1152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5280" bIns="-3528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709" name=""/>
                  <p:cNvSpPr/>
                  <p:nvPr/>
                </p:nvSpPr>
                <p:spPr>
                  <a:xfrm>
                    <a:off x="3687120" y="2031840"/>
                    <a:ext cx="1080" cy="1152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5280" bIns="-3528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710" name=""/>
                  <p:cNvSpPr/>
                  <p:nvPr/>
                </p:nvSpPr>
                <p:spPr>
                  <a:xfrm>
                    <a:off x="3709080" y="2031840"/>
                    <a:ext cx="1080" cy="1152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5280" bIns="-3528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711" name=""/>
                  <p:cNvSpPr/>
                  <p:nvPr/>
                </p:nvSpPr>
                <p:spPr>
                  <a:xfrm>
                    <a:off x="3726720" y="2031840"/>
                    <a:ext cx="1080" cy="1152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5280" bIns="-3528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712" name=""/>
                  <p:cNvSpPr/>
                  <p:nvPr/>
                </p:nvSpPr>
                <p:spPr>
                  <a:xfrm>
                    <a:off x="3742920" y="2031840"/>
                    <a:ext cx="1440" cy="3420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12600" bIns="-1260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713" name=""/>
                  <p:cNvSpPr/>
                  <p:nvPr/>
                </p:nvSpPr>
                <p:spPr>
                  <a:xfrm>
                    <a:off x="3846960" y="2031840"/>
                    <a:ext cx="1440" cy="1152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5280" bIns="-3528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714" name=""/>
                  <p:cNvSpPr/>
                  <p:nvPr/>
                </p:nvSpPr>
                <p:spPr>
                  <a:xfrm>
                    <a:off x="3914640" y="2031840"/>
                    <a:ext cx="1440" cy="1152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5280" bIns="-3528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715" name=""/>
                  <p:cNvSpPr/>
                  <p:nvPr/>
                </p:nvSpPr>
                <p:spPr>
                  <a:xfrm>
                    <a:off x="3958920" y="2031840"/>
                    <a:ext cx="1080" cy="1152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5280" bIns="-3528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716" name=""/>
                  <p:cNvSpPr/>
                  <p:nvPr/>
                </p:nvSpPr>
                <p:spPr>
                  <a:xfrm>
                    <a:off x="3991320" y="2031840"/>
                    <a:ext cx="1080" cy="2196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24840" bIns="-2484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717" name=""/>
                  <p:cNvSpPr/>
                  <p:nvPr/>
                </p:nvSpPr>
                <p:spPr>
                  <a:xfrm>
                    <a:off x="4019040" y="2031840"/>
                    <a:ext cx="1440" cy="1152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5280" bIns="-3528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718" name=""/>
                  <p:cNvSpPr/>
                  <p:nvPr/>
                </p:nvSpPr>
                <p:spPr>
                  <a:xfrm>
                    <a:off x="4046760" y="2031840"/>
                    <a:ext cx="1440" cy="1152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5280" bIns="-3528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719" name=""/>
                  <p:cNvSpPr/>
                  <p:nvPr/>
                </p:nvSpPr>
                <p:spPr>
                  <a:xfrm>
                    <a:off x="4063320" y="2031840"/>
                    <a:ext cx="1080" cy="1152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5280" bIns="-3528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720" name=""/>
                  <p:cNvSpPr/>
                  <p:nvPr/>
                </p:nvSpPr>
                <p:spPr>
                  <a:xfrm>
                    <a:off x="4085280" y="2031840"/>
                    <a:ext cx="1080" cy="1152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5280" bIns="-3528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721" name=""/>
                  <p:cNvSpPr/>
                  <p:nvPr/>
                </p:nvSpPr>
                <p:spPr>
                  <a:xfrm>
                    <a:off x="4101120" y="2031840"/>
                    <a:ext cx="1440" cy="3420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12600" bIns="-1260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722" name=""/>
                  <p:cNvSpPr/>
                  <p:nvPr/>
                </p:nvSpPr>
                <p:spPr>
                  <a:xfrm>
                    <a:off x="4207320" y="2031840"/>
                    <a:ext cx="1080" cy="1152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5280" bIns="-3528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723" name=""/>
                  <p:cNvSpPr/>
                  <p:nvPr/>
                </p:nvSpPr>
                <p:spPr>
                  <a:xfrm>
                    <a:off x="4273200" y="2031840"/>
                    <a:ext cx="1440" cy="1152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5280" bIns="-3528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724" name=""/>
                  <p:cNvSpPr/>
                  <p:nvPr/>
                </p:nvSpPr>
                <p:spPr>
                  <a:xfrm>
                    <a:off x="4317480" y="2031840"/>
                    <a:ext cx="1080" cy="1152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5280" bIns="-3528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725" name=""/>
                  <p:cNvSpPr/>
                  <p:nvPr/>
                </p:nvSpPr>
                <p:spPr>
                  <a:xfrm>
                    <a:off x="4350960" y="2031840"/>
                    <a:ext cx="1080" cy="2196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24840" bIns="-2484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726" name=""/>
                  <p:cNvSpPr/>
                  <p:nvPr/>
                </p:nvSpPr>
                <p:spPr>
                  <a:xfrm>
                    <a:off x="4377240" y="2031840"/>
                    <a:ext cx="1440" cy="1152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5280" bIns="-3528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727" name=""/>
                  <p:cNvSpPr/>
                  <p:nvPr/>
                </p:nvSpPr>
                <p:spPr>
                  <a:xfrm>
                    <a:off x="4399560" y="2031840"/>
                    <a:ext cx="1080" cy="1152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5280" bIns="-3528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728" name=""/>
                  <p:cNvSpPr/>
                  <p:nvPr/>
                </p:nvSpPr>
                <p:spPr>
                  <a:xfrm>
                    <a:off x="4421520" y="2031840"/>
                    <a:ext cx="1080" cy="1152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5280" bIns="-3528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729" name=""/>
                  <p:cNvSpPr/>
                  <p:nvPr/>
                </p:nvSpPr>
                <p:spPr>
                  <a:xfrm>
                    <a:off x="4439160" y="2031840"/>
                    <a:ext cx="1080" cy="1152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5280" bIns="-3528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730" name=""/>
                  <p:cNvSpPr/>
                  <p:nvPr/>
                </p:nvSpPr>
                <p:spPr>
                  <a:xfrm>
                    <a:off x="4455360" y="2031840"/>
                    <a:ext cx="1080" cy="3420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12600" bIns="-1260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</p:grpSp>
            <p:grpSp>
              <p:nvGrpSpPr>
                <p:cNvPr id="731" name=""/>
                <p:cNvGrpSpPr/>
                <p:nvPr/>
              </p:nvGrpSpPr>
              <p:grpSpPr>
                <a:xfrm>
                  <a:off x="2960280" y="2073600"/>
                  <a:ext cx="1572480" cy="160200"/>
                  <a:chOff x="2960280" y="2073600"/>
                  <a:chExt cx="1572480" cy="160200"/>
                </a:xfrm>
              </p:grpSpPr>
              <p:sp>
                <p:nvSpPr>
                  <p:cNvPr id="732" name=""/>
                  <p:cNvSpPr/>
                  <p:nvPr/>
                </p:nvSpPr>
                <p:spPr>
                  <a:xfrm>
                    <a:off x="2960280" y="2111760"/>
                    <a:ext cx="113400" cy="12204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1" lang="en-US" sz="800" spc="-1" strike="noStrike">
                        <a:solidFill>
                          <a:srgbClr val="000000"/>
                        </a:solidFill>
                        <a:latin typeface="Arial"/>
                      </a:rPr>
                      <a:t>10</a:t>
                    </a:r>
                    <a:endParaRPr b="0" lang="en-US" sz="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733" name=""/>
                  <p:cNvSpPr/>
                  <p:nvPr/>
                </p:nvSpPr>
                <p:spPr>
                  <a:xfrm>
                    <a:off x="3060000" y="2073600"/>
                    <a:ext cx="49320" cy="10692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1" lang="en-US" sz="700" spc="-1" strike="noStrike">
                        <a:solidFill>
                          <a:srgbClr val="000000"/>
                        </a:solidFill>
                        <a:latin typeface="Arial"/>
                      </a:rPr>
                      <a:t>0</a:t>
                    </a:r>
                    <a:endParaRPr b="0" lang="en-US" sz="7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734" name=""/>
                  <p:cNvSpPr/>
                  <p:nvPr/>
                </p:nvSpPr>
                <p:spPr>
                  <a:xfrm>
                    <a:off x="3313800" y="2111760"/>
                    <a:ext cx="113400" cy="12204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1" lang="en-US" sz="800" spc="-1" strike="noStrike">
                        <a:solidFill>
                          <a:srgbClr val="000000"/>
                        </a:solidFill>
                        <a:latin typeface="Arial"/>
                      </a:rPr>
                      <a:t>10</a:t>
                    </a:r>
                    <a:endParaRPr b="0" lang="en-US" sz="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735" name=""/>
                  <p:cNvSpPr/>
                  <p:nvPr/>
                </p:nvSpPr>
                <p:spPr>
                  <a:xfrm>
                    <a:off x="3414240" y="2073600"/>
                    <a:ext cx="49320" cy="10692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1" lang="en-US" sz="700" spc="-1" strike="noStrike">
                        <a:solidFill>
                          <a:srgbClr val="000000"/>
                        </a:solidFill>
                        <a:latin typeface="Arial"/>
                      </a:rPr>
                      <a:t>1</a:t>
                    </a:r>
                    <a:endParaRPr b="0" lang="en-US" sz="7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736" name=""/>
                  <p:cNvSpPr/>
                  <p:nvPr/>
                </p:nvSpPr>
                <p:spPr>
                  <a:xfrm>
                    <a:off x="3672360" y="2111760"/>
                    <a:ext cx="113400" cy="12204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1" lang="en-US" sz="800" spc="-1" strike="noStrike">
                        <a:solidFill>
                          <a:srgbClr val="000000"/>
                        </a:solidFill>
                        <a:latin typeface="Arial"/>
                      </a:rPr>
                      <a:t>10</a:t>
                    </a:r>
                    <a:endParaRPr b="0" lang="en-US" sz="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737" name=""/>
                  <p:cNvSpPr/>
                  <p:nvPr/>
                </p:nvSpPr>
                <p:spPr>
                  <a:xfrm>
                    <a:off x="3772440" y="2073600"/>
                    <a:ext cx="49320" cy="10692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1" lang="en-US" sz="700" spc="-1" strike="noStrike">
                        <a:solidFill>
                          <a:srgbClr val="000000"/>
                        </a:solidFill>
                        <a:latin typeface="Arial"/>
                      </a:rPr>
                      <a:t>2</a:t>
                    </a:r>
                    <a:endParaRPr b="0" lang="en-US" sz="7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738" name=""/>
                  <p:cNvSpPr/>
                  <p:nvPr/>
                </p:nvSpPr>
                <p:spPr>
                  <a:xfrm>
                    <a:off x="4031280" y="2111760"/>
                    <a:ext cx="113400" cy="12204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1" lang="en-US" sz="800" spc="-1" strike="noStrike">
                        <a:solidFill>
                          <a:srgbClr val="000000"/>
                        </a:solidFill>
                        <a:latin typeface="Arial"/>
                      </a:rPr>
                      <a:t>10</a:t>
                    </a:r>
                    <a:endParaRPr b="0" lang="en-US" sz="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739" name=""/>
                  <p:cNvSpPr/>
                  <p:nvPr/>
                </p:nvSpPr>
                <p:spPr>
                  <a:xfrm>
                    <a:off x="4132080" y="2073600"/>
                    <a:ext cx="49320" cy="10692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1" lang="en-US" sz="700" spc="-1" strike="noStrike">
                        <a:solidFill>
                          <a:srgbClr val="000000"/>
                        </a:solidFill>
                        <a:latin typeface="Arial"/>
                      </a:rPr>
                      <a:t>3</a:t>
                    </a:r>
                    <a:endParaRPr b="0" lang="en-US" sz="7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740" name=""/>
                  <p:cNvSpPr/>
                  <p:nvPr/>
                </p:nvSpPr>
                <p:spPr>
                  <a:xfrm>
                    <a:off x="4385520" y="2111760"/>
                    <a:ext cx="113400" cy="12204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1" lang="en-US" sz="800" spc="-1" strike="noStrike">
                        <a:solidFill>
                          <a:srgbClr val="000000"/>
                        </a:solidFill>
                        <a:latin typeface="Arial"/>
                      </a:rPr>
                      <a:t>10</a:t>
                    </a:r>
                    <a:endParaRPr b="0" lang="en-US" sz="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741" name=""/>
                  <p:cNvSpPr/>
                  <p:nvPr/>
                </p:nvSpPr>
                <p:spPr>
                  <a:xfrm>
                    <a:off x="4483440" y="2073600"/>
                    <a:ext cx="49320" cy="10692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1" lang="en-US" sz="700" spc="-1" strike="noStrike">
                        <a:solidFill>
                          <a:srgbClr val="000000"/>
                        </a:solidFill>
                        <a:latin typeface="Arial"/>
                      </a:rPr>
                      <a:t>4</a:t>
                    </a:r>
                    <a:endParaRPr b="0" lang="en-US" sz="7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</p:grpSp>
            <p:sp>
              <p:nvSpPr>
                <p:cNvPr id="742" name=""/>
                <p:cNvSpPr/>
                <p:nvPr/>
              </p:nvSpPr>
              <p:spPr>
                <a:xfrm>
                  <a:off x="3628440" y="2201400"/>
                  <a:ext cx="259920" cy="1220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800" spc="-1" strike="noStrike">
                      <a:solidFill>
                        <a:srgbClr val="000000"/>
                      </a:solidFill>
                      <a:latin typeface="Arial"/>
                    </a:rPr>
                    <a:t>CD69</a:t>
                  </a:r>
                  <a:endParaRPr b="0" lang="en-US" sz="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grpSp>
            <p:nvGrpSpPr>
              <p:cNvPr id="743" name=""/>
              <p:cNvGrpSpPr/>
              <p:nvPr/>
            </p:nvGrpSpPr>
            <p:grpSpPr>
              <a:xfrm>
                <a:off x="2738520" y="506520"/>
                <a:ext cx="293400" cy="1603800"/>
                <a:chOff x="2738520" y="506520"/>
                <a:chExt cx="293400" cy="1603800"/>
              </a:xfrm>
            </p:grpSpPr>
            <p:sp>
              <p:nvSpPr>
                <p:cNvPr id="744" name=""/>
                <p:cNvSpPr/>
                <p:nvPr/>
              </p:nvSpPr>
              <p:spPr>
                <a:xfrm flipV="1">
                  <a:off x="3030840" y="582120"/>
                  <a:ext cx="1080" cy="1444680"/>
                </a:xfrm>
                <a:prstGeom prst="line">
                  <a:avLst/>
                </a:prstGeom>
                <a:ln w="64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grpSp>
              <p:nvGrpSpPr>
                <p:cNvPr id="745" name=""/>
                <p:cNvGrpSpPr/>
                <p:nvPr/>
              </p:nvGrpSpPr>
              <p:grpSpPr>
                <a:xfrm>
                  <a:off x="2996640" y="582480"/>
                  <a:ext cx="33840" cy="1445400"/>
                  <a:chOff x="2996640" y="582480"/>
                  <a:chExt cx="33840" cy="1445400"/>
                </a:xfrm>
              </p:grpSpPr>
              <p:sp>
                <p:nvSpPr>
                  <p:cNvPr id="746" name=""/>
                  <p:cNvSpPr/>
                  <p:nvPr/>
                </p:nvSpPr>
                <p:spPr>
                  <a:xfrm flipH="1">
                    <a:off x="2996640" y="2026800"/>
                    <a:ext cx="33840" cy="108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5720" bIns="-4572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747" name=""/>
                  <p:cNvSpPr/>
                  <p:nvPr/>
                </p:nvSpPr>
                <p:spPr>
                  <a:xfrm flipH="1">
                    <a:off x="3017880" y="1919160"/>
                    <a:ext cx="11880" cy="144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5360" bIns="-4536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748" name=""/>
                  <p:cNvSpPr/>
                  <p:nvPr/>
                </p:nvSpPr>
                <p:spPr>
                  <a:xfrm flipH="1">
                    <a:off x="3017880" y="1858680"/>
                    <a:ext cx="11880" cy="108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5720" bIns="-4572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749" name=""/>
                  <p:cNvSpPr/>
                  <p:nvPr/>
                </p:nvSpPr>
                <p:spPr>
                  <a:xfrm flipH="1">
                    <a:off x="3017880" y="1813680"/>
                    <a:ext cx="11880" cy="144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5360" bIns="-4536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750" name=""/>
                  <p:cNvSpPr/>
                  <p:nvPr/>
                </p:nvSpPr>
                <p:spPr>
                  <a:xfrm flipH="1">
                    <a:off x="3008520" y="1773360"/>
                    <a:ext cx="21600" cy="144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5360" bIns="-4536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751" name=""/>
                  <p:cNvSpPr/>
                  <p:nvPr/>
                </p:nvSpPr>
                <p:spPr>
                  <a:xfrm flipH="1">
                    <a:off x="3017880" y="1746720"/>
                    <a:ext cx="11880" cy="108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5720" bIns="-4572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752" name=""/>
                  <p:cNvSpPr/>
                  <p:nvPr/>
                </p:nvSpPr>
                <p:spPr>
                  <a:xfrm flipH="1">
                    <a:off x="3017880" y="1724400"/>
                    <a:ext cx="11880" cy="108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5720" bIns="-4572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753" name=""/>
                  <p:cNvSpPr/>
                  <p:nvPr/>
                </p:nvSpPr>
                <p:spPr>
                  <a:xfrm flipH="1">
                    <a:off x="3017880" y="1702080"/>
                    <a:ext cx="11880" cy="108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5720" bIns="-4572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754" name=""/>
                  <p:cNvSpPr/>
                  <p:nvPr/>
                </p:nvSpPr>
                <p:spPr>
                  <a:xfrm flipH="1">
                    <a:off x="3017880" y="1684440"/>
                    <a:ext cx="11880" cy="108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5720" bIns="-4572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755" name=""/>
                  <p:cNvSpPr/>
                  <p:nvPr/>
                </p:nvSpPr>
                <p:spPr>
                  <a:xfrm flipH="1">
                    <a:off x="2996640" y="1667880"/>
                    <a:ext cx="33840" cy="144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5360" bIns="-4536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756" name=""/>
                  <p:cNvSpPr/>
                  <p:nvPr/>
                </p:nvSpPr>
                <p:spPr>
                  <a:xfrm flipH="1">
                    <a:off x="3017880" y="1556280"/>
                    <a:ext cx="11880" cy="108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5720" bIns="-4572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757" name=""/>
                  <p:cNvSpPr/>
                  <p:nvPr/>
                </p:nvSpPr>
                <p:spPr>
                  <a:xfrm flipH="1">
                    <a:off x="3017880" y="1493640"/>
                    <a:ext cx="11880" cy="144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5360" bIns="-4536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758" name=""/>
                  <p:cNvSpPr/>
                  <p:nvPr/>
                </p:nvSpPr>
                <p:spPr>
                  <a:xfrm flipH="1">
                    <a:off x="3017880" y="1449000"/>
                    <a:ext cx="11880" cy="108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5720" bIns="-4572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759" name=""/>
                  <p:cNvSpPr/>
                  <p:nvPr/>
                </p:nvSpPr>
                <p:spPr>
                  <a:xfrm flipH="1">
                    <a:off x="3008520" y="1416240"/>
                    <a:ext cx="21600" cy="108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5720" bIns="-4572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760" name=""/>
                  <p:cNvSpPr/>
                  <p:nvPr/>
                </p:nvSpPr>
                <p:spPr>
                  <a:xfrm flipH="1">
                    <a:off x="3017880" y="1382040"/>
                    <a:ext cx="11880" cy="108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5720" bIns="-4572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761" name=""/>
                  <p:cNvSpPr/>
                  <p:nvPr/>
                </p:nvSpPr>
                <p:spPr>
                  <a:xfrm flipH="1">
                    <a:off x="3017880" y="1359360"/>
                    <a:ext cx="11880" cy="144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5360" bIns="-4536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762" name=""/>
                  <p:cNvSpPr/>
                  <p:nvPr/>
                </p:nvSpPr>
                <p:spPr>
                  <a:xfrm flipH="1">
                    <a:off x="3017880" y="1337040"/>
                    <a:ext cx="11880" cy="144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5360" bIns="-4536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763" name=""/>
                  <p:cNvSpPr/>
                  <p:nvPr/>
                </p:nvSpPr>
                <p:spPr>
                  <a:xfrm flipH="1">
                    <a:off x="3017880" y="1320840"/>
                    <a:ext cx="11880" cy="108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5720" bIns="-4572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764" name=""/>
                  <p:cNvSpPr/>
                  <p:nvPr/>
                </p:nvSpPr>
                <p:spPr>
                  <a:xfrm flipH="1">
                    <a:off x="2996640" y="1304280"/>
                    <a:ext cx="33840" cy="144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5360" bIns="-4536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765" name=""/>
                  <p:cNvSpPr/>
                  <p:nvPr/>
                </p:nvSpPr>
                <p:spPr>
                  <a:xfrm flipH="1">
                    <a:off x="3017880" y="1197360"/>
                    <a:ext cx="11880" cy="108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5720" bIns="-4572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766" name=""/>
                  <p:cNvSpPr/>
                  <p:nvPr/>
                </p:nvSpPr>
                <p:spPr>
                  <a:xfrm flipH="1">
                    <a:off x="3017880" y="1130040"/>
                    <a:ext cx="11880" cy="144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5360" bIns="-4536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767" name=""/>
                  <p:cNvSpPr/>
                  <p:nvPr/>
                </p:nvSpPr>
                <p:spPr>
                  <a:xfrm flipH="1">
                    <a:off x="3017880" y="1085400"/>
                    <a:ext cx="11880" cy="108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5720" bIns="-4572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768" name=""/>
                  <p:cNvSpPr/>
                  <p:nvPr/>
                </p:nvSpPr>
                <p:spPr>
                  <a:xfrm flipH="1">
                    <a:off x="3008520" y="1052640"/>
                    <a:ext cx="21600" cy="108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5720" bIns="-4572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769" name=""/>
                  <p:cNvSpPr/>
                  <p:nvPr/>
                </p:nvSpPr>
                <p:spPr>
                  <a:xfrm flipH="1">
                    <a:off x="3017880" y="1024200"/>
                    <a:ext cx="11880" cy="144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5360" bIns="-4536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770" name=""/>
                  <p:cNvSpPr/>
                  <p:nvPr/>
                </p:nvSpPr>
                <p:spPr>
                  <a:xfrm flipH="1">
                    <a:off x="3017880" y="996120"/>
                    <a:ext cx="11880" cy="144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5360" bIns="-4536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771" name=""/>
                  <p:cNvSpPr/>
                  <p:nvPr/>
                </p:nvSpPr>
                <p:spPr>
                  <a:xfrm flipH="1">
                    <a:off x="3017880" y="979920"/>
                    <a:ext cx="11880" cy="108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5720" bIns="-4572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772" name=""/>
                  <p:cNvSpPr/>
                  <p:nvPr/>
                </p:nvSpPr>
                <p:spPr>
                  <a:xfrm flipH="1">
                    <a:off x="3017880" y="957600"/>
                    <a:ext cx="11880" cy="108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5720" bIns="-4572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773" name=""/>
                  <p:cNvSpPr/>
                  <p:nvPr/>
                </p:nvSpPr>
                <p:spPr>
                  <a:xfrm flipH="1">
                    <a:off x="2996640" y="939600"/>
                    <a:ext cx="33840" cy="108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5720" bIns="-4572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774" name=""/>
                  <p:cNvSpPr/>
                  <p:nvPr/>
                </p:nvSpPr>
                <p:spPr>
                  <a:xfrm flipH="1">
                    <a:off x="3017880" y="833760"/>
                    <a:ext cx="11880" cy="108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5720" bIns="-4572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775" name=""/>
                  <p:cNvSpPr/>
                  <p:nvPr/>
                </p:nvSpPr>
                <p:spPr>
                  <a:xfrm flipH="1">
                    <a:off x="3017880" y="766800"/>
                    <a:ext cx="11880" cy="144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5360" bIns="-4536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776" name=""/>
                  <p:cNvSpPr/>
                  <p:nvPr/>
                </p:nvSpPr>
                <p:spPr>
                  <a:xfrm flipH="1">
                    <a:off x="3017880" y="722160"/>
                    <a:ext cx="11880" cy="108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5720" bIns="-4572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777" name=""/>
                  <p:cNvSpPr/>
                  <p:nvPr/>
                </p:nvSpPr>
                <p:spPr>
                  <a:xfrm flipH="1">
                    <a:off x="3008520" y="687960"/>
                    <a:ext cx="21600" cy="108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5720" bIns="-4572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778" name=""/>
                  <p:cNvSpPr/>
                  <p:nvPr/>
                </p:nvSpPr>
                <p:spPr>
                  <a:xfrm flipH="1">
                    <a:off x="3017880" y="660960"/>
                    <a:ext cx="11880" cy="144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5360" bIns="-4536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779" name=""/>
                  <p:cNvSpPr/>
                  <p:nvPr/>
                </p:nvSpPr>
                <p:spPr>
                  <a:xfrm flipH="1">
                    <a:off x="3017880" y="637200"/>
                    <a:ext cx="11880" cy="108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5720" bIns="-4572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780" name=""/>
                  <p:cNvSpPr/>
                  <p:nvPr/>
                </p:nvSpPr>
                <p:spPr>
                  <a:xfrm flipH="1">
                    <a:off x="3017880" y="614880"/>
                    <a:ext cx="11880" cy="108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5720" bIns="-4572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781" name=""/>
                  <p:cNvSpPr/>
                  <p:nvPr/>
                </p:nvSpPr>
                <p:spPr>
                  <a:xfrm flipH="1">
                    <a:off x="3017880" y="598680"/>
                    <a:ext cx="11880" cy="108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5720" bIns="-4572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782" name=""/>
                  <p:cNvSpPr/>
                  <p:nvPr/>
                </p:nvSpPr>
                <p:spPr>
                  <a:xfrm flipH="1">
                    <a:off x="2996640" y="582480"/>
                    <a:ext cx="33840" cy="1080"/>
                  </a:xfrm>
                  <a:prstGeom prst="line">
                    <a:avLst/>
                  </a:prstGeom>
                  <a:ln w="648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5720" bIns="-45720" anchor="t">
                    <a:noAutofit/>
                  </a:bodyPr>
                  <a:p>
                    <a:endParaRPr b="0" lang="en-US" sz="2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</p:grpSp>
            <p:grpSp>
              <p:nvGrpSpPr>
                <p:cNvPr id="783" name=""/>
                <p:cNvGrpSpPr/>
                <p:nvPr/>
              </p:nvGrpSpPr>
              <p:grpSpPr>
                <a:xfrm>
                  <a:off x="2833560" y="506520"/>
                  <a:ext cx="148680" cy="1603800"/>
                  <a:chOff x="2833560" y="506520"/>
                  <a:chExt cx="148680" cy="1603800"/>
                </a:xfrm>
              </p:grpSpPr>
              <p:sp>
                <p:nvSpPr>
                  <p:cNvPr id="784" name=""/>
                  <p:cNvSpPr/>
                  <p:nvPr/>
                </p:nvSpPr>
                <p:spPr>
                  <a:xfrm>
                    <a:off x="2833560" y="1988280"/>
                    <a:ext cx="113400" cy="12204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1" lang="en-US" sz="800" spc="-1" strike="noStrike">
                        <a:solidFill>
                          <a:srgbClr val="000000"/>
                        </a:solidFill>
                        <a:latin typeface="Arial"/>
                      </a:rPr>
                      <a:t>10</a:t>
                    </a:r>
                    <a:endParaRPr b="0" lang="en-US" sz="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785" name=""/>
                  <p:cNvSpPr/>
                  <p:nvPr/>
                </p:nvSpPr>
                <p:spPr>
                  <a:xfrm>
                    <a:off x="2932920" y="1952640"/>
                    <a:ext cx="49320" cy="10692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1" lang="en-US" sz="700" spc="-1" strike="noStrike">
                        <a:solidFill>
                          <a:srgbClr val="000000"/>
                        </a:solidFill>
                        <a:latin typeface="Arial"/>
                      </a:rPr>
                      <a:t>0</a:t>
                    </a:r>
                    <a:endParaRPr b="0" lang="en-US" sz="7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786" name=""/>
                  <p:cNvSpPr/>
                  <p:nvPr/>
                </p:nvSpPr>
                <p:spPr>
                  <a:xfrm>
                    <a:off x="2833560" y="1636920"/>
                    <a:ext cx="113400" cy="12204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1" lang="en-US" sz="800" spc="-1" strike="noStrike">
                        <a:solidFill>
                          <a:srgbClr val="000000"/>
                        </a:solidFill>
                        <a:latin typeface="Arial"/>
                      </a:rPr>
                      <a:t>10</a:t>
                    </a:r>
                    <a:endParaRPr b="0" lang="en-US" sz="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787" name=""/>
                  <p:cNvSpPr/>
                  <p:nvPr/>
                </p:nvSpPr>
                <p:spPr>
                  <a:xfrm>
                    <a:off x="2932920" y="1591920"/>
                    <a:ext cx="49320" cy="10692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1" lang="en-US" sz="700" spc="-1" strike="noStrike">
                        <a:solidFill>
                          <a:srgbClr val="000000"/>
                        </a:solidFill>
                        <a:latin typeface="Arial"/>
                      </a:rPr>
                      <a:t>1</a:t>
                    </a:r>
                    <a:endParaRPr b="0" lang="en-US" sz="7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788" name=""/>
                  <p:cNvSpPr/>
                  <p:nvPr/>
                </p:nvSpPr>
                <p:spPr>
                  <a:xfrm>
                    <a:off x="2833560" y="1266120"/>
                    <a:ext cx="113400" cy="12204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1" lang="en-US" sz="800" spc="-1" strike="noStrike">
                        <a:solidFill>
                          <a:srgbClr val="000000"/>
                        </a:solidFill>
                        <a:latin typeface="Arial"/>
                      </a:rPr>
                      <a:t>10</a:t>
                    </a:r>
                    <a:endParaRPr b="0" lang="en-US" sz="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789" name=""/>
                  <p:cNvSpPr/>
                  <p:nvPr/>
                </p:nvSpPr>
                <p:spPr>
                  <a:xfrm>
                    <a:off x="2932920" y="1227240"/>
                    <a:ext cx="49320" cy="10692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1" lang="en-US" sz="700" spc="-1" strike="noStrike">
                        <a:solidFill>
                          <a:srgbClr val="000000"/>
                        </a:solidFill>
                        <a:latin typeface="Arial"/>
                      </a:rPr>
                      <a:t>2</a:t>
                    </a:r>
                    <a:endParaRPr b="0" lang="en-US" sz="7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790" name=""/>
                  <p:cNvSpPr/>
                  <p:nvPr/>
                </p:nvSpPr>
                <p:spPr>
                  <a:xfrm>
                    <a:off x="2833560" y="902520"/>
                    <a:ext cx="113400" cy="12204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1" lang="en-US" sz="800" spc="-1" strike="noStrike">
                        <a:solidFill>
                          <a:srgbClr val="000000"/>
                        </a:solidFill>
                        <a:latin typeface="Arial"/>
                      </a:rPr>
                      <a:t>10</a:t>
                    </a:r>
                    <a:endParaRPr b="0" lang="en-US" sz="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791" name=""/>
                  <p:cNvSpPr/>
                  <p:nvPr/>
                </p:nvSpPr>
                <p:spPr>
                  <a:xfrm>
                    <a:off x="2932920" y="863640"/>
                    <a:ext cx="49320" cy="10692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1" lang="en-US" sz="700" spc="-1" strike="noStrike">
                        <a:solidFill>
                          <a:srgbClr val="000000"/>
                        </a:solidFill>
                        <a:latin typeface="Arial"/>
                      </a:rPr>
                      <a:t>3</a:t>
                    </a:r>
                    <a:endParaRPr b="0" lang="en-US" sz="7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792" name=""/>
                  <p:cNvSpPr/>
                  <p:nvPr/>
                </p:nvSpPr>
                <p:spPr>
                  <a:xfrm>
                    <a:off x="2833560" y="544680"/>
                    <a:ext cx="113400" cy="12204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1" lang="en-US" sz="800" spc="-1" strike="noStrike">
                        <a:solidFill>
                          <a:srgbClr val="000000"/>
                        </a:solidFill>
                        <a:latin typeface="Arial"/>
                      </a:rPr>
                      <a:t>10</a:t>
                    </a:r>
                    <a:endParaRPr b="0" lang="en-US" sz="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793" name=""/>
                  <p:cNvSpPr/>
                  <p:nvPr/>
                </p:nvSpPr>
                <p:spPr>
                  <a:xfrm>
                    <a:off x="2932920" y="506520"/>
                    <a:ext cx="49320" cy="10692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1" lang="en-US" sz="700" spc="-1" strike="noStrike">
                        <a:solidFill>
                          <a:srgbClr val="000000"/>
                        </a:solidFill>
                        <a:latin typeface="Arial"/>
                      </a:rPr>
                      <a:t>4</a:t>
                    </a:r>
                    <a:endParaRPr b="0" lang="en-US" sz="7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</p:grpSp>
            <p:sp>
              <p:nvSpPr>
                <p:cNvPr id="794" name=""/>
                <p:cNvSpPr/>
                <p:nvPr/>
              </p:nvSpPr>
              <p:spPr>
                <a:xfrm rot="16200000">
                  <a:off x="2697840" y="1229400"/>
                  <a:ext cx="203400" cy="1220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800" spc="-1" strike="noStrike">
                      <a:solidFill>
                        <a:srgbClr val="000000"/>
                      </a:solidFill>
                      <a:latin typeface="Arial"/>
                    </a:rPr>
                    <a:t>CD4</a:t>
                  </a:r>
                  <a:endParaRPr b="0" lang="en-US" sz="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</p:grpSp>
        <p:grpSp>
          <p:nvGrpSpPr>
            <p:cNvPr id="795" name=""/>
            <p:cNvGrpSpPr/>
            <p:nvPr/>
          </p:nvGrpSpPr>
          <p:grpSpPr>
            <a:xfrm>
              <a:off x="3041280" y="592560"/>
              <a:ext cx="1408320" cy="1428480"/>
              <a:chOff x="3041280" y="592560"/>
              <a:chExt cx="1408320" cy="1428480"/>
            </a:xfrm>
          </p:grpSpPr>
          <p:pic>
            <p:nvPicPr>
              <p:cNvPr id="796" name="" descr=""/>
              <p:cNvPicPr/>
              <p:nvPr/>
            </p:nvPicPr>
            <p:blipFill>
              <a:blip r:embed="rId9"/>
              <a:stretch/>
            </p:blipFill>
            <p:spPr>
              <a:xfrm>
                <a:off x="3041280" y="592560"/>
                <a:ext cx="1408320" cy="1428480"/>
              </a:xfrm>
              <a:prstGeom prst="rect">
                <a:avLst/>
              </a:prstGeom>
              <a:ln w="0">
                <a:noFill/>
              </a:ln>
            </p:spPr>
          </p:pic>
          <p:grpSp>
            <p:nvGrpSpPr>
              <p:cNvPr id="797" name=""/>
              <p:cNvGrpSpPr/>
              <p:nvPr/>
            </p:nvGrpSpPr>
            <p:grpSpPr>
              <a:xfrm>
                <a:off x="3444840" y="862200"/>
                <a:ext cx="543240" cy="665280"/>
                <a:chOff x="3444840" y="862200"/>
                <a:chExt cx="543240" cy="665280"/>
              </a:xfrm>
            </p:grpSpPr>
            <p:sp>
              <p:nvSpPr>
                <p:cNvPr id="798" name=""/>
                <p:cNvSpPr/>
                <p:nvPr/>
              </p:nvSpPr>
              <p:spPr>
                <a:xfrm>
                  <a:off x="3444840" y="1046520"/>
                  <a:ext cx="464040" cy="480960"/>
                </a:xfrm>
                <a:prstGeom prst="rect">
                  <a:avLst/>
                </a:prstGeom>
                <a:noFill/>
                <a:ln w="6480">
                  <a:solidFill>
                    <a:srgbClr val="0000ff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99" name=""/>
                <p:cNvSpPr/>
                <p:nvPr/>
              </p:nvSpPr>
              <p:spPr>
                <a:xfrm>
                  <a:off x="3682800" y="862200"/>
                  <a:ext cx="263880" cy="162000"/>
                </a:xfrm>
                <a:custGeom>
                  <a:avLst/>
                  <a:gdLst/>
                  <a:ahLst/>
                  <a:rect l="l" t="t" r="r" b="b"/>
                  <a:pathLst>
                    <a:path w="180" h="109">
                      <a:moveTo>
                        <a:pt x="0" y="4"/>
                      </a:moveTo>
                      <a:lnTo>
                        <a:pt x="0" y="109"/>
                      </a:lnTo>
                      <a:lnTo>
                        <a:pt x="0" y="109"/>
                      </a:lnTo>
                      <a:lnTo>
                        <a:pt x="180" y="109"/>
                      </a:lnTo>
                      <a:lnTo>
                        <a:pt x="180" y="0"/>
                      </a:lnTo>
                      <a:lnTo>
                        <a:pt x="180" y="0"/>
                      </a:lnTo>
                      <a:lnTo>
                        <a:pt x="0" y="0"/>
                      </a:lnTo>
                      <a:lnTo>
                        <a:pt x="0" y="4"/>
                      </a:lnTo>
                      <a:close/>
                    </a:path>
                  </a:pathLst>
                </a:custGeom>
                <a:solidFill>
                  <a:srgbClr val="ffffff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00" name=""/>
                <p:cNvSpPr/>
                <p:nvPr/>
              </p:nvSpPr>
              <p:spPr>
                <a:xfrm>
                  <a:off x="3688560" y="869400"/>
                  <a:ext cx="299520" cy="1828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1200" spc="-1" strike="noStrike">
                      <a:solidFill>
                        <a:srgbClr val="000000"/>
                      </a:solidFill>
                      <a:latin typeface="Arial"/>
                    </a:rPr>
                    <a:t>88.9</a:t>
                  </a:r>
                  <a:endParaRPr b="0" lang="en-US" sz="1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</p:grpSp>
      </p:grpSp>
      <p:sp>
        <p:nvSpPr>
          <p:cNvPr id="801" name=""/>
          <p:cNvSpPr/>
          <p:nvPr/>
        </p:nvSpPr>
        <p:spPr>
          <a:xfrm>
            <a:off x="918360" y="289080"/>
            <a:ext cx="1067760" cy="33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 baseline="-25000">
                <a:solidFill>
                  <a:srgbClr val="000000"/>
                </a:solidFill>
                <a:latin typeface="Arial"/>
              </a:rPr>
              <a:t>DC, gate for CD4+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02" name=""/>
          <p:cNvSpPr/>
          <p:nvPr/>
        </p:nvSpPr>
        <p:spPr>
          <a:xfrm>
            <a:off x="736560" y="2338560"/>
            <a:ext cx="1543320" cy="33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 baseline="-25000">
                <a:solidFill>
                  <a:srgbClr val="000000"/>
                </a:solidFill>
                <a:latin typeface="Arial"/>
              </a:rPr>
              <a:t>DC, control without peptide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03" name=""/>
          <p:cNvSpPr/>
          <p:nvPr/>
        </p:nvSpPr>
        <p:spPr>
          <a:xfrm>
            <a:off x="3207960" y="298440"/>
            <a:ext cx="997560" cy="33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 baseline="-25000">
                <a:solidFill>
                  <a:srgbClr val="000000"/>
                </a:solidFill>
                <a:latin typeface="Arial"/>
              </a:rPr>
              <a:t>DC, with peptide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04" name=""/>
          <p:cNvSpPr/>
          <p:nvPr/>
        </p:nvSpPr>
        <p:spPr>
          <a:xfrm>
            <a:off x="5079600" y="314280"/>
            <a:ext cx="1340640" cy="33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 baseline="-25000">
                <a:solidFill>
                  <a:srgbClr val="000000"/>
                </a:solidFill>
                <a:latin typeface="Arial"/>
              </a:rPr>
              <a:t>DC + RBC, with peptide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05" name=""/>
          <p:cNvSpPr/>
          <p:nvPr/>
        </p:nvSpPr>
        <p:spPr>
          <a:xfrm>
            <a:off x="2944080" y="2354400"/>
            <a:ext cx="1369440" cy="33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 baseline="-25000">
                <a:solidFill>
                  <a:srgbClr val="000000"/>
                </a:solidFill>
                <a:latin typeface="Arial"/>
              </a:rPr>
              <a:t>DC + iRBC, with peptide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06" name=""/>
          <p:cNvSpPr/>
          <p:nvPr/>
        </p:nvSpPr>
        <p:spPr>
          <a:xfrm>
            <a:off x="341280" y="-9360"/>
            <a:ext cx="1700280" cy="370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 baseline="-25000">
                <a:solidFill>
                  <a:srgbClr val="000000"/>
                </a:solidFill>
                <a:latin typeface="Arial"/>
              </a:rPr>
              <a:t>FACs analysis for figure 4F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07" name=""/>
          <p:cNvSpPr/>
          <p:nvPr/>
        </p:nvSpPr>
        <p:spPr>
          <a:xfrm>
            <a:off x="317880" y="4460760"/>
            <a:ext cx="1720080" cy="370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 baseline="-25000">
                <a:solidFill>
                  <a:srgbClr val="000000"/>
                </a:solidFill>
                <a:latin typeface="Arial"/>
              </a:rPr>
              <a:t>FACs analysis for figure 4G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08" name=""/>
          <p:cNvSpPr/>
          <p:nvPr/>
        </p:nvSpPr>
        <p:spPr>
          <a:xfrm>
            <a:off x="5226840" y="8737560"/>
            <a:ext cx="714240" cy="370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 baseline="-25000">
                <a:solidFill>
                  <a:srgbClr val="000000"/>
                </a:solidFill>
                <a:latin typeface="Arial"/>
              </a:rPr>
              <a:t>Figure S1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261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8-03-13T19:50:57Z</dcterms:created>
  <dc:creator>Ana Rodriguez</dc:creator>
  <dc:description/>
  <dc:language>en-US</dc:language>
  <cp:lastModifiedBy>Ana Rodriguez</cp:lastModifiedBy>
  <dcterms:modified xsi:type="dcterms:W3CDTF">2008-03-14T16:52:25Z</dcterms:modified>
  <cp:revision>6</cp:revision>
  <dc:subject/>
  <dc:title>PowerPoint Presentation</dc:title>
</cp:coreProperties>
</file>